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8" r:id="rId2"/>
    <p:sldId id="285" r:id="rId3"/>
    <p:sldId id="264" r:id="rId4"/>
    <p:sldId id="280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2" d="100"/>
          <a:sy n="82" d="100"/>
        </p:scale>
        <p:origin x="60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G:\My%20Drive\Liu%20Files\Bud%20Delay_2019\Fuit%20setting\Frost_BD2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1122850421965801E-2"/>
          <c:y val="4.569055036344756E-2"/>
          <c:w val="0.86920647644473004"/>
          <c:h val="0.68003021515577222"/>
        </c:manualLayout>
      </c:layout>
      <c:scatterChart>
        <c:scatterStyle val="lineMarker"/>
        <c:varyColors val="0"/>
        <c:ser>
          <c:idx val="0"/>
          <c:order val="0"/>
          <c:tx>
            <c:strRef>
              <c:f>Sunhigh_1!$E$1</c:f>
              <c:strCache>
                <c:ptCount val="1"/>
                <c:pt idx="0">
                  <c:v>Sunhigh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xVal>
            <c:numRef>
              <c:f>Sunhigh_1!$B$2:$B$721</c:f>
              <c:numCache>
                <c:formatCode>m/d;@</c:formatCode>
                <c:ptCount val="720"/>
                <c:pt idx="0">
                  <c:v>43936</c:v>
                </c:pt>
                <c:pt idx="1">
                  <c:v>43936.006944444445</c:v>
                </c:pt>
                <c:pt idx="2">
                  <c:v>43936.013888888891</c:v>
                </c:pt>
                <c:pt idx="3">
                  <c:v>43936.020833333336</c:v>
                </c:pt>
                <c:pt idx="4">
                  <c:v>43936.027777777781</c:v>
                </c:pt>
                <c:pt idx="5">
                  <c:v>43936.034722222219</c:v>
                </c:pt>
                <c:pt idx="6">
                  <c:v>43936.041666666664</c:v>
                </c:pt>
                <c:pt idx="7">
                  <c:v>43936.048611111109</c:v>
                </c:pt>
                <c:pt idx="8">
                  <c:v>43936.055555555555</c:v>
                </c:pt>
                <c:pt idx="9">
                  <c:v>43936.0625</c:v>
                </c:pt>
                <c:pt idx="10">
                  <c:v>43936.069444444445</c:v>
                </c:pt>
                <c:pt idx="11">
                  <c:v>43936.076388888891</c:v>
                </c:pt>
                <c:pt idx="12">
                  <c:v>43936.083333333336</c:v>
                </c:pt>
                <c:pt idx="13">
                  <c:v>43936.090277777781</c:v>
                </c:pt>
                <c:pt idx="14">
                  <c:v>43936.097222222219</c:v>
                </c:pt>
                <c:pt idx="15">
                  <c:v>43936.104166666664</c:v>
                </c:pt>
                <c:pt idx="16">
                  <c:v>43936.111111111109</c:v>
                </c:pt>
                <c:pt idx="17">
                  <c:v>43936.118055555555</c:v>
                </c:pt>
                <c:pt idx="18">
                  <c:v>43936.125</c:v>
                </c:pt>
                <c:pt idx="19">
                  <c:v>43936.131944444445</c:v>
                </c:pt>
                <c:pt idx="20">
                  <c:v>43936.138888888891</c:v>
                </c:pt>
                <c:pt idx="21">
                  <c:v>43936.145833333336</c:v>
                </c:pt>
                <c:pt idx="22">
                  <c:v>43936.152777777781</c:v>
                </c:pt>
                <c:pt idx="23">
                  <c:v>43936.159722222219</c:v>
                </c:pt>
                <c:pt idx="24">
                  <c:v>43936.166666666664</c:v>
                </c:pt>
                <c:pt idx="25">
                  <c:v>43936.173611111109</c:v>
                </c:pt>
                <c:pt idx="26">
                  <c:v>43936.180555555555</c:v>
                </c:pt>
                <c:pt idx="27">
                  <c:v>43936.1875</c:v>
                </c:pt>
                <c:pt idx="28">
                  <c:v>43936.194444444445</c:v>
                </c:pt>
                <c:pt idx="29">
                  <c:v>43936.201388888891</c:v>
                </c:pt>
                <c:pt idx="30">
                  <c:v>43936.208333333336</c:v>
                </c:pt>
                <c:pt idx="31">
                  <c:v>43936.215277777781</c:v>
                </c:pt>
                <c:pt idx="32">
                  <c:v>43936.222222222219</c:v>
                </c:pt>
                <c:pt idx="33">
                  <c:v>43936.229166666664</c:v>
                </c:pt>
                <c:pt idx="34">
                  <c:v>43936.236111111109</c:v>
                </c:pt>
                <c:pt idx="35">
                  <c:v>43936.243055555555</c:v>
                </c:pt>
                <c:pt idx="36">
                  <c:v>43936.25</c:v>
                </c:pt>
                <c:pt idx="37">
                  <c:v>43936.256944444445</c:v>
                </c:pt>
                <c:pt idx="38">
                  <c:v>43936.263888888891</c:v>
                </c:pt>
                <c:pt idx="39">
                  <c:v>43936.270833333336</c:v>
                </c:pt>
                <c:pt idx="40">
                  <c:v>43936.277777777781</c:v>
                </c:pt>
                <c:pt idx="41">
                  <c:v>43936.284722222219</c:v>
                </c:pt>
                <c:pt idx="42">
                  <c:v>43936.291666666664</c:v>
                </c:pt>
                <c:pt idx="43">
                  <c:v>43936.298611111109</c:v>
                </c:pt>
                <c:pt idx="44">
                  <c:v>43936.305555555555</c:v>
                </c:pt>
                <c:pt idx="45">
                  <c:v>43936.3125</c:v>
                </c:pt>
                <c:pt idx="46">
                  <c:v>43936.319444444445</c:v>
                </c:pt>
                <c:pt idx="47">
                  <c:v>43936.326388888891</c:v>
                </c:pt>
                <c:pt idx="48">
                  <c:v>43936.333333333336</c:v>
                </c:pt>
                <c:pt idx="49">
                  <c:v>43936.340277777781</c:v>
                </c:pt>
                <c:pt idx="50">
                  <c:v>43936.347222222219</c:v>
                </c:pt>
                <c:pt idx="51">
                  <c:v>43936.354166666664</c:v>
                </c:pt>
                <c:pt idx="52">
                  <c:v>43936.361111111109</c:v>
                </c:pt>
                <c:pt idx="53">
                  <c:v>43936.368055555555</c:v>
                </c:pt>
                <c:pt idx="54">
                  <c:v>43936.375</c:v>
                </c:pt>
                <c:pt idx="55">
                  <c:v>43936.381944444445</c:v>
                </c:pt>
                <c:pt idx="56">
                  <c:v>43936.388888888891</c:v>
                </c:pt>
                <c:pt idx="57">
                  <c:v>43936.395833333336</c:v>
                </c:pt>
                <c:pt idx="58">
                  <c:v>43936.402777777781</c:v>
                </c:pt>
                <c:pt idx="59">
                  <c:v>43936.409722222219</c:v>
                </c:pt>
                <c:pt idx="60">
                  <c:v>43936.416666666664</c:v>
                </c:pt>
                <c:pt idx="61">
                  <c:v>43936.423611111109</c:v>
                </c:pt>
                <c:pt idx="62">
                  <c:v>43936.430555555555</c:v>
                </c:pt>
                <c:pt idx="63">
                  <c:v>43936.4375</c:v>
                </c:pt>
                <c:pt idx="64">
                  <c:v>43936.444444444445</c:v>
                </c:pt>
                <c:pt idx="65">
                  <c:v>43936.451388888891</c:v>
                </c:pt>
                <c:pt idx="66">
                  <c:v>43936.458333333336</c:v>
                </c:pt>
                <c:pt idx="67">
                  <c:v>43936.465277777781</c:v>
                </c:pt>
                <c:pt idx="68">
                  <c:v>43936.472222222219</c:v>
                </c:pt>
                <c:pt idx="69">
                  <c:v>43936.479166666664</c:v>
                </c:pt>
                <c:pt idx="70">
                  <c:v>43936.486111111109</c:v>
                </c:pt>
                <c:pt idx="71">
                  <c:v>43936.493055555555</c:v>
                </c:pt>
                <c:pt idx="72">
                  <c:v>43936.5</c:v>
                </c:pt>
                <c:pt idx="73">
                  <c:v>43936.506944444445</c:v>
                </c:pt>
                <c:pt idx="74">
                  <c:v>43936.513888888891</c:v>
                </c:pt>
                <c:pt idx="75">
                  <c:v>43936.520833333336</c:v>
                </c:pt>
                <c:pt idx="76">
                  <c:v>43936.527777777781</c:v>
                </c:pt>
                <c:pt idx="77">
                  <c:v>43936.534722222219</c:v>
                </c:pt>
                <c:pt idx="78">
                  <c:v>43936.541666666664</c:v>
                </c:pt>
                <c:pt idx="79">
                  <c:v>43936.548611111109</c:v>
                </c:pt>
                <c:pt idx="80">
                  <c:v>43936.555555555555</c:v>
                </c:pt>
                <c:pt idx="81">
                  <c:v>43936.5625</c:v>
                </c:pt>
                <c:pt idx="82">
                  <c:v>43936.569444444445</c:v>
                </c:pt>
                <c:pt idx="83">
                  <c:v>43936.576388888891</c:v>
                </c:pt>
                <c:pt idx="84">
                  <c:v>43936.583333333336</c:v>
                </c:pt>
                <c:pt idx="85">
                  <c:v>43936.590277777781</c:v>
                </c:pt>
                <c:pt idx="86">
                  <c:v>43936.597222222219</c:v>
                </c:pt>
                <c:pt idx="87">
                  <c:v>43936.604166666664</c:v>
                </c:pt>
                <c:pt idx="88">
                  <c:v>43936.611111111109</c:v>
                </c:pt>
                <c:pt idx="89">
                  <c:v>43936.618055555555</c:v>
                </c:pt>
                <c:pt idx="90">
                  <c:v>43936.625</c:v>
                </c:pt>
                <c:pt idx="91">
                  <c:v>43936.631944444445</c:v>
                </c:pt>
                <c:pt idx="92">
                  <c:v>43936.638888888891</c:v>
                </c:pt>
                <c:pt idx="93">
                  <c:v>43936.645833333336</c:v>
                </c:pt>
                <c:pt idx="94">
                  <c:v>43936.652777777781</c:v>
                </c:pt>
                <c:pt idx="95">
                  <c:v>43936.659722222219</c:v>
                </c:pt>
                <c:pt idx="96">
                  <c:v>43936.666666666664</c:v>
                </c:pt>
                <c:pt idx="97">
                  <c:v>43936.673611111109</c:v>
                </c:pt>
                <c:pt idx="98">
                  <c:v>43936.680555555555</c:v>
                </c:pt>
                <c:pt idx="99">
                  <c:v>43936.6875</c:v>
                </c:pt>
                <c:pt idx="100">
                  <c:v>43936.694444444445</c:v>
                </c:pt>
                <c:pt idx="101">
                  <c:v>43936.701388888891</c:v>
                </c:pt>
                <c:pt idx="102">
                  <c:v>43936.708333333336</c:v>
                </c:pt>
                <c:pt idx="103">
                  <c:v>43936.715277777781</c:v>
                </c:pt>
                <c:pt idx="104">
                  <c:v>43936.722222222219</c:v>
                </c:pt>
                <c:pt idx="105">
                  <c:v>43936.729166666664</c:v>
                </c:pt>
                <c:pt idx="106">
                  <c:v>43936.736111111109</c:v>
                </c:pt>
                <c:pt idx="107">
                  <c:v>43936.743055555555</c:v>
                </c:pt>
                <c:pt idx="108">
                  <c:v>43936.75</c:v>
                </c:pt>
                <c:pt idx="109">
                  <c:v>43936.756944444445</c:v>
                </c:pt>
                <c:pt idx="110">
                  <c:v>43936.763888888891</c:v>
                </c:pt>
                <c:pt idx="111">
                  <c:v>43936.770833333336</c:v>
                </c:pt>
                <c:pt idx="112">
                  <c:v>43936.777777777781</c:v>
                </c:pt>
                <c:pt idx="113">
                  <c:v>43936.784722222219</c:v>
                </c:pt>
                <c:pt idx="114">
                  <c:v>43936.791666666664</c:v>
                </c:pt>
                <c:pt idx="115">
                  <c:v>43936.798611111109</c:v>
                </c:pt>
                <c:pt idx="116">
                  <c:v>43936.805555555555</c:v>
                </c:pt>
                <c:pt idx="117">
                  <c:v>43936.8125</c:v>
                </c:pt>
                <c:pt idx="118">
                  <c:v>43936.819444444445</c:v>
                </c:pt>
                <c:pt idx="119">
                  <c:v>43936.826388888891</c:v>
                </c:pt>
                <c:pt idx="120">
                  <c:v>43936.833333333336</c:v>
                </c:pt>
                <c:pt idx="121">
                  <c:v>43936.840277777781</c:v>
                </c:pt>
                <c:pt idx="122">
                  <c:v>43936.847222222219</c:v>
                </c:pt>
                <c:pt idx="123">
                  <c:v>43936.854166666664</c:v>
                </c:pt>
                <c:pt idx="124">
                  <c:v>43936.861111111109</c:v>
                </c:pt>
                <c:pt idx="125">
                  <c:v>43936.868055555555</c:v>
                </c:pt>
                <c:pt idx="126">
                  <c:v>43936.875</c:v>
                </c:pt>
                <c:pt idx="127">
                  <c:v>43936.881944444445</c:v>
                </c:pt>
                <c:pt idx="128">
                  <c:v>43936.888888888891</c:v>
                </c:pt>
                <c:pt idx="129">
                  <c:v>43936.895833333336</c:v>
                </c:pt>
                <c:pt idx="130">
                  <c:v>43936.902777777781</c:v>
                </c:pt>
                <c:pt idx="131">
                  <c:v>43936.909722222219</c:v>
                </c:pt>
                <c:pt idx="132">
                  <c:v>43936.916666666664</c:v>
                </c:pt>
                <c:pt idx="133">
                  <c:v>43936.923611111109</c:v>
                </c:pt>
                <c:pt idx="134">
                  <c:v>43936.930555555555</c:v>
                </c:pt>
                <c:pt idx="135">
                  <c:v>43936.9375</c:v>
                </c:pt>
                <c:pt idx="136">
                  <c:v>43936.944444444445</c:v>
                </c:pt>
                <c:pt idx="137">
                  <c:v>43936.951388888891</c:v>
                </c:pt>
                <c:pt idx="138">
                  <c:v>43936.958333333336</c:v>
                </c:pt>
                <c:pt idx="139">
                  <c:v>43936.965277777781</c:v>
                </c:pt>
                <c:pt idx="140">
                  <c:v>43936.972222222219</c:v>
                </c:pt>
                <c:pt idx="141">
                  <c:v>43936.979166666664</c:v>
                </c:pt>
                <c:pt idx="142">
                  <c:v>43936.986111111109</c:v>
                </c:pt>
                <c:pt idx="143">
                  <c:v>43936.993055555555</c:v>
                </c:pt>
                <c:pt idx="144">
                  <c:v>43937</c:v>
                </c:pt>
                <c:pt idx="145">
                  <c:v>43937.006944444445</c:v>
                </c:pt>
                <c:pt idx="146">
                  <c:v>43937.013888888891</c:v>
                </c:pt>
                <c:pt idx="147">
                  <c:v>43937.020833333336</c:v>
                </c:pt>
                <c:pt idx="148">
                  <c:v>43937.027777777781</c:v>
                </c:pt>
                <c:pt idx="149">
                  <c:v>43937.034722222219</c:v>
                </c:pt>
                <c:pt idx="150">
                  <c:v>43937.041666666664</c:v>
                </c:pt>
                <c:pt idx="151">
                  <c:v>43937.048611111109</c:v>
                </c:pt>
                <c:pt idx="152">
                  <c:v>43937.055555555555</c:v>
                </c:pt>
                <c:pt idx="153">
                  <c:v>43937.0625</c:v>
                </c:pt>
                <c:pt idx="154">
                  <c:v>43937.069444444445</c:v>
                </c:pt>
                <c:pt idx="155">
                  <c:v>43937.076388888891</c:v>
                </c:pt>
                <c:pt idx="156">
                  <c:v>43937.083333333336</c:v>
                </c:pt>
                <c:pt idx="157">
                  <c:v>43937.090277777781</c:v>
                </c:pt>
                <c:pt idx="158">
                  <c:v>43937.097222222219</c:v>
                </c:pt>
                <c:pt idx="159">
                  <c:v>43937.104166666664</c:v>
                </c:pt>
                <c:pt idx="160">
                  <c:v>43937.111111111109</c:v>
                </c:pt>
                <c:pt idx="161">
                  <c:v>43937.118055555555</c:v>
                </c:pt>
                <c:pt idx="162">
                  <c:v>43937.125</c:v>
                </c:pt>
                <c:pt idx="163">
                  <c:v>43937.131944444445</c:v>
                </c:pt>
                <c:pt idx="164">
                  <c:v>43937.138888888891</c:v>
                </c:pt>
                <c:pt idx="165">
                  <c:v>43937.145833333336</c:v>
                </c:pt>
                <c:pt idx="166">
                  <c:v>43937.152777777781</c:v>
                </c:pt>
                <c:pt idx="167">
                  <c:v>43937.159722222219</c:v>
                </c:pt>
                <c:pt idx="168">
                  <c:v>43937.166666666664</c:v>
                </c:pt>
                <c:pt idx="169">
                  <c:v>43937.173611111109</c:v>
                </c:pt>
                <c:pt idx="170">
                  <c:v>43937.180555555555</c:v>
                </c:pt>
                <c:pt idx="171">
                  <c:v>43937.1875</c:v>
                </c:pt>
                <c:pt idx="172">
                  <c:v>43937.194444444445</c:v>
                </c:pt>
                <c:pt idx="173">
                  <c:v>43937.201388888891</c:v>
                </c:pt>
                <c:pt idx="174">
                  <c:v>43937.208333333336</c:v>
                </c:pt>
                <c:pt idx="175">
                  <c:v>43937.215277777781</c:v>
                </c:pt>
                <c:pt idx="176">
                  <c:v>43937.222222222219</c:v>
                </c:pt>
                <c:pt idx="177">
                  <c:v>43937.229166666664</c:v>
                </c:pt>
                <c:pt idx="178">
                  <c:v>43937.236111111109</c:v>
                </c:pt>
                <c:pt idx="179">
                  <c:v>43937.243055555555</c:v>
                </c:pt>
                <c:pt idx="180">
                  <c:v>43937.25</c:v>
                </c:pt>
                <c:pt idx="181">
                  <c:v>43937.256944444445</c:v>
                </c:pt>
                <c:pt idx="182">
                  <c:v>43937.263888888891</c:v>
                </c:pt>
                <c:pt idx="183">
                  <c:v>43937.270833333336</c:v>
                </c:pt>
                <c:pt idx="184">
                  <c:v>43937.277777777781</c:v>
                </c:pt>
                <c:pt idx="185">
                  <c:v>43937.284722222219</c:v>
                </c:pt>
                <c:pt idx="186">
                  <c:v>43937.291666666664</c:v>
                </c:pt>
                <c:pt idx="187">
                  <c:v>43937.298611111109</c:v>
                </c:pt>
                <c:pt idx="188">
                  <c:v>43937.305555555555</c:v>
                </c:pt>
                <c:pt idx="189">
                  <c:v>43937.3125</c:v>
                </c:pt>
                <c:pt idx="190">
                  <c:v>43937.319444444445</c:v>
                </c:pt>
                <c:pt idx="191">
                  <c:v>43937.326388888891</c:v>
                </c:pt>
                <c:pt idx="192">
                  <c:v>43937.333333333336</c:v>
                </c:pt>
                <c:pt idx="193">
                  <c:v>43937.340277777781</c:v>
                </c:pt>
                <c:pt idx="194">
                  <c:v>43937.347222222219</c:v>
                </c:pt>
                <c:pt idx="195">
                  <c:v>43937.354166666664</c:v>
                </c:pt>
                <c:pt idx="196">
                  <c:v>43937.361111111109</c:v>
                </c:pt>
                <c:pt idx="197">
                  <c:v>43937.368055555555</c:v>
                </c:pt>
                <c:pt idx="198">
                  <c:v>43937.375</c:v>
                </c:pt>
                <c:pt idx="199">
                  <c:v>43937.381944444445</c:v>
                </c:pt>
                <c:pt idx="200">
                  <c:v>43937.388888888891</c:v>
                </c:pt>
                <c:pt idx="201">
                  <c:v>43937.395833333336</c:v>
                </c:pt>
                <c:pt idx="202">
                  <c:v>43937.402777777781</c:v>
                </c:pt>
                <c:pt idx="203">
                  <c:v>43937.409722222219</c:v>
                </c:pt>
                <c:pt idx="204">
                  <c:v>43937.416666666664</c:v>
                </c:pt>
                <c:pt idx="205">
                  <c:v>43937.423611111109</c:v>
                </c:pt>
                <c:pt idx="206">
                  <c:v>43937.430555555555</c:v>
                </c:pt>
                <c:pt idx="207">
                  <c:v>43937.4375</c:v>
                </c:pt>
                <c:pt idx="208">
                  <c:v>43937.444444444445</c:v>
                </c:pt>
                <c:pt idx="209">
                  <c:v>43937.451388888891</c:v>
                </c:pt>
                <c:pt idx="210">
                  <c:v>43937.458333333336</c:v>
                </c:pt>
                <c:pt idx="211">
                  <c:v>43937.465277777781</c:v>
                </c:pt>
                <c:pt idx="212">
                  <c:v>43937.472222222219</c:v>
                </c:pt>
                <c:pt idx="213">
                  <c:v>43937.479166666664</c:v>
                </c:pt>
                <c:pt idx="214">
                  <c:v>43937.486111111109</c:v>
                </c:pt>
                <c:pt idx="215">
                  <c:v>43937.493055555555</c:v>
                </c:pt>
                <c:pt idx="216">
                  <c:v>43937.5</c:v>
                </c:pt>
                <c:pt idx="217">
                  <c:v>43937.506944444445</c:v>
                </c:pt>
                <c:pt idx="218">
                  <c:v>43937.513888888891</c:v>
                </c:pt>
                <c:pt idx="219">
                  <c:v>43937.520833333336</c:v>
                </c:pt>
                <c:pt idx="220">
                  <c:v>43937.527777777781</c:v>
                </c:pt>
                <c:pt idx="221">
                  <c:v>43937.534722222219</c:v>
                </c:pt>
                <c:pt idx="222">
                  <c:v>43937.541666666664</c:v>
                </c:pt>
                <c:pt idx="223">
                  <c:v>43937.548611111109</c:v>
                </c:pt>
                <c:pt idx="224">
                  <c:v>43937.555555555555</c:v>
                </c:pt>
                <c:pt idx="225">
                  <c:v>43937.5625</c:v>
                </c:pt>
                <c:pt idx="226">
                  <c:v>43937.569444444445</c:v>
                </c:pt>
                <c:pt idx="227">
                  <c:v>43937.576388888891</c:v>
                </c:pt>
                <c:pt idx="228">
                  <c:v>43937.583333333336</c:v>
                </c:pt>
                <c:pt idx="229">
                  <c:v>43937.590277777781</c:v>
                </c:pt>
                <c:pt idx="230">
                  <c:v>43937.597222222219</c:v>
                </c:pt>
                <c:pt idx="231">
                  <c:v>43937.604166666664</c:v>
                </c:pt>
                <c:pt idx="232">
                  <c:v>43937.611111111109</c:v>
                </c:pt>
                <c:pt idx="233">
                  <c:v>43937.618055555555</c:v>
                </c:pt>
                <c:pt idx="234">
                  <c:v>43937.625</c:v>
                </c:pt>
                <c:pt idx="235">
                  <c:v>43937.631944444445</c:v>
                </c:pt>
                <c:pt idx="236">
                  <c:v>43937.638888888891</c:v>
                </c:pt>
                <c:pt idx="237">
                  <c:v>43937.645833333336</c:v>
                </c:pt>
                <c:pt idx="238">
                  <c:v>43937.652777777781</c:v>
                </c:pt>
                <c:pt idx="239">
                  <c:v>43937.659722222219</c:v>
                </c:pt>
                <c:pt idx="240">
                  <c:v>43937.666666666664</c:v>
                </c:pt>
                <c:pt idx="241">
                  <c:v>43937.673611111109</c:v>
                </c:pt>
                <c:pt idx="242">
                  <c:v>43937.680555555555</c:v>
                </c:pt>
                <c:pt idx="243">
                  <c:v>43937.6875</c:v>
                </c:pt>
                <c:pt idx="244">
                  <c:v>43937.694444444445</c:v>
                </c:pt>
                <c:pt idx="245">
                  <c:v>43937.701388888891</c:v>
                </c:pt>
                <c:pt idx="246">
                  <c:v>43937.708333333336</c:v>
                </c:pt>
                <c:pt idx="247">
                  <c:v>43937.715277777781</c:v>
                </c:pt>
                <c:pt idx="248">
                  <c:v>43937.722222222219</c:v>
                </c:pt>
                <c:pt idx="249">
                  <c:v>43937.729166666664</c:v>
                </c:pt>
                <c:pt idx="250">
                  <c:v>43937.736111111109</c:v>
                </c:pt>
                <c:pt idx="251">
                  <c:v>43937.743055555555</c:v>
                </c:pt>
                <c:pt idx="252">
                  <c:v>43937.75</c:v>
                </c:pt>
                <c:pt idx="253">
                  <c:v>43937.756944444445</c:v>
                </c:pt>
                <c:pt idx="254">
                  <c:v>43937.763888888891</c:v>
                </c:pt>
                <c:pt idx="255">
                  <c:v>43937.770833333336</c:v>
                </c:pt>
                <c:pt idx="256">
                  <c:v>43937.777777777781</c:v>
                </c:pt>
                <c:pt idx="257">
                  <c:v>43937.784722222219</c:v>
                </c:pt>
                <c:pt idx="258">
                  <c:v>43937.791666666664</c:v>
                </c:pt>
                <c:pt idx="259">
                  <c:v>43937.798611111109</c:v>
                </c:pt>
                <c:pt idx="260">
                  <c:v>43937.805555555555</c:v>
                </c:pt>
                <c:pt idx="261">
                  <c:v>43937.8125</c:v>
                </c:pt>
                <c:pt idx="262">
                  <c:v>43937.819444444445</c:v>
                </c:pt>
                <c:pt idx="263">
                  <c:v>43937.826388888891</c:v>
                </c:pt>
                <c:pt idx="264">
                  <c:v>43937.833333333336</c:v>
                </c:pt>
                <c:pt idx="265">
                  <c:v>43937.840277777781</c:v>
                </c:pt>
                <c:pt idx="266">
                  <c:v>43937.847222222219</c:v>
                </c:pt>
                <c:pt idx="267">
                  <c:v>43937.854166666664</c:v>
                </c:pt>
                <c:pt idx="268">
                  <c:v>43937.861111111109</c:v>
                </c:pt>
                <c:pt idx="269">
                  <c:v>43937.868055555555</c:v>
                </c:pt>
                <c:pt idx="270">
                  <c:v>43937.875</c:v>
                </c:pt>
                <c:pt idx="271">
                  <c:v>43937.881944444445</c:v>
                </c:pt>
                <c:pt idx="272">
                  <c:v>43937.888888888891</c:v>
                </c:pt>
                <c:pt idx="273">
                  <c:v>43937.895833333336</c:v>
                </c:pt>
                <c:pt idx="274">
                  <c:v>43937.902777777781</c:v>
                </c:pt>
                <c:pt idx="275">
                  <c:v>43937.909722222219</c:v>
                </c:pt>
                <c:pt idx="276">
                  <c:v>43937.916666666664</c:v>
                </c:pt>
                <c:pt idx="277">
                  <c:v>43937.923611111109</c:v>
                </c:pt>
                <c:pt idx="278">
                  <c:v>43937.930555555555</c:v>
                </c:pt>
                <c:pt idx="279">
                  <c:v>43937.9375</c:v>
                </c:pt>
                <c:pt idx="280">
                  <c:v>43937.944444444445</c:v>
                </c:pt>
                <c:pt idx="281">
                  <c:v>43937.951388888891</c:v>
                </c:pt>
                <c:pt idx="282">
                  <c:v>43937.958333333336</c:v>
                </c:pt>
                <c:pt idx="283">
                  <c:v>43937.965277777781</c:v>
                </c:pt>
                <c:pt idx="284">
                  <c:v>43937.972222222219</c:v>
                </c:pt>
                <c:pt idx="285">
                  <c:v>43937.979166666664</c:v>
                </c:pt>
                <c:pt idx="286">
                  <c:v>43937.986111111109</c:v>
                </c:pt>
                <c:pt idx="287">
                  <c:v>43937.993055555555</c:v>
                </c:pt>
                <c:pt idx="288">
                  <c:v>43938</c:v>
                </c:pt>
                <c:pt idx="289">
                  <c:v>43938.006944444445</c:v>
                </c:pt>
                <c:pt idx="290">
                  <c:v>43938.013888888891</c:v>
                </c:pt>
                <c:pt idx="291">
                  <c:v>43938.020833333336</c:v>
                </c:pt>
                <c:pt idx="292">
                  <c:v>43938.027777777781</c:v>
                </c:pt>
                <c:pt idx="293">
                  <c:v>43938.034722222219</c:v>
                </c:pt>
                <c:pt idx="294">
                  <c:v>43938.041666666664</c:v>
                </c:pt>
                <c:pt idx="295">
                  <c:v>43938.048611111109</c:v>
                </c:pt>
                <c:pt idx="296">
                  <c:v>43938.055555555555</c:v>
                </c:pt>
                <c:pt idx="297">
                  <c:v>43938.0625</c:v>
                </c:pt>
                <c:pt idx="298">
                  <c:v>43938.069444444445</c:v>
                </c:pt>
                <c:pt idx="299">
                  <c:v>43938.076388888891</c:v>
                </c:pt>
                <c:pt idx="300">
                  <c:v>43938.083333333336</c:v>
                </c:pt>
                <c:pt idx="301">
                  <c:v>43938.090277777781</c:v>
                </c:pt>
                <c:pt idx="302">
                  <c:v>43938.097222222219</c:v>
                </c:pt>
                <c:pt idx="303">
                  <c:v>43938.104166666664</c:v>
                </c:pt>
                <c:pt idx="304">
                  <c:v>43938.111111111109</c:v>
                </c:pt>
                <c:pt idx="305">
                  <c:v>43938.118055555555</c:v>
                </c:pt>
                <c:pt idx="306">
                  <c:v>43938.125</c:v>
                </c:pt>
                <c:pt idx="307">
                  <c:v>43938.131944444445</c:v>
                </c:pt>
                <c:pt idx="308">
                  <c:v>43938.138888888891</c:v>
                </c:pt>
                <c:pt idx="309">
                  <c:v>43938.145833333336</c:v>
                </c:pt>
                <c:pt idx="310">
                  <c:v>43938.152777777781</c:v>
                </c:pt>
                <c:pt idx="311">
                  <c:v>43938.159722222219</c:v>
                </c:pt>
                <c:pt idx="312">
                  <c:v>43938.166666666664</c:v>
                </c:pt>
                <c:pt idx="313">
                  <c:v>43938.173611111109</c:v>
                </c:pt>
                <c:pt idx="314">
                  <c:v>43938.180555555555</c:v>
                </c:pt>
                <c:pt idx="315">
                  <c:v>43938.1875</c:v>
                </c:pt>
                <c:pt idx="316">
                  <c:v>43938.194444444445</c:v>
                </c:pt>
                <c:pt idx="317">
                  <c:v>43938.201388888891</c:v>
                </c:pt>
                <c:pt idx="318">
                  <c:v>43938.208333333336</c:v>
                </c:pt>
                <c:pt idx="319">
                  <c:v>43938.215277777781</c:v>
                </c:pt>
                <c:pt idx="320">
                  <c:v>43938.222222222219</c:v>
                </c:pt>
                <c:pt idx="321">
                  <c:v>43938.229166666664</c:v>
                </c:pt>
                <c:pt idx="322">
                  <c:v>43938.236111111109</c:v>
                </c:pt>
                <c:pt idx="323">
                  <c:v>43938.243055555555</c:v>
                </c:pt>
                <c:pt idx="324">
                  <c:v>43938.25</c:v>
                </c:pt>
                <c:pt idx="325">
                  <c:v>43938.256944444445</c:v>
                </c:pt>
                <c:pt idx="326">
                  <c:v>43938.263888888891</c:v>
                </c:pt>
                <c:pt idx="327">
                  <c:v>43938.270833333336</c:v>
                </c:pt>
                <c:pt idx="328">
                  <c:v>43938.277777777781</c:v>
                </c:pt>
                <c:pt idx="329">
                  <c:v>43938.284722222219</c:v>
                </c:pt>
                <c:pt idx="330">
                  <c:v>43938.291666666664</c:v>
                </c:pt>
                <c:pt idx="331">
                  <c:v>43938.298611111109</c:v>
                </c:pt>
                <c:pt idx="332">
                  <c:v>43938.305555555555</c:v>
                </c:pt>
                <c:pt idx="333">
                  <c:v>43938.3125</c:v>
                </c:pt>
                <c:pt idx="334">
                  <c:v>43938.319444444445</c:v>
                </c:pt>
                <c:pt idx="335">
                  <c:v>43938.326388888891</c:v>
                </c:pt>
                <c:pt idx="336">
                  <c:v>43938.333333333336</c:v>
                </c:pt>
                <c:pt idx="337">
                  <c:v>43938.340277777781</c:v>
                </c:pt>
                <c:pt idx="338">
                  <c:v>43938.347222222219</c:v>
                </c:pt>
                <c:pt idx="339">
                  <c:v>43938.354166666664</c:v>
                </c:pt>
                <c:pt idx="340">
                  <c:v>43938.361111111109</c:v>
                </c:pt>
                <c:pt idx="341">
                  <c:v>43938.368055555555</c:v>
                </c:pt>
                <c:pt idx="342">
                  <c:v>43938.375</c:v>
                </c:pt>
                <c:pt idx="343">
                  <c:v>43938.381944444445</c:v>
                </c:pt>
                <c:pt idx="344">
                  <c:v>43938.388888888891</c:v>
                </c:pt>
                <c:pt idx="345">
                  <c:v>43938.395833333336</c:v>
                </c:pt>
                <c:pt idx="346">
                  <c:v>43938.402777777781</c:v>
                </c:pt>
                <c:pt idx="347">
                  <c:v>43938.409722222219</c:v>
                </c:pt>
                <c:pt idx="348">
                  <c:v>43938.416666666664</c:v>
                </c:pt>
                <c:pt idx="349">
                  <c:v>43938.423611111109</c:v>
                </c:pt>
                <c:pt idx="350">
                  <c:v>43938.430555555555</c:v>
                </c:pt>
                <c:pt idx="351">
                  <c:v>43938.4375</c:v>
                </c:pt>
                <c:pt idx="352">
                  <c:v>43938.444444444445</c:v>
                </c:pt>
                <c:pt idx="353">
                  <c:v>43938.451388888891</c:v>
                </c:pt>
                <c:pt idx="354">
                  <c:v>43938.458333333336</c:v>
                </c:pt>
                <c:pt idx="355">
                  <c:v>43938.465277777781</c:v>
                </c:pt>
                <c:pt idx="356">
                  <c:v>43938.472222222219</c:v>
                </c:pt>
                <c:pt idx="357">
                  <c:v>43938.479166666664</c:v>
                </c:pt>
                <c:pt idx="358">
                  <c:v>43938.486111111109</c:v>
                </c:pt>
                <c:pt idx="359">
                  <c:v>43938.493055555555</c:v>
                </c:pt>
                <c:pt idx="360">
                  <c:v>43938.5</c:v>
                </c:pt>
                <c:pt idx="361">
                  <c:v>43938.506944444445</c:v>
                </c:pt>
                <c:pt idx="362">
                  <c:v>43938.513888888891</c:v>
                </c:pt>
                <c:pt idx="363">
                  <c:v>43938.520833333336</c:v>
                </c:pt>
                <c:pt idx="364">
                  <c:v>43938.527777777781</c:v>
                </c:pt>
                <c:pt idx="365">
                  <c:v>43938.534722222219</c:v>
                </c:pt>
                <c:pt idx="366">
                  <c:v>43938.541666666664</c:v>
                </c:pt>
                <c:pt idx="367">
                  <c:v>43938.548611111109</c:v>
                </c:pt>
                <c:pt idx="368">
                  <c:v>43938.555555555555</c:v>
                </c:pt>
                <c:pt idx="369">
                  <c:v>43938.5625</c:v>
                </c:pt>
                <c:pt idx="370">
                  <c:v>43938.569444444445</c:v>
                </c:pt>
                <c:pt idx="371">
                  <c:v>43938.576388888891</c:v>
                </c:pt>
                <c:pt idx="372">
                  <c:v>43938.583333333336</c:v>
                </c:pt>
                <c:pt idx="373">
                  <c:v>43938.590277777781</c:v>
                </c:pt>
                <c:pt idx="374">
                  <c:v>43938.597222222219</c:v>
                </c:pt>
                <c:pt idx="375">
                  <c:v>43938.604166666664</c:v>
                </c:pt>
                <c:pt idx="376">
                  <c:v>43938.611111111109</c:v>
                </c:pt>
                <c:pt idx="377">
                  <c:v>43938.618055555555</c:v>
                </c:pt>
                <c:pt idx="378">
                  <c:v>43938.625</c:v>
                </c:pt>
                <c:pt idx="379">
                  <c:v>43938.631944444445</c:v>
                </c:pt>
                <c:pt idx="380">
                  <c:v>43938.638888888891</c:v>
                </c:pt>
                <c:pt idx="381">
                  <c:v>43938.645833333336</c:v>
                </c:pt>
                <c:pt idx="382">
                  <c:v>43938.652777777781</c:v>
                </c:pt>
                <c:pt idx="383">
                  <c:v>43938.659722222219</c:v>
                </c:pt>
                <c:pt idx="384">
                  <c:v>43938.666666666664</c:v>
                </c:pt>
                <c:pt idx="385">
                  <c:v>43938.673611111109</c:v>
                </c:pt>
                <c:pt idx="386">
                  <c:v>43938.680555555555</c:v>
                </c:pt>
                <c:pt idx="387">
                  <c:v>43938.6875</c:v>
                </c:pt>
                <c:pt idx="388">
                  <c:v>43938.694444444445</c:v>
                </c:pt>
                <c:pt idx="389">
                  <c:v>43938.701388888891</c:v>
                </c:pt>
                <c:pt idx="390">
                  <c:v>43938.708333333336</c:v>
                </c:pt>
                <c:pt idx="391">
                  <c:v>43938.715277777781</c:v>
                </c:pt>
                <c:pt idx="392">
                  <c:v>43938.722222222219</c:v>
                </c:pt>
                <c:pt idx="393">
                  <c:v>43938.729166666664</c:v>
                </c:pt>
                <c:pt idx="394">
                  <c:v>43938.736111111109</c:v>
                </c:pt>
                <c:pt idx="395">
                  <c:v>43938.743055555555</c:v>
                </c:pt>
                <c:pt idx="396">
                  <c:v>43938.75</c:v>
                </c:pt>
                <c:pt idx="397">
                  <c:v>43938.756944444445</c:v>
                </c:pt>
                <c:pt idx="398">
                  <c:v>43938.763888888891</c:v>
                </c:pt>
                <c:pt idx="399">
                  <c:v>43938.770833333336</c:v>
                </c:pt>
                <c:pt idx="400">
                  <c:v>43938.777777777781</c:v>
                </c:pt>
                <c:pt idx="401">
                  <c:v>43938.784722222219</c:v>
                </c:pt>
                <c:pt idx="402">
                  <c:v>43938.791666666664</c:v>
                </c:pt>
                <c:pt idx="403">
                  <c:v>43938.798611111109</c:v>
                </c:pt>
                <c:pt idx="404">
                  <c:v>43938.805555555555</c:v>
                </c:pt>
                <c:pt idx="405">
                  <c:v>43938.8125</c:v>
                </c:pt>
                <c:pt idx="406">
                  <c:v>43938.819444444445</c:v>
                </c:pt>
                <c:pt idx="407">
                  <c:v>43938.826388888891</c:v>
                </c:pt>
                <c:pt idx="408">
                  <c:v>43938.833333333336</c:v>
                </c:pt>
                <c:pt idx="409">
                  <c:v>43938.840277777781</c:v>
                </c:pt>
                <c:pt idx="410">
                  <c:v>43938.847222222219</c:v>
                </c:pt>
                <c:pt idx="411">
                  <c:v>43938.854166666664</c:v>
                </c:pt>
                <c:pt idx="412">
                  <c:v>43938.861111111109</c:v>
                </c:pt>
                <c:pt idx="413">
                  <c:v>43938.868055555555</c:v>
                </c:pt>
                <c:pt idx="414">
                  <c:v>43938.875</c:v>
                </c:pt>
                <c:pt idx="415">
                  <c:v>43938.881944444445</c:v>
                </c:pt>
                <c:pt idx="416">
                  <c:v>43938.888888888891</c:v>
                </c:pt>
                <c:pt idx="417">
                  <c:v>43938.895833333336</c:v>
                </c:pt>
                <c:pt idx="418">
                  <c:v>43938.902777777781</c:v>
                </c:pt>
                <c:pt idx="419">
                  <c:v>43938.909722222219</c:v>
                </c:pt>
                <c:pt idx="420">
                  <c:v>43938.916666666664</c:v>
                </c:pt>
                <c:pt idx="421">
                  <c:v>43938.923611111109</c:v>
                </c:pt>
                <c:pt idx="422">
                  <c:v>43938.930555555555</c:v>
                </c:pt>
                <c:pt idx="423">
                  <c:v>43938.9375</c:v>
                </c:pt>
                <c:pt idx="424">
                  <c:v>43938.944444444445</c:v>
                </c:pt>
                <c:pt idx="425">
                  <c:v>43938.951388888891</c:v>
                </c:pt>
                <c:pt idx="426">
                  <c:v>43938.958333333336</c:v>
                </c:pt>
                <c:pt idx="427">
                  <c:v>43938.965277777781</c:v>
                </c:pt>
                <c:pt idx="428">
                  <c:v>43938.972222222219</c:v>
                </c:pt>
                <c:pt idx="429">
                  <c:v>43938.979166666664</c:v>
                </c:pt>
                <c:pt idx="430">
                  <c:v>43938.986111111109</c:v>
                </c:pt>
                <c:pt idx="431">
                  <c:v>43938.993055555555</c:v>
                </c:pt>
                <c:pt idx="432">
                  <c:v>43939</c:v>
                </c:pt>
                <c:pt idx="433">
                  <c:v>43939.006944444445</c:v>
                </c:pt>
                <c:pt idx="434">
                  <c:v>43939.013888888891</c:v>
                </c:pt>
                <c:pt idx="435">
                  <c:v>43939.020833333336</c:v>
                </c:pt>
                <c:pt idx="436">
                  <c:v>43939.027777777781</c:v>
                </c:pt>
                <c:pt idx="437">
                  <c:v>43939.034722222219</c:v>
                </c:pt>
                <c:pt idx="438">
                  <c:v>43939.041666666664</c:v>
                </c:pt>
                <c:pt idx="439">
                  <c:v>43939.048611111109</c:v>
                </c:pt>
                <c:pt idx="440">
                  <c:v>43939.055555555555</c:v>
                </c:pt>
                <c:pt idx="441">
                  <c:v>43939.0625</c:v>
                </c:pt>
                <c:pt idx="442">
                  <c:v>43939.069444444445</c:v>
                </c:pt>
                <c:pt idx="443">
                  <c:v>43939.076388888891</c:v>
                </c:pt>
                <c:pt idx="444">
                  <c:v>43939.083333333336</c:v>
                </c:pt>
                <c:pt idx="445">
                  <c:v>43939.090277777781</c:v>
                </c:pt>
                <c:pt idx="446">
                  <c:v>43939.097222222219</c:v>
                </c:pt>
                <c:pt idx="447">
                  <c:v>43939.104166666664</c:v>
                </c:pt>
                <c:pt idx="448">
                  <c:v>43939.111111111109</c:v>
                </c:pt>
                <c:pt idx="449">
                  <c:v>43939.118055555555</c:v>
                </c:pt>
                <c:pt idx="450">
                  <c:v>43939.125</c:v>
                </c:pt>
                <c:pt idx="451">
                  <c:v>43939.131944444445</c:v>
                </c:pt>
                <c:pt idx="452">
                  <c:v>43939.138888888891</c:v>
                </c:pt>
                <c:pt idx="453">
                  <c:v>43939.145833333336</c:v>
                </c:pt>
                <c:pt idx="454">
                  <c:v>43939.152777777781</c:v>
                </c:pt>
                <c:pt idx="455">
                  <c:v>43939.159722222219</c:v>
                </c:pt>
                <c:pt idx="456">
                  <c:v>43939.166666666664</c:v>
                </c:pt>
                <c:pt idx="457">
                  <c:v>43939.173611111109</c:v>
                </c:pt>
                <c:pt idx="458">
                  <c:v>43939.180555555555</c:v>
                </c:pt>
                <c:pt idx="459">
                  <c:v>43939.1875</c:v>
                </c:pt>
                <c:pt idx="460">
                  <c:v>43939.194444444445</c:v>
                </c:pt>
                <c:pt idx="461">
                  <c:v>43939.201388888891</c:v>
                </c:pt>
                <c:pt idx="462">
                  <c:v>43939.208333333336</c:v>
                </c:pt>
                <c:pt idx="463">
                  <c:v>43939.215277777781</c:v>
                </c:pt>
                <c:pt idx="464">
                  <c:v>43939.222222222219</c:v>
                </c:pt>
                <c:pt idx="465">
                  <c:v>43939.229166666664</c:v>
                </c:pt>
                <c:pt idx="466">
                  <c:v>43939.236111111109</c:v>
                </c:pt>
                <c:pt idx="467">
                  <c:v>43939.243055555555</c:v>
                </c:pt>
                <c:pt idx="468">
                  <c:v>43939.25</c:v>
                </c:pt>
                <c:pt idx="469">
                  <c:v>43939.256944444445</c:v>
                </c:pt>
                <c:pt idx="470">
                  <c:v>43939.263888888891</c:v>
                </c:pt>
                <c:pt idx="471">
                  <c:v>43939.270833333336</c:v>
                </c:pt>
                <c:pt idx="472">
                  <c:v>43939.277777777781</c:v>
                </c:pt>
                <c:pt idx="473">
                  <c:v>43939.284722222219</c:v>
                </c:pt>
                <c:pt idx="474">
                  <c:v>43939.291666666664</c:v>
                </c:pt>
                <c:pt idx="475">
                  <c:v>43939.298611111109</c:v>
                </c:pt>
                <c:pt idx="476">
                  <c:v>43939.305555555555</c:v>
                </c:pt>
                <c:pt idx="477">
                  <c:v>43939.3125</c:v>
                </c:pt>
                <c:pt idx="478">
                  <c:v>43939.319444444445</c:v>
                </c:pt>
                <c:pt idx="479">
                  <c:v>43939.326388888891</c:v>
                </c:pt>
                <c:pt idx="480">
                  <c:v>43939.333333333336</c:v>
                </c:pt>
                <c:pt idx="481">
                  <c:v>43939.340277777781</c:v>
                </c:pt>
                <c:pt idx="482">
                  <c:v>43939.347222222219</c:v>
                </c:pt>
                <c:pt idx="483">
                  <c:v>43939.354166666664</c:v>
                </c:pt>
                <c:pt idx="484">
                  <c:v>43939.361111111109</c:v>
                </c:pt>
                <c:pt idx="485">
                  <c:v>43939.368055555555</c:v>
                </c:pt>
                <c:pt idx="486">
                  <c:v>43939.375</c:v>
                </c:pt>
                <c:pt idx="487">
                  <c:v>43939.381944444445</c:v>
                </c:pt>
                <c:pt idx="488">
                  <c:v>43939.388888888891</c:v>
                </c:pt>
                <c:pt idx="489">
                  <c:v>43939.395833333336</c:v>
                </c:pt>
                <c:pt idx="490">
                  <c:v>43939.402777777781</c:v>
                </c:pt>
                <c:pt idx="491">
                  <c:v>43939.409722222219</c:v>
                </c:pt>
                <c:pt idx="492">
                  <c:v>43939.416666666664</c:v>
                </c:pt>
                <c:pt idx="493">
                  <c:v>43939.423611111109</c:v>
                </c:pt>
                <c:pt idx="494">
                  <c:v>43939.430555555555</c:v>
                </c:pt>
                <c:pt idx="495">
                  <c:v>43939.4375</c:v>
                </c:pt>
                <c:pt idx="496">
                  <c:v>43939.444444444445</c:v>
                </c:pt>
                <c:pt idx="497">
                  <c:v>43939.451388888891</c:v>
                </c:pt>
                <c:pt idx="498">
                  <c:v>43939.458333333336</c:v>
                </c:pt>
                <c:pt idx="499">
                  <c:v>43939.465277777781</c:v>
                </c:pt>
                <c:pt idx="500">
                  <c:v>43939.472222222219</c:v>
                </c:pt>
                <c:pt idx="501">
                  <c:v>43939.479166666664</c:v>
                </c:pt>
                <c:pt idx="502">
                  <c:v>43939.486111111109</c:v>
                </c:pt>
                <c:pt idx="503">
                  <c:v>43939.493055555555</c:v>
                </c:pt>
                <c:pt idx="504">
                  <c:v>43939.5</c:v>
                </c:pt>
                <c:pt idx="505">
                  <c:v>43939.506944444445</c:v>
                </c:pt>
                <c:pt idx="506">
                  <c:v>43939.513888888891</c:v>
                </c:pt>
                <c:pt idx="507">
                  <c:v>43939.520833333336</c:v>
                </c:pt>
                <c:pt idx="508">
                  <c:v>43939.527777777781</c:v>
                </c:pt>
                <c:pt idx="509">
                  <c:v>43939.534722222219</c:v>
                </c:pt>
                <c:pt idx="510">
                  <c:v>43939.541666666664</c:v>
                </c:pt>
                <c:pt idx="511">
                  <c:v>43939.548611111109</c:v>
                </c:pt>
                <c:pt idx="512">
                  <c:v>43939.555555555555</c:v>
                </c:pt>
                <c:pt idx="513">
                  <c:v>43939.5625</c:v>
                </c:pt>
                <c:pt idx="514">
                  <c:v>43939.569444444445</c:v>
                </c:pt>
                <c:pt idx="515">
                  <c:v>43939.576388888891</c:v>
                </c:pt>
                <c:pt idx="516">
                  <c:v>43939.583333333336</c:v>
                </c:pt>
                <c:pt idx="517">
                  <c:v>43939.590277777781</c:v>
                </c:pt>
                <c:pt idx="518">
                  <c:v>43939.597222222219</c:v>
                </c:pt>
                <c:pt idx="519">
                  <c:v>43939.604166666664</c:v>
                </c:pt>
                <c:pt idx="520">
                  <c:v>43939.611111111109</c:v>
                </c:pt>
                <c:pt idx="521">
                  <c:v>43939.618055555555</c:v>
                </c:pt>
                <c:pt idx="522">
                  <c:v>43939.625</c:v>
                </c:pt>
                <c:pt idx="523">
                  <c:v>43939.631944444445</c:v>
                </c:pt>
                <c:pt idx="524">
                  <c:v>43939.638888888891</c:v>
                </c:pt>
                <c:pt idx="525">
                  <c:v>43939.645833333336</c:v>
                </c:pt>
                <c:pt idx="526">
                  <c:v>43939.652777777781</c:v>
                </c:pt>
                <c:pt idx="527">
                  <c:v>43939.659722222219</c:v>
                </c:pt>
                <c:pt idx="528">
                  <c:v>43939.666666666664</c:v>
                </c:pt>
                <c:pt idx="529">
                  <c:v>43939.673611111109</c:v>
                </c:pt>
                <c:pt idx="530">
                  <c:v>43939.680555555555</c:v>
                </c:pt>
                <c:pt idx="531">
                  <c:v>43939.6875</c:v>
                </c:pt>
                <c:pt idx="532">
                  <c:v>43939.694444444445</c:v>
                </c:pt>
                <c:pt idx="533">
                  <c:v>43939.701388888891</c:v>
                </c:pt>
                <c:pt idx="534">
                  <c:v>43939.708333333336</c:v>
                </c:pt>
                <c:pt idx="535">
                  <c:v>43939.715277777781</c:v>
                </c:pt>
                <c:pt idx="536">
                  <c:v>43939.722222222219</c:v>
                </c:pt>
                <c:pt idx="537">
                  <c:v>43939.729166666664</c:v>
                </c:pt>
                <c:pt idx="538">
                  <c:v>43939.736111111109</c:v>
                </c:pt>
                <c:pt idx="539">
                  <c:v>43939.743055555555</c:v>
                </c:pt>
                <c:pt idx="540">
                  <c:v>43939.75</c:v>
                </c:pt>
                <c:pt idx="541">
                  <c:v>43939.756944444445</c:v>
                </c:pt>
                <c:pt idx="542">
                  <c:v>43939.763888888891</c:v>
                </c:pt>
                <c:pt idx="543">
                  <c:v>43939.770833333336</c:v>
                </c:pt>
                <c:pt idx="544">
                  <c:v>43939.777777777781</c:v>
                </c:pt>
                <c:pt idx="545">
                  <c:v>43939.784722222219</c:v>
                </c:pt>
                <c:pt idx="546">
                  <c:v>43939.791666666664</c:v>
                </c:pt>
                <c:pt idx="547">
                  <c:v>43939.798611111109</c:v>
                </c:pt>
                <c:pt idx="548">
                  <c:v>43939.805555555555</c:v>
                </c:pt>
                <c:pt idx="549">
                  <c:v>43939.8125</c:v>
                </c:pt>
                <c:pt idx="550">
                  <c:v>43939.819444444445</c:v>
                </c:pt>
                <c:pt idx="551">
                  <c:v>43939.826388888891</c:v>
                </c:pt>
                <c:pt idx="552">
                  <c:v>43939.833333333336</c:v>
                </c:pt>
                <c:pt idx="553">
                  <c:v>43939.840277777781</c:v>
                </c:pt>
                <c:pt idx="554">
                  <c:v>43939.847222222219</c:v>
                </c:pt>
                <c:pt idx="555">
                  <c:v>43939.854166666664</c:v>
                </c:pt>
                <c:pt idx="556">
                  <c:v>43939.861111111109</c:v>
                </c:pt>
                <c:pt idx="557">
                  <c:v>43939.868055555555</c:v>
                </c:pt>
                <c:pt idx="558">
                  <c:v>43939.875</c:v>
                </c:pt>
                <c:pt idx="559">
                  <c:v>43939.881944444445</c:v>
                </c:pt>
                <c:pt idx="560">
                  <c:v>43939.888888888891</c:v>
                </c:pt>
                <c:pt idx="561">
                  <c:v>43939.895833333336</c:v>
                </c:pt>
                <c:pt idx="562">
                  <c:v>43939.902777777781</c:v>
                </c:pt>
                <c:pt idx="563">
                  <c:v>43939.909722222219</c:v>
                </c:pt>
                <c:pt idx="564">
                  <c:v>43939.916666666664</c:v>
                </c:pt>
                <c:pt idx="565">
                  <c:v>43939.923611111109</c:v>
                </c:pt>
                <c:pt idx="566">
                  <c:v>43939.930555555555</c:v>
                </c:pt>
                <c:pt idx="567">
                  <c:v>43939.9375</c:v>
                </c:pt>
                <c:pt idx="568">
                  <c:v>43939.944444444445</c:v>
                </c:pt>
                <c:pt idx="569">
                  <c:v>43939.951388888891</c:v>
                </c:pt>
                <c:pt idx="570">
                  <c:v>43939.958333333336</c:v>
                </c:pt>
                <c:pt idx="571">
                  <c:v>43939.965277777781</c:v>
                </c:pt>
                <c:pt idx="572">
                  <c:v>43939.972222222219</c:v>
                </c:pt>
                <c:pt idx="573">
                  <c:v>43939.979166666664</c:v>
                </c:pt>
                <c:pt idx="574">
                  <c:v>43939.986111111109</c:v>
                </c:pt>
                <c:pt idx="575">
                  <c:v>43939.993055555555</c:v>
                </c:pt>
                <c:pt idx="576">
                  <c:v>43940</c:v>
                </c:pt>
                <c:pt idx="577">
                  <c:v>43940.006944444445</c:v>
                </c:pt>
                <c:pt idx="578">
                  <c:v>43940.013888888891</c:v>
                </c:pt>
                <c:pt idx="579">
                  <c:v>43940.020833333336</c:v>
                </c:pt>
                <c:pt idx="580">
                  <c:v>43940.027777777781</c:v>
                </c:pt>
                <c:pt idx="581">
                  <c:v>43940.034722222219</c:v>
                </c:pt>
                <c:pt idx="582">
                  <c:v>43940.041666666664</c:v>
                </c:pt>
                <c:pt idx="583">
                  <c:v>43940.048611111109</c:v>
                </c:pt>
                <c:pt idx="584">
                  <c:v>43940.055555555555</c:v>
                </c:pt>
                <c:pt idx="585">
                  <c:v>43940.0625</c:v>
                </c:pt>
                <c:pt idx="586">
                  <c:v>43940.069444444445</c:v>
                </c:pt>
                <c:pt idx="587">
                  <c:v>43940.076388888891</c:v>
                </c:pt>
                <c:pt idx="588">
                  <c:v>43940.083333333336</c:v>
                </c:pt>
                <c:pt idx="589">
                  <c:v>43940.090277777781</c:v>
                </c:pt>
                <c:pt idx="590">
                  <c:v>43940.097222222219</c:v>
                </c:pt>
                <c:pt idx="591">
                  <c:v>43940.104166666664</c:v>
                </c:pt>
                <c:pt idx="592">
                  <c:v>43940.111111111109</c:v>
                </c:pt>
                <c:pt idx="593">
                  <c:v>43940.118055555555</c:v>
                </c:pt>
                <c:pt idx="594">
                  <c:v>43940.125</c:v>
                </c:pt>
                <c:pt idx="595">
                  <c:v>43940.131944444445</c:v>
                </c:pt>
                <c:pt idx="596">
                  <c:v>43940.138888888891</c:v>
                </c:pt>
                <c:pt idx="597">
                  <c:v>43940.145833333336</c:v>
                </c:pt>
                <c:pt idx="598">
                  <c:v>43940.152777777781</c:v>
                </c:pt>
                <c:pt idx="599">
                  <c:v>43940.159722222219</c:v>
                </c:pt>
                <c:pt idx="600">
                  <c:v>43940.166666666664</c:v>
                </c:pt>
                <c:pt idx="601">
                  <c:v>43940.173611111109</c:v>
                </c:pt>
                <c:pt idx="602">
                  <c:v>43940.180555555555</c:v>
                </c:pt>
                <c:pt idx="603">
                  <c:v>43940.1875</c:v>
                </c:pt>
                <c:pt idx="604">
                  <c:v>43940.194444444445</c:v>
                </c:pt>
                <c:pt idx="605">
                  <c:v>43940.201388888891</c:v>
                </c:pt>
                <c:pt idx="606">
                  <c:v>43940.208333333336</c:v>
                </c:pt>
                <c:pt idx="607">
                  <c:v>43940.215277777781</c:v>
                </c:pt>
                <c:pt idx="608">
                  <c:v>43940.222222222219</c:v>
                </c:pt>
                <c:pt idx="609">
                  <c:v>43940.229166666664</c:v>
                </c:pt>
                <c:pt idx="610">
                  <c:v>43940.236111111109</c:v>
                </c:pt>
                <c:pt idx="611">
                  <c:v>43940.243055555555</c:v>
                </c:pt>
                <c:pt idx="612">
                  <c:v>43940.25</c:v>
                </c:pt>
                <c:pt idx="613">
                  <c:v>43940.256944444445</c:v>
                </c:pt>
                <c:pt idx="614">
                  <c:v>43940.263888888891</c:v>
                </c:pt>
                <c:pt idx="615">
                  <c:v>43940.270833333336</c:v>
                </c:pt>
                <c:pt idx="616">
                  <c:v>43940.277777777781</c:v>
                </c:pt>
                <c:pt idx="617">
                  <c:v>43940.284722222219</c:v>
                </c:pt>
                <c:pt idx="618">
                  <c:v>43940.291666666664</c:v>
                </c:pt>
                <c:pt idx="619">
                  <c:v>43940.298611111109</c:v>
                </c:pt>
                <c:pt idx="620">
                  <c:v>43940.305555555555</c:v>
                </c:pt>
                <c:pt idx="621">
                  <c:v>43940.3125</c:v>
                </c:pt>
                <c:pt idx="622">
                  <c:v>43940.319444444445</c:v>
                </c:pt>
                <c:pt idx="623">
                  <c:v>43940.326388888891</c:v>
                </c:pt>
                <c:pt idx="624">
                  <c:v>43940.333333333336</c:v>
                </c:pt>
                <c:pt idx="625">
                  <c:v>43940.340277777781</c:v>
                </c:pt>
                <c:pt idx="626">
                  <c:v>43940.347222222219</c:v>
                </c:pt>
                <c:pt idx="627">
                  <c:v>43940.354166666664</c:v>
                </c:pt>
                <c:pt idx="628">
                  <c:v>43940.361111111109</c:v>
                </c:pt>
                <c:pt idx="629">
                  <c:v>43940.368055555555</c:v>
                </c:pt>
                <c:pt idx="630">
                  <c:v>43940.375</c:v>
                </c:pt>
                <c:pt idx="631">
                  <c:v>43940.381944444445</c:v>
                </c:pt>
                <c:pt idx="632">
                  <c:v>43940.388888888891</c:v>
                </c:pt>
                <c:pt idx="633">
                  <c:v>43940.395833333336</c:v>
                </c:pt>
                <c:pt idx="634">
                  <c:v>43940.402777777781</c:v>
                </c:pt>
                <c:pt idx="635">
                  <c:v>43940.409722222219</c:v>
                </c:pt>
                <c:pt idx="636">
                  <c:v>43940.416666666664</c:v>
                </c:pt>
                <c:pt idx="637">
                  <c:v>43940.423611111109</c:v>
                </c:pt>
                <c:pt idx="638">
                  <c:v>43940.430555555555</c:v>
                </c:pt>
                <c:pt idx="639">
                  <c:v>43940.4375</c:v>
                </c:pt>
                <c:pt idx="640">
                  <c:v>43940.444444444445</c:v>
                </c:pt>
                <c:pt idx="641">
                  <c:v>43940.451388888891</c:v>
                </c:pt>
                <c:pt idx="642">
                  <c:v>43940.458333333336</c:v>
                </c:pt>
                <c:pt idx="643">
                  <c:v>43940.465277777781</c:v>
                </c:pt>
                <c:pt idx="644">
                  <c:v>43940.472222222219</c:v>
                </c:pt>
                <c:pt idx="645">
                  <c:v>43940.479166666664</c:v>
                </c:pt>
                <c:pt idx="646">
                  <c:v>43940.486111111109</c:v>
                </c:pt>
                <c:pt idx="647">
                  <c:v>43940.493055555555</c:v>
                </c:pt>
                <c:pt idx="648">
                  <c:v>43940.5</c:v>
                </c:pt>
                <c:pt idx="649">
                  <c:v>43940.506944444445</c:v>
                </c:pt>
                <c:pt idx="650">
                  <c:v>43940.513888888891</c:v>
                </c:pt>
                <c:pt idx="651">
                  <c:v>43940.520833333336</c:v>
                </c:pt>
                <c:pt idx="652">
                  <c:v>43940.527777777781</c:v>
                </c:pt>
                <c:pt idx="653">
                  <c:v>43940.534722222219</c:v>
                </c:pt>
                <c:pt idx="654">
                  <c:v>43940.541666666664</c:v>
                </c:pt>
                <c:pt idx="655">
                  <c:v>43940.548611111109</c:v>
                </c:pt>
                <c:pt idx="656">
                  <c:v>43940.555555555555</c:v>
                </c:pt>
                <c:pt idx="657">
                  <c:v>43940.5625</c:v>
                </c:pt>
                <c:pt idx="658">
                  <c:v>43940.569444444445</c:v>
                </c:pt>
                <c:pt idx="659">
                  <c:v>43940.576388888891</c:v>
                </c:pt>
                <c:pt idx="660">
                  <c:v>43940.583333333336</c:v>
                </c:pt>
                <c:pt idx="661">
                  <c:v>43940.590277777781</c:v>
                </c:pt>
                <c:pt idx="662">
                  <c:v>43940.597222222219</c:v>
                </c:pt>
                <c:pt idx="663">
                  <c:v>43940.604166666664</c:v>
                </c:pt>
                <c:pt idx="664">
                  <c:v>43940.611111111109</c:v>
                </c:pt>
                <c:pt idx="665">
                  <c:v>43940.618055555555</c:v>
                </c:pt>
                <c:pt idx="666">
                  <c:v>43940.625</c:v>
                </c:pt>
                <c:pt idx="667">
                  <c:v>43940.631944444445</c:v>
                </c:pt>
                <c:pt idx="668">
                  <c:v>43940.638888888891</c:v>
                </c:pt>
                <c:pt idx="669">
                  <c:v>43940.645833333336</c:v>
                </c:pt>
                <c:pt idx="670">
                  <c:v>43940.652777777781</c:v>
                </c:pt>
                <c:pt idx="671">
                  <c:v>43940.659722222219</c:v>
                </c:pt>
                <c:pt idx="672">
                  <c:v>43940.666666666664</c:v>
                </c:pt>
                <c:pt idx="673">
                  <c:v>43940.673611111109</c:v>
                </c:pt>
                <c:pt idx="674">
                  <c:v>43940.680555555555</c:v>
                </c:pt>
                <c:pt idx="675">
                  <c:v>43940.6875</c:v>
                </c:pt>
                <c:pt idx="676">
                  <c:v>43940.694444444445</c:v>
                </c:pt>
                <c:pt idx="677">
                  <c:v>43940.701388888891</c:v>
                </c:pt>
                <c:pt idx="678">
                  <c:v>43940.708333333336</c:v>
                </c:pt>
                <c:pt idx="679">
                  <c:v>43940.715277777781</c:v>
                </c:pt>
                <c:pt idx="680">
                  <c:v>43940.722222222219</c:v>
                </c:pt>
                <c:pt idx="681">
                  <c:v>43940.729166666664</c:v>
                </c:pt>
                <c:pt idx="682">
                  <c:v>43940.736111111109</c:v>
                </c:pt>
                <c:pt idx="683">
                  <c:v>43940.743055555555</c:v>
                </c:pt>
                <c:pt idx="684">
                  <c:v>43940.75</c:v>
                </c:pt>
                <c:pt idx="685">
                  <c:v>43940.756944444445</c:v>
                </c:pt>
                <c:pt idx="686">
                  <c:v>43940.763888888891</c:v>
                </c:pt>
                <c:pt idx="687">
                  <c:v>43940.770833333336</c:v>
                </c:pt>
                <c:pt idx="688">
                  <c:v>43940.777777777781</c:v>
                </c:pt>
                <c:pt idx="689">
                  <c:v>43940.784722222219</c:v>
                </c:pt>
                <c:pt idx="690">
                  <c:v>43940.791666666664</c:v>
                </c:pt>
                <c:pt idx="691">
                  <c:v>43940.798611111109</c:v>
                </c:pt>
                <c:pt idx="692">
                  <c:v>43940.805555555555</c:v>
                </c:pt>
                <c:pt idx="693">
                  <c:v>43940.8125</c:v>
                </c:pt>
                <c:pt idx="694">
                  <c:v>43940.819444444445</c:v>
                </c:pt>
                <c:pt idx="695">
                  <c:v>43940.826388888891</c:v>
                </c:pt>
                <c:pt idx="696">
                  <c:v>43940.833333333336</c:v>
                </c:pt>
                <c:pt idx="697">
                  <c:v>43940.840277777781</c:v>
                </c:pt>
                <c:pt idx="698">
                  <c:v>43940.847222222219</c:v>
                </c:pt>
                <c:pt idx="699">
                  <c:v>43940.854166666664</c:v>
                </c:pt>
                <c:pt idx="700">
                  <c:v>43940.861111111109</c:v>
                </c:pt>
                <c:pt idx="701">
                  <c:v>43940.868055555555</c:v>
                </c:pt>
                <c:pt idx="702">
                  <c:v>43940.875</c:v>
                </c:pt>
                <c:pt idx="703">
                  <c:v>43940.881944444445</c:v>
                </c:pt>
                <c:pt idx="704">
                  <c:v>43940.888888888891</c:v>
                </c:pt>
                <c:pt idx="705">
                  <c:v>43940.895833333336</c:v>
                </c:pt>
                <c:pt idx="706">
                  <c:v>43940.902777777781</c:v>
                </c:pt>
                <c:pt idx="707">
                  <c:v>43940.909722222219</c:v>
                </c:pt>
                <c:pt idx="708">
                  <c:v>43940.916666666664</c:v>
                </c:pt>
                <c:pt idx="709">
                  <c:v>43940.923611111109</c:v>
                </c:pt>
                <c:pt idx="710">
                  <c:v>43940.930555555555</c:v>
                </c:pt>
                <c:pt idx="711">
                  <c:v>43940.9375</c:v>
                </c:pt>
                <c:pt idx="712">
                  <c:v>43940.944444444445</c:v>
                </c:pt>
                <c:pt idx="713">
                  <c:v>43940.951388888891</c:v>
                </c:pt>
                <c:pt idx="714">
                  <c:v>43940.958333333336</c:v>
                </c:pt>
                <c:pt idx="715">
                  <c:v>43940.965277777781</c:v>
                </c:pt>
                <c:pt idx="716">
                  <c:v>43940.972222222219</c:v>
                </c:pt>
                <c:pt idx="717">
                  <c:v>43940.979166666664</c:v>
                </c:pt>
                <c:pt idx="718">
                  <c:v>43940.986111111109</c:v>
                </c:pt>
                <c:pt idx="719">
                  <c:v>43940.993055555555</c:v>
                </c:pt>
              </c:numCache>
            </c:numRef>
          </c:xVal>
          <c:yVal>
            <c:numRef>
              <c:f>Sunhigh_1!$E$2:$E$721</c:f>
              <c:numCache>
                <c:formatCode>0.0</c:formatCode>
                <c:ptCount val="720"/>
                <c:pt idx="0">
                  <c:v>2.7777777777777777</c:v>
                </c:pt>
                <c:pt idx="1">
                  <c:v>2.7777777777777777</c:v>
                </c:pt>
                <c:pt idx="2">
                  <c:v>2.7777777777777777</c:v>
                </c:pt>
                <c:pt idx="3">
                  <c:v>2.7777777777777777</c:v>
                </c:pt>
                <c:pt idx="4">
                  <c:v>2.7777777777777777</c:v>
                </c:pt>
                <c:pt idx="5">
                  <c:v>2.7777777777777777</c:v>
                </c:pt>
                <c:pt idx="6">
                  <c:v>2.7777777777777777</c:v>
                </c:pt>
                <c:pt idx="7">
                  <c:v>2.7777777777777777</c:v>
                </c:pt>
                <c:pt idx="8">
                  <c:v>2.7777777777777777</c:v>
                </c:pt>
                <c:pt idx="9">
                  <c:v>2.2222222222222223</c:v>
                </c:pt>
                <c:pt idx="10">
                  <c:v>2.2222222222222223</c:v>
                </c:pt>
                <c:pt idx="11">
                  <c:v>2.2222222222222223</c:v>
                </c:pt>
                <c:pt idx="12">
                  <c:v>2.2222222222222223</c:v>
                </c:pt>
                <c:pt idx="13">
                  <c:v>2.2222222222222223</c:v>
                </c:pt>
                <c:pt idx="14">
                  <c:v>2.2222222222222223</c:v>
                </c:pt>
                <c:pt idx="15">
                  <c:v>2.2222222222222223</c:v>
                </c:pt>
                <c:pt idx="16">
                  <c:v>2.2222222222222223</c:v>
                </c:pt>
                <c:pt idx="17">
                  <c:v>2.2222222222222223</c:v>
                </c:pt>
                <c:pt idx="18">
                  <c:v>1.6666666666666665</c:v>
                </c:pt>
                <c:pt idx="19">
                  <c:v>1.6666666666666665</c:v>
                </c:pt>
                <c:pt idx="20">
                  <c:v>1.6666666666666665</c:v>
                </c:pt>
                <c:pt idx="21">
                  <c:v>1.6666666666666665</c:v>
                </c:pt>
                <c:pt idx="22">
                  <c:v>1.6666666666666665</c:v>
                </c:pt>
                <c:pt idx="23">
                  <c:v>1.6666666666666665</c:v>
                </c:pt>
                <c:pt idx="24">
                  <c:v>1.6666666666666665</c:v>
                </c:pt>
                <c:pt idx="25">
                  <c:v>1.6666666666666665</c:v>
                </c:pt>
                <c:pt idx="26">
                  <c:v>1.6666666666666665</c:v>
                </c:pt>
                <c:pt idx="27">
                  <c:v>1.6666666666666665</c:v>
                </c:pt>
                <c:pt idx="28">
                  <c:v>1.1111111111111112</c:v>
                </c:pt>
                <c:pt idx="29">
                  <c:v>1.1111111111111112</c:v>
                </c:pt>
                <c:pt idx="30">
                  <c:v>1.1111111111111112</c:v>
                </c:pt>
                <c:pt idx="31">
                  <c:v>1.1111111111111112</c:v>
                </c:pt>
                <c:pt idx="32">
                  <c:v>1.1111111111111112</c:v>
                </c:pt>
                <c:pt idx="33">
                  <c:v>0.55555555555555558</c:v>
                </c:pt>
                <c:pt idx="34">
                  <c:v>0.55555555555555558</c:v>
                </c:pt>
                <c:pt idx="35">
                  <c:v>0.55555555555555558</c:v>
                </c:pt>
                <c:pt idx="36">
                  <c:v>0.55555555555555558</c:v>
                </c:pt>
                <c:pt idx="37">
                  <c:v>0</c:v>
                </c:pt>
                <c:pt idx="38">
                  <c:v>0</c:v>
                </c:pt>
                <c:pt idx="39">
                  <c:v>-0.55555555555555558</c:v>
                </c:pt>
                <c:pt idx="40">
                  <c:v>-0.55555555555555558</c:v>
                </c:pt>
                <c:pt idx="41">
                  <c:v>-0.55555555555555558</c:v>
                </c:pt>
                <c:pt idx="42">
                  <c:v>-1.1111111111111112</c:v>
                </c:pt>
                <c:pt idx="43">
                  <c:v>-1.1111111111111112</c:v>
                </c:pt>
                <c:pt idx="44">
                  <c:v>-1.1111111111111112</c:v>
                </c:pt>
                <c:pt idx="45">
                  <c:v>-0.55555555555555558</c:v>
                </c:pt>
                <c:pt idx="46">
                  <c:v>1.6666666666666665</c:v>
                </c:pt>
                <c:pt idx="47">
                  <c:v>3.333333333333333</c:v>
                </c:pt>
                <c:pt idx="48">
                  <c:v>5</c:v>
                </c:pt>
                <c:pt idx="49">
                  <c:v>6.1111111111111107</c:v>
                </c:pt>
                <c:pt idx="50">
                  <c:v>7.2222222222222223</c:v>
                </c:pt>
                <c:pt idx="51">
                  <c:v>7.7777777777777777</c:v>
                </c:pt>
                <c:pt idx="52">
                  <c:v>8.8888888888888893</c:v>
                </c:pt>
                <c:pt idx="53">
                  <c:v>8.8888888888888893</c:v>
                </c:pt>
                <c:pt idx="54">
                  <c:v>9.4444444444444446</c:v>
                </c:pt>
                <c:pt idx="55">
                  <c:v>10</c:v>
                </c:pt>
                <c:pt idx="56">
                  <c:v>10</c:v>
                </c:pt>
                <c:pt idx="57">
                  <c:v>10.555555555555555</c:v>
                </c:pt>
                <c:pt idx="58">
                  <c:v>10</c:v>
                </c:pt>
                <c:pt idx="59">
                  <c:v>10</c:v>
                </c:pt>
                <c:pt idx="60">
                  <c:v>10</c:v>
                </c:pt>
                <c:pt idx="61">
                  <c:v>10.555555555555555</c:v>
                </c:pt>
                <c:pt idx="62">
                  <c:v>10.555555555555555</c:v>
                </c:pt>
                <c:pt idx="63">
                  <c:v>10.555555555555555</c:v>
                </c:pt>
                <c:pt idx="64">
                  <c:v>10</c:v>
                </c:pt>
                <c:pt idx="65">
                  <c:v>10</c:v>
                </c:pt>
                <c:pt idx="66">
                  <c:v>10</c:v>
                </c:pt>
                <c:pt idx="67">
                  <c:v>10.555555555555555</c:v>
                </c:pt>
                <c:pt idx="68">
                  <c:v>10.555555555555555</c:v>
                </c:pt>
                <c:pt idx="69">
                  <c:v>11.111111111111111</c:v>
                </c:pt>
                <c:pt idx="70">
                  <c:v>11.111111111111111</c:v>
                </c:pt>
                <c:pt idx="71">
                  <c:v>11.111111111111111</c:v>
                </c:pt>
                <c:pt idx="72">
                  <c:v>11.111111111111111</c:v>
                </c:pt>
                <c:pt idx="73">
                  <c:v>11.666666666666666</c:v>
                </c:pt>
                <c:pt idx="74">
                  <c:v>11.666666666666666</c:v>
                </c:pt>
                <c:pt idx="75">
                  <c:v>11.666666666666666</c:v>
                </c:pt>
                <c:pt idx="76">
                  <c:v>11.666666666666666</c:v>
                </c:pt>
                <c:pt idx="77">
                  <c:v>11.666666666666666</c:v>
                </c:pt>
                <c:pt idx="78">
                  <c:v>12.222222222222221</c:v>
                </c:pt>
                <c:pt idx="79">
                  <c:v>12.222222222222221</c:v>
                </c:pt>
                <c:pt idx="80">
                  <c:v>12.222222222222221</c:v>
                </c:pt>
                <c:pt idx="81">
                  <c:v>12.777777777777777</c:v>
                </c:pt>
                <c:pt idx="82">
                  <c:v>12.777777777777777</c:v>
                </c:pt>
                <c:pt idx="83">
                  <c:v>12.777777777777777</c:v>
                </c:pt>
                <c:pt idx="84">
                  <c:v>12.777777777777777</c:v>
                </c:pt>
                <c:pt idx="85">
                  <c:v>12.777777777777777</c:v>
                </c:pt>
                <c:pt idx="86">
                  <c:v>12.777777777777777</c:v>
                </c:pt>
                <c:pt idx="87">
                  <c:v>12.777777777777777</c:v>
                </c:pt>
                <c:pt idx="88">
                  <c:v>12.777777777777777</c:v>
                </c:pt>
                <c:pt idx="89">
                  <c:v>13.333333333333332</c:v>
                </c:pt>
                <c:pt idx="90">
                  <c:v>13.333333333333332</c:v>
                </c:pt>
                <c:pt idx="91">
                  <c:v>12.777777777777777</c:v>
                </c:pt>
                <c:pt idx="92">
                  <c:v>12.777777777777777</c:v>
                </c:pt>
                <c:pt idx="93">
                  <c:v>12.777777777777777</c:v>
                </c:pt>
                <c:pt idx="94">
                  <c:v>12.777777777777777</c:v>
                </c:pt>
                <c:pt idx="95">
                  <c:v>13.333333333333332</c:v>
                </c:pt>
                <c:pt idx="96">
                  <c:v>13.333333333333332</c:v>
                </c:pt>
                <c:pt idx="97">
                  <c:v>13.333333333333332</c:v>
                </c:pt>
                <c:pt idx="98">
                  <c:v>12.777777777777777</c:v>
                </c:pt>
                <c:pt idx="99">
                  <c:v>12.777777777777777</c:v>
                </c:pt>
                <c:pt idx="100">
                  <c:v>12.777777777777777</c:v>
                </c:pt>
                <c:pt idx="101">
                  <c:v>13.333333333333332</c:v>
                </c:pt>
                <c:pt idx="102">
                  <c:v>13.333333333333332</c:v>
                </c:pt>
                <c:pt idx="103">
                  <c:v>13.333333333333332</c:v>
                </c:pt>
                <c:pt idx="104">
                  <c:v>12.777777777777777</c:v>
                </c:pt>
                <c:pt idx="105">
                  <c:v>12.777777777777777</c:v>
                </c:pt>
                <c:pt idx="106">
                  <c:v>12.777777777777777</c:v>
                </c:pt>
                <c:pt idx="107">
                  <c:v>12.777777777777777</c:v>
                </c:pt>
                <c:pt idx="108">
                  <c:v>12.777777777777777</c:v>
                </c:pt>
                <c:pt idx="109">
                  <c:v>12.777777777777777</c:v>
                </c:pt>
                <c:pt idx="110">
                  <c:v>12.777777777777777</c:v>
                </c:pt>
                <c:pt idx="111">
                  <c:v>12.222222222222221</c:v>
                </c:pt>
                <c:pt idx="112">
                  <c:v>12.222222222222221</c:v>
                </c:pt>
                <c:pt idx="113">
                  <c:v>12.222222222222221</c:v>
                </c:pt>
                <c:pt idx="114">
                  <c:v>11.666666666666666</c:v>
                </c:pt>
                <c:pt idx="115">
                  <c:v>11.111111111111111</c:v>
                </c:pt>
                <c:pt idx="116">
                  <c:v>10.555555555555555</c:v>
                </c:pt>
                <c:pt idx="117">
                  <c:v>10</c:v>
                </c:pt>
                <c:pt idx="118">
                  <c:v>8.8888888888888893</c:v>
                </c:pt>
                <c:pt idx="119">
                  <c:v>8.3333333333333339</c:v>
                </c:pt>
                <c:pt idx="120">
                  <c:v>7.2222222222222223</c:v>
                </c:pt>
                <c:pt idx="121">
                  <c:v>6.6666666666666661</c:v>
                </c:pt>
                <c:pt idx="122">
                  <c:v>6.1111111111111107</c:v>
                </c:pt>
                <c:pt idx="123">
                  <c:v>5.5555555555555554</c:v>
                </c:pt>
                <c:pt idx="124">
                  <c:v>5</c:v>
                </c:pt>
                <c:pt idx="125">
                  <c:v>3.8888888888888888</c:v>
                </c:pt>
                <c:pt idx="126">
                  <c:v>3.333333333333333</c:v>
                </c:pt>
                <c:pt idx="127">
                  <c:v>2.7777777777777777</c:v>
                </c:pt>
                <c:pt idx="128">
                  <c:v>2.2222222222222223</c:v>
                </c:pt>
                <c:pt idx="129">
                  <c:v>1.6666666666666665</c:v>
                </c:pt>
                <c:pt idx="130">
                  <c:v>1.6666666666666665</c:v>
                </c:pt>
                <c:pt idx="131">
                  <c:v>1.1111111111111112</c:v>
                </c:pt>
                <c:pt idx="132">
                  <c:v>1.1111111111111112</c:v>
                </c:pt>
                <c:pt idx="133">
                  <c:v>1.6666666666666665</c:v>
                </c:pt>
                <c:pt idx="134">
                  <c:v>1.6666666666666665</c:v>
                </c:pt>
                <c:pt idx="135">
                  <c:v>1.1111111111111112</c:v>
                </c:pt>
                <c:pt idx="136">
                  <c:v>1.1111111111111112</c:v>
                </c:pt>
                <c:pt idx="137">
                  <c:v>1.1111111111111112</c:v>
                </c:pt>
                <c:pt idx="138">
                  <c:v>1.1111111111111112</c:v>
                </c:pt>
                <c:pt idx="139">
                  <c:v>1.1111111111111112</c:v>
                </c:pt>
                <c:pt idx="140">
                  <c:v>0.55555555555555558</c:v>
                </c:pt>
                <c:pt idx="141">
                  <c:v>0.55555555555555558</c:v>
                </c:pt>
                <c:pt idx="142">
                  <c:v>0.55555555555555558</c:v>
                </c:pt>
                <c:pt idx="143">
                  <c:v>0.55555555555555558</c:v>
                </c:pt>
                <c:pt idx="144">
                  <c:v>1.1111111111111112</c:v>
                </c:pt>
                <c:pt idx="145">
                  <c:v>1.6666666666666665</c:v>
                </c:pt>
                <c:pt idx="146">
                  <c:v>3.333333333333333</c:v>
                </c:pt>
                <c:pt idx="147">
                  <c:v>3.8888888888888888</c:v>
                </c:pt>
                <c:pt idx="148">
                  <c:v>5</c:v>
                </c:pt>
                <c:pt idx="149">
                  <c:v>5.5555555555555554</c:v>
                </c:pt>
                <c:pt idx="150">
                  <c:v>5.5555555555555554</c:v>
                </c:pt>
                <c:pt idx="151">
                  <c:v>6.1111111111111107</c:v>
                </c:pt>
                <c:pt idx="152">
                  <c:v>6.1111111111111107</c:v>
                </c:pt>
                <c:pt idx="153">
                  <c:v>6.1111111111111107</c:v>
                </c:pt>
                <c:pt idx="154">
                  <c:v>6.1111111111111107</c:v>
                </c:pt>
                <c:pt idx="155">
                  <c:v>5.5555555555555554</c:v>
                </c:pt>
                <c:pt idx="156">
                  <c:v>5.5555555555555554</c:v>
                </c:pt>
                <c:pt idx="157">
                  <c:v>5</c:v>
                </c:pt>
                <c:pt idx="158">
                  <c:v>4.4444444444444446</c:v>
                </c:pt>
                <c:pt idx="159">
                  <c:v>4.4444444444444446</c:v>
                </c:pt>
                <c:pt idx="160">
                  <c:v>4.4444444444444446</c:v>
                </c:pt>
                <c:pt idx="161">
                  <c:v>3.8888888888888888</c:v>
                </c:pt>
                <c:pt idx="162">
                  <c:v>3.8888888888888888</c:v>
                </c:pt>
                <c:pt idx="163">
                  <c:v>3.333333333333333</c:v>
                </c:pt>
                <c:pt idx="164">
                  <c:v>3.333333333333333</c:v>
                </c:pt>
                <c:pt idx="165">
                  <c:v>2.7777777777777777</c:v>
                </c:pt>
                <c:pt idx="166">
                  <c:v>2.7777777777777777</c:v>
                </c:pt>
                <c:pt idx="167">
                  <c:v>2.7777777777777777</c:v>
                </c:pt>
                <c:pt idx="168">
                  <c:v>2.7777777777777777</c:v>
                </c:pt>
                <c:pt idx="169">
                  <c:v>2.7777777777777777</c:v>
                </c:pt>
                <c:pt idx="170">
                  <c:v>2.2222222222222223</c:v>
                </c:pt>
                <c:pt idx="171">
                  <c:v>2.2222222222222223</c:v>
                </c:pt>
                <c:pt idx="172">
                  <c:v>2.2222222222222223</c:v>
                </c:pt>
                <c:pt idx="173">
                  <c:v>2.2222222222222223</c:v>
                </c:pt>
                <c:pt idx="174">
                  <c:v>2.2222222222222223</c:v>
                </c:pt>
                <c:pt idx="175">
                  <c:v>2.2222222222222223</c:v>
                </c:pt>
                <c:pt idx="176">
                  <c:v>1.6666666666666665</c:v>
                </c:pt>
                <c:pt idx="177">
                  <c:v>1.6666666666666665</c:v>
                </c:pt>
                <c:pt idx="178">
                  <c:v>1.6666666666666665</c:v>
                </c:pt>
                <c:pt idx="179">
                  <c:v>1.6666666666666665</c:v>
                </c:pt>
                <c:pt idx="180">
                  <c:v>1.6666666666666665</c:v>
                </c:pt>
                <c:pt idx="181">
                  <c:v>1.6666666666666665</c:v>
                </c:pt>
                <c:pt idx="182">
                  <c:v>1.6666666666666665</c:v>
                </c:pt>
                <c:pt idx="183">
                  <c:v>1.1111111111111112</c:v>
                </c:pt>
                <c:pt idx="184">
                  <c:v>1.6666666666666665</c:v>
                </c:pt>
                <c:pt idx="185">
                  <c:v>1.6666666666666665</c:v>
                </c:pt>
                <c:pt idx="186">
                  <c:v>1.6666666666666665</c:v>
                </c:pt>
                <c:pt idx="187">
                  <c:v>1.6666666666666665</c:v>
                </c:pt>
                <c:pt idx="188">
                  <c:v>2.2222222222222223</c:v>
                </c:pt>
                <c:pt idx="189">
                  <c:v>3.333333333333333</c:v>
                </c:pt>
                <c:pt idx="190">
                  <c:v>4.4444444444444446</c:v>
                </c:pt>
                <c:pt idx="191">
                  <c:v>5.5555555555555554</c:v>
                </c:pt>
                <c:pt idx="192">
                  <c:v>6.1111111111111107</c:v>
                </c:pt>
                <c:pt idx="193">
                  <c:v>7.2222222222222223</c:v>
                </c:pt>
                <c:pt idx="194">
                  <c:v>7.7777777777777777</c:v>
                </c:pt>
                <c:pt idx="195">
                  <c:v>8.3333333333333339</c:v>
                </c:pt>
                <c:pt idx="196">
                  <c:v>8.8888888888888893</c:v>
                </c:pt>
                <c:pt idx="197">
                  <c:v>9.4444444444444446</c:v>
                </c:pt>
                <c:pt idx="198">
                  <c:v>10</c:v>
                </c:pt>
                <c:pt idx="199">
                  <c:v>10</c:v>
                </c:pt>
                <c:pt idx="200">
                  <c:v>10</c:v>
                </c:pt>
                <c:pt idx="201">
                  <c:v>9.4444444444444446</c:v>
                </c:pt>
                <c:pt idx="202">
                  <c:v>8.8888888888888893</c:v>
                </c:pt>
                <c:pt idx="203">
                  <c:v>8.3333333333333339</c:v>
                </c:pt>
                <c:pt idx="204">
                  <c:v>7.7777777777777777</c:v>
                </c:pt>
                <c:pt idx="205">
                  <c:v>7.7777777777777777</c:v>
                </c:pt>
                <c:pt idx="206">
                  <c:v>7.2222222222222223</c:v>
                </c:pt>
                <c:pt idx="207">
                  <c:v>7.7777777777777777</c:v>
                </c:pt>
                <c:pt idx="208">
                  <c:v>8.3333333333333339</c:v>
                </c:pt>
                <c:pt idx="209">
                  <c:v>8.8888888888888893</c:v>
                </c:pt>
                <c:pt idx="210">
                  <c:v>8.8888888888888893</c:v>
                </c:pt>
                <c:pt idx="211">
                  <c:v>9.4444444444444446</c:v>
                </c:pt>
                <c:pt idx="212">
                  <c:v>8.8888888888888893</c:v>
                </c:pt>
                <c:pt idx="213">
                  <c:v>9.4444444444444446</c:v>
                </c:pt>
                <c:pt idx="214">
                  <c:v>10</c:v>
                </c:pt>
                <c:pt idx="215">
                  <c:v>9.4444444444444446</c:v>
                </c:pt>
                <c:pt idx="216">
                  <c:v>9.4444444444444446</c:v>
                </c:pt>
                <c:pt idx="217">
                  <c:v>9.4444444444444446</c:v>
                </c:pt>
                <c:pt idx="218">
                  <c:v>9.4444444444444446</c:v>
                </c:pt>
                <c:pt idx="219">
                  <c:v>10</c:v>
                </c:pt>
                <c:pt idx="220">
                  <c:v>10.555555555555555</c:v>
                </c:pt>
                <c:pt idx="221">
                  <c:v>10.555555555555555</c:v>
                </c:pt>
                <c:pt idx="222">
                  <c:v>10.555555555555555</c:v>
                </c:pt>
                <c:pt idx="223">
                  <c:v>10.555555555555555</c:v>
                </c:pt>
                <c:pt idx="224">
                  <c:v>11.111111111111111</c:v>
                </c:pt>
                <c:pt idx="225">
                  <c:v>11.666666666666666</c:v>
                </c:pt>
                <c:pt idx="226">
                  <c:v>11.666666666666666</c:v>
                </c:pt>
                <c:pt idx="227">
                  <c:v>11.666666666666666</c:v>
                </c:pt>
                <c:pt idx="228">
                  <c:v>11.666666666666666</c:v>
                </c:pt>
                <c:pt idx="229">
                  <c:v>11.666666666666666</c:v>
                </c:pt>
                <c:pt idx="230">
                  <c:v>11.666666666666666</c:v>
                </c:pt>
                <c:pt idx="231">
                  <c:v>11.666666666666666</c:v>
                </c:pt>
                <c:pt idx="232">
                  <c:v>12.222222222222221</c:v>
                </c:pt>
                <c:pt idx="233">
                  <c:v>12.222222222222221</c:v>
                </c:pt>
                <c:pt idx="234">
                  <c:v>12.222222222222221</c:v>
                </c:pt>
                <c:pt idx="235">
                  <c:v>11.666666666666666</c:v>
                </c:pt>
                <c:pt idx="236">
                  <c:v>11.666666666666666</c:v>
                </c:pt>
                <c:pt idx="237">
                  <c:v>11.666666666666666</c:v>
                </c:pt>
                <c:pt idx="238">
                  <c:v>11.666666666666666</c:v>
                </c:pt>
                <c:pt idx="239">
                  <c:v>11.666666666666666</c:v>
                </c:pt>
                <c:pt idx="240">
                  <c:v>11.666666666666666</c:v>
                </c:pt>
                <c:pt idx="241">
                  <c:v>11.666666666666666</c:v>
                </c:pt>
                <c:pt idx="242">
                  <c:v>11.666666666666666</c:v>
                </c:pt>
                <c:pt idx="243">
                  <c:v>11.666666666666666</c:v>
                </c:pt>
                <c:pt idx="244">
                  <c:v>11.111111111111111</c:v>
                </c:pt>
                <c:pt idx="245">
                  <c:v>11.666666666666666</c:v>
                </c:pt>
                <c:pt idx="246">
                  <c:v>11.666666666666666</c:v>
                </c:pt>
                <c:pt idx="247">
                  <c:v>11.666666666666666</c:v>
                </c:pt>
                <c:pt idx="248">
                  <c:v>11.666666666666666</c:v>
                </c:pt>
                <c:pt idx="249">
                  <c:v>11.666666666666666</c:v>
                </c:pt>
                <c:pt idx="250">
                  <c:v>11.666666666666666</c:v>
                </c:pt>
                <c:pt idx="251">
                  <c:v>11.666666666666666</c:v>
                </c:pt>
                <c:pt idx="252">
                  <c:v>11.111111111111111</c:v>
                </c:pt>
                <c:pt idx="253">
                  <c:v>11.111111111111111</c:v>
                </c:pt>
                <c:pt idx="254">
                  <c:v>11.111111111111111</c:v>
                </c:pt>
                <c:pt idx="255">
                  <c:v>11.111111111111111</c:v>
                </c:pt>
                <c:pt idx="256">
                  <c:v>10.555555555555555</c:v>
                </c:pt>
                <c:pt idx="257">
                  <c:v>10.555555555555555</c:v>
                </c:pt>
                <c:pt idx="258">
                  <c:v>10</c:v>
                </c:pt>
                <c:pt idx="259">
                  <c:v>9.4444444444444446</c:v>
                </c:pt>
                <c:pt idx="260">
                  <c:v>8.8888888888888893</c:v>
                </c:pt>
                <c:pt idx="261">
                  <c:v>8.3333333333333339</c:v>
                </c:pt>
                <c:pt idx="262">
                  <c:v>7.7777777777777777</c:v>
                </c:pt>
                <c:pt idx="263">
                  <c:v>7.2222222222222223</c:v>
                </c:pt>
                <c:pt idx="264">
                  <c:v>6.6666666666666661</c:v>
                </c:pt>
                <c:pt idx="265">
                  <c:v>5.5555555555555554</c:v>
                </c:pt>
                <c:pt idx="266">
                  <c:v>5</c:v>
                </c:pt>
                <c:pt idx="267">
                  <c:v>4.4444444444444446</c:v>
                </c:pt>
                <c:pt idx="268">
                  <c:v>3.8888888888888888</c:v>
                </c:pt>
                <c:pt idx="269">
                  <c:v>3.333333333333333</c:v>
                </c:pt>
                <c:pt idx="270">
                  <c:v>2.2222222222222223</c:v>
                </c:pt>
                <c:pt idx="271">
                  <c:v>1.6666666666666665</c:v>
                </c:pt>
                <c:pt idx="272">
                  <c:v>1.1111111111111112</c:v>
                </c:pt>
                <c:pt idx="273">
                  <c:v>1.1111111111111112</c:v>
                </c:pt>
                <c:pt idx="274">
                  <c:v>0.55555555555555558</c:v>
                </c:pt>
                <c:pt idx="275">
                  <c:v>0</c:v>
                </c:pt>
                <c:pt idx="276">
                  <c:v>0</c:v>
                </c:pt>
                <c:pt idx="277">
                  <c:v>-0.55555555555555558</c:v>
                </c:pt>
                <c:pt idx="278">
                  <c:v>-0.55555555555555558</c:v>
                </c:pt>
                <c:pt idx="279">
                  <c:v>-0.55555555555555558</c:v>
                </c:pt>
                <c:pt idx="280">
                  <c:v>-1.1111111111111112</c:v>
                </c:pt>
                <c:pt idx="281">
                  <c:v>-1.1111111111111112</c:v>
                </c:pt>
                <c:pt idx="282">
                  <c:v>-1.1111111111111112</c:v>
                </c:pt>
                <c:pt idx="283">
                  <c:v>-1.6666666666666665</c:v>
                </c:pt>
                <c:pt idx="284">
                  <c:v>-1.1111111111111112</c:v>
                </c:pt>
                <c:pt idx="285">
                  <c:v>-1.1111111111111112</c:v>
                </c:pt>
                <c:pt idx="286">
                  <c:v>-1.1111111111111112</c:v>
                </c:pt>
                <c:pt idx="287">
                  <c:v>-1.1111111111111112</c:v>
                </c:pt>
                <c:pt idx="288">
                  <c:v>-1.1111111111111112</c:v>
                </c:pt>
                <c:pt idx="289">
                  <c:v>-1.1111111111111112</c:v>
                </c:pt>
                <c:pt idx="290">
                  <c:v>-1.1111111111111112</c:v>
                </c:pt>
                <c:pt idx="291">
                  <c:v>-1.1111111111111112</c:v>
                </c:pt>
                <c:pt idx="292">
                  <c:v>-1.1111111111111112</c:v>
                </c:pt>
                <c:pt idx="293">
                  <c:v>-1.1111111111111112</c:v>
                </c:pt>
                <c:pt idx="294">
                  <c:v>-1.1111111111111112</c:v>
                </c:pt>
                <c:pt idx="295">
                  <c:v>-0.55555555555555558</c:v>
                </c:pt>
                <c:pt idx="296">
                  <c:v>-0.55555555555555558</c:v>
                </c:pt>
                <c:pt idx="297">
                  <c:v>-0.55555555555555558</c:v>
                </c:pt>
                <c:pt idx="298">
                  <c:v>-0.55555555555555558</c:v>
                </c:pt>
                <c:pt idx="299">
                  <c:v>-0.55555555555555558</c:v>
                </c:pt>
                <c:pt idx="300">
                  <c:v>-0.55555555555555558</c:v>
                </c:pt>
                <c:pt idx="301">
                  <c:v>-0.55555555555555558</c:v>
                </c:pt>
                <c:pt idx="302">
                  <c:v>-1.1111111111111112</c:v>
                </c:pt>
                <c:pt idx="303">
                  <c:v>-1.1111111111111112</c:v>
                </c:pt>
                <c:pt idx="304">
                  <c:v>-1.1111111111111112</c:v>
                </c:pt>
                <c:pt idx="305">
                  <c:v>-1.1111111111111112</c:v>
                </c:pt>
                <c:pt idx="306">
                  <c:v>-1.1111111111111112</c:v>
                </c:pt>
                <c:pt idx="307">
                  <c:v>-1.6666666666666665</c:v>
                </c:pt>
                <c:pt idx="308">
                  <c:v>-1.6666666666666665</c:v>
                </c:pt>
                <c:pt idx="309">
                  <c:v>-2.2222222222222223</c:v>
                </c:pt>
                <c:pt idx="310">
                  <c:v>-2.2222222222222223</c:v>
                </c:pt>
                <c:pt idx="311">
                  <c:v>-2.2222222222222223</c:v>
                </c:pt>
                <c:pt idx="312">
                  <c:v>-2.2222222222222223</c:v>
                </c:pt>
                <c:pt idx="313">
                  <c:v>-2.2222222222222223</c:v>
                </c:pt>
                <c:pt idx="314">
                  <c:v>-2.7777777777777777</c:v>
                </c:pt>
                <c:pt idx="315">
                  <c:v>-2.7777777777777777</c:v>
                </c:pt>
                <c:pt idx="316">
                  <c:v>-2.7777777777777777</c:v>
                </c:pt>
                <c:pt idx="317">
                  <c:v>-2.7777777777777777</c:v>
                </c:pt>
                <c:pt idx="318">
                  <c:v>-2.7777777777777777</c:v>
                </c:pt>
                <c:pt idx="319">
                  <c:v>-2.2222222222222223</c:v>
                </c:pt>
                <c:pt idx="320">
                  <c:v>-2.2222222222222223</c:v>
                </c:pt>
                <c:pt idx="321">
                  <c:v>-2.2222222222222223</c:v>
                </c:pt>
                <c:pt idx="322">
                  <c:v>-1.6666666666666665</c:v>
                </c:pt>
                <c:pt idx="323">
                  <c:v>-1.6666666666666665</c:v>
                </c:pt>
                <c:pt idx="324">
                  <c:v>-1.6666666666666665</c:v>
                </c:pt>
                <c:pt idx="325">
                  <c:v>-2.2222222222222223</c:v>
                </c:pt>
                <c:pt idx="326">
                  <c:v>-2.2222222222222223</c:v>
                </c:pt>
                <c:pt idx="327">
                  <c:v>-2.2222222222222223</c:v>
                </c:pt>
                <c:pt idx="328">
                  <c:v>-2.7777777777777777</c:v>
                </c:pt>
                <c:pt idx="329">
                  <c:v>-2.7777777777777777</c:v>
                </c:pt>
                <c:pt idx="330">
                  <c:v>-2.7777777777777777</c:v>
                </c:pt>
                <c:pt idx="331">
                  <c:v>-2.7777777777777777</c:v>
                </c:pt>
                <c:pt idx="332">
                  <c:v>-2.2222222222222223</c:v>
                </c:pt>
                <c:pt idx="333">
                  <c:v>-1.1111111111111112</c:v>
                </c:pt>
                <c:pt idx="334">
                  <c:v>0.55555555555555558</c:v>
                </c:pt>
                <c:pt idx="335">
                  <c:v>1.1111111111111112</c:v>
                </c:pt>
                <c:pt idx="336">
                  <c:v>2.2222222222222223</c:v>
                </c:pt>
                <c:pt idx="337">
                  <c:v>2.7777777777777777</c:v>
                </c:pt>
                <c:pt idx="338">
                  <c:v>3.8888888888888888</c:v>
                </c:pt>
                <c:pt idx="339">
                  <c:v>4.4444444444444446</c:v>
                </c:pt>
                <c:pt idx="340">
                  <c:v>5</c:v>
                </c:pt>
                <c:pt idx="341">
                  <c:v>5.5555555555555554</c:v>
                </c:pt>
                <c:pt idx="342">
                  <c:v>6.1111111111111107</c:v>
                </c:pt>
                <c:pt idx="343">
                  <c:v>6.6666666666666661</c:v>
                </c:pt>
                <c:pt idx="344">
                  <c:v>6.6666666666666661</c:v>
                </c:pt>
                <c:pt idx="345">
                  <c:v>6.6666666666666661</c:v>
                </c:pt>
                <c:pt idx="346">
                  <c:v>6.6666666666666661</c:v>
                </c:pt>
                <c:pt idx="347">
                  <c:v>6.6666666666666661</c:v>
                </c:pt>
                <c:pt idx="348">
                  <c:v>7.2222222222222223</c:v>
                </c:pt>
                <c:pt idx="349">
                  <c:v>7.7777777777777777</c:v>
                </c:pt>
                <c:pt idx="350">
                  <c:v>8.3333333333333339</c:v>
                </c:pt>
                <c:pt idx="351">
                  <c:v>8.8888888888888893</c:v>
                </c:pt>
                <c:pt idx="352">
                  <c:v>9.4444444444444446</c:v>
                </c:pt>
                <c:pt idx="353">
                  <c:v>10</c:v>
                </c:pt>
                <c:pt idx="354">
                  <c:v>11.111111111111111</c:v>
                </c:pt>
                <c:pt idx="355">
                  <c:v>12.222222222222221</c:v>
                </c:pt>
                <c:pt idx="356">
                  <c:v>12.777777777777777</c:v>
                </c:pt>
                <c:pt idx="357">
                  <c:v>13.333333333333332</c:v>
                </c:pt>
                <c:pt idx="358">
                  <c:v>13.888888888888889</c:v>
                </c:pt>
                <c:pt idx="359">
                  <c:v>13.888888888888889</c:v>
                </c:pt>
                <c:pt idx="360">
                  <c:v>14.444444444444445</c:v>
                </c:pt>
                <c:pt idx="361">
                  <c:v>15</c:v>
                </c:pt>
                <c:pt idx="362">
                  <c:v>15</c:v>
                </c:pt>
                <c:pt idx="363">
                  <c:v>15</c:v>
                </c:pt>
                <c:pt idx="364">
                  <c:v>15</c:v>
                </c:pt>
                <c:pt idx="365">
                  <c:v>14.444444444444445</c:v>
                </c:pt>
                <c:pt idx="366">
                  <c:v>14.444444444444445</c:v>
                </c:pt>
                <c:pt idx="367">
                  <c:v>13.888888888888889</c:v>
                </c:pt>
                <c:pt idx="368">
                  <c:v>13.888888888888889</c:v>
                </c:pt>
                <c:pt idx="369">
                  <c:v>13.888888888888889</c:v>
                </c:pt>
                <c:pt idx="370">
                  <c:v>14.444444444444445</c:v>
                </c:pt>
                <c:pt idx="371">
                  <c:v>13.888888888888889</c:v>
                </c:pt>
                <c:pt idx="372">
                  <c:v>13.888888888888889</c:v>
                </c:pt>
                <c:pt idx="373">
                  <c:v>14.444444444444445</c:v>
                </c:pt>
                <c:pt idx="374">
                  <c:v>14.444444444444445</c:v>
                </c:pt>
                <c:pt idx="375">
                  <c:v>14.444444444444445</c:v>
                </c:pt>
                <c:pt idx="376">
                  <c:v>14.444444444444445</c:v>
                </c:pt>
                <c:pt idx="377">
                  <c:v>13.888888888888889</c:v>
                </c:pt>
                <c:pt idx="378">
                  <c:v>13.888888888888889</c:v>
                </c:pt>
                <c:pt idx="379">
                  <c:v>13.888888888888889</c:v>
                </c:pt>
                <c:pt idx="380">
                  <c:v>14.444444444444445</c:v>
                </c:pt>
                <c:pt idx="381">
                  <c:v>15</c:v>
                </c:pt>
                <c:pt idx="382">
                  <c:v>15</c:v>
                </c:pt>
                <c:pt idx="383">
                  <c:v>15.555555555555555</c:v>
                </c:pt>
                <c:pt idx="384">
                  <c:v>15.555555555555555</c:v>
                </c:pt>
                <c:pt idx="385">
                  <c:v>15.555555555555555</c:v>
                </c:pt>
                <c:pt idx="386">
                  <c:v>15.555555555555555</c:v>
                </c:pt>
                <c:pt idx="387">
                  <c:v>15.555555555555555</c:v>
                </c:pt>
                <c:pt idx="388">
                  <c:v>15.555555555555555</c:v>
                </c:pt>
                <c:pt idx="389">
                  <c:v>15.555555555555555</c:v>
                </c:pt>
                <c:pt idx="390">
                  <c:v>15.555555555555555</c:v>
                </c:pt>
                <c:pt idx="391">
                  <c:v>15.555555555555555</c:v>
                </c:pt>
                <c:pt idx="392">
                  <c:v>15.555555555555555</c:v>
                </c:pt>
                <c:pt idx="393">
                  <c:v>15</c:v>
                </c:pt>
                <c:pt idx="394">
                  <c:v>15</c:v>
                </c:pt>
                <c:pt idx="395">
                  <c:v>14.444444444444445</c:v>
                </c:pt>
                <c:pt idx="396">
                  <c:v>14.444444444444445</c:v>
                </c:pt>
                <c:pt idx="397">
                  <c:v>13.888888888888889</c:v>
                </c:pt>
                <c:pt idx="398">
                  <c:v>13.333333333333332</c:v>
                </c:pt>
                <c:pt idx="399">
                  <c:v>13.333333333333332</c:v>
                </c:pt>
                <c:pt idx="400">
                  <c:v>13.333333333333332</c:v>
                </c:pt>
                <c:pt idx="401">
                  <c:v>12.777777777777777</c:v>
                </c:pt>
                <c:pt idx="402">
                  <c:v>12.777777777777777</c:v>
                </c:pt>
                <c:pt idx="403">
                  <c:v>12.777777777777777</c:v>
                </c:pt>
                <c:pt idx="404">
                  <c:v>12.222222222222221</c:v>
                </c:pt>
                <c:pt idx="405">
                  <c:v>12.222222222222221</c:v>
                </c:pt>
                <c:pt idx="406">
                  <c:v>11.666666666666666</c:v>
                </c:pt>
                <c:pt idx="407">
                  <c:v>11.666666666666666</c:v>
                </c:pt>
                <c:pt idx="408">
                  <c:v>11.111111111111111</c:v>
                </c:pt>
                <c:pt idx="409">
                  <c:v>11.111111111111111</c:v>
                </c:pt>
                <c:pt idx="410">
                  <c:v>11.111111111111111</c:v>
                </c:pt>
                <c:pt idx="411">
                  <c:v>10.555555555555555</c:v>
                </c:pt>
                <c:pt idx="412">
                  <c:v>10.555555555555555</c:v>
                </c:pt>
                <c:pt idx="413">
                  <c:v>10.555555555555555</c:v>
                </c:pt>
                <c:pt idx="414">
                  <c:v>10.555555555555555</c:v>
                </c:pt>
                <c:pt idx="415">
                  <c:v>10.555555555555555</c:v>
                </c:pt>
                <c:pt idx="416">
                  <c:v>10.555555555555555</c:v>
                </c:pt>
                <c:pt idx="417">
                  <c:v>10.555555555555555</c:v>
                </c:pt>
                <c:pt idx="418">
                  <c:v>10.555555555555555</c:v>
                </c:pt>
                <c:pt idx="419">
                  <c:v>10.555555555555555</c:v>
                </c:pt>
                <c:pt idx="420">
                  <c:v>10.555555555555555</c:v>
                </c:pt>
                <c:pt idx="421">
                  <c:v>10</c:v>
                </c:pt>
                <c:pt idx="422">
                  <c:v>10</c:v>
                </c:pt>
                <c:pt idx="423">
                  <c:v>10</c:v>
                </c:pt>
                <c:pt idx="424">
                  <c:v>10</c:v>
                </c:pt>
                <c:pt idx="425">
                  <c:v>10</c:v>
                </c:pt>
                <c:pt idx="426">
                  <c:v>9.4444444444444446</c:v>
                </c:pt>
                <c:pt idx="427">
                  <c:v>9.4444444444444446</c:v>
                </c:pt>
                <c:pt idx="428">
                  <c:v>9.4444444444444446</c:v>
                </c:pt>
                <c:pt idx="429">
                  <c:v>9.4444444444444446</c:v>
                </c:pt>
                <c:pt idx="430">
                  <c:v>9.4444444444444446</c:v>
                </c:pt>
                <c:pt idx="431">
                  <c:v>9.4444444444444446</c:v>
                </c:pt>
                <c:pt idx="432">
                  <c:v>8.8888888888888893</c:v>
                </c:pt>
                <c:pt idx="433">
                  <c:v>8.8888888888888893</c:v>
                </c:pt>
                <c:pt idx="434">
                  <c:v>8.3333333333333339</c:v>
                </c:pt>
                <c:pt idx="435">
                  <c:v>8.3333333333333339</c:v>
                </c:pt>
                <c:pt idx="436">
                  <c:v>7.7777777777777777</c:v>
                </c:pt>
                <c:pt idx="437">
                  <c:v>7.7777777777777777</c:v>
                </c:pt>
                <c:pt idx="438">
                  <c:v>7.7777777777777777</c:v>
                </c:pt>
                <c:pt idx="439">
                  <c:v>7.2222222222222223</c:v>
                </c:pt>
                <c:pt idx="440">
                  <c:v>7.2222222222222223</c:v>
                </c:pt>
                <c:pt idx="441">
                  <c:v>7.2222222222222223</c:v>
                </c:pt>
                <c:pt idx="442">
                  <c:v>7.7777777777777777</c:v>
                </c:pt>
                <c:pt idx="443">
                  <c:v>7.7777777777777777</c:v>
                </c:pt>
                <c:pt idx="444">
                  <c:v>7.7777777777777777</c:v>
                </c:pt>
                <c:pt idx="445">
                  <c:v>7.7777777777777777</c:v>
                </c:pt>
                <c:pt idx="446">
                  <c:v>7.7777777777777777</c:v>
                </c:pt>
                <c:pt idx="447">
                  <c:v>7.7777777777777777</c:v>
                </c:pt>
                <c:pt idx="448">
                  <c:v>7.7777777777777777</c:v>
                </c:pt>
                <c:pt idx="449">
                  <c:v>7.7777777777777777</c:v>
                </c:pt>
                <c:pt idx="450">
                  <c:v>7.7777777777777777</c:v>
                </c:pt>
                <c:pt idx="451">
                  <c:v>7.7777777777777777</c:v>
                </c:pt>
                <c:pt idx="452">
                  <c:v>7.7777777777777777</c:v>
                </c:pt>
                <c:pt idx="453">
                  <c:v>7.7777777777777777</c:v>
                </c:pt>
                <c:pt idx="454">
                  <c:v>7.7777777777777777</c:v>
                </c:pt>
                <c:pt idx="455">
                  <c:v>7.7777777777777777</c:v>
                </c:pt>
                <c:pt idx="456">
                  <c:v>7.7777777777777777</c:v>
                </c:pt>
                <c:pt idx="457">
                  <c:v>7.7777777777777777</c:v>
                </c:pt>
                <c:pt idx="458">
                  <c:v>7.7777777777777777</c:v>
                </c:pt>
                <c:pt idx="459">
                  <c:v>7.7777777777777777</c:v>
                </c:pt>
                <c:pt idx="460">
                  <c:v>7.7777777777777777</c:v>
                </c:pt>
                <c:pt idx="461">
                  <c:v>7.7777777777777777</c:v>
                </c:pt>
                <c:pt idx="462">
                  <c:v>8.3333333333333339</c:v>
                </c:pt>
                <c:pt idx="463">
                  <c:v>8.3333333333333339</c:v>
                </c:pt>
                <c:pt idx="464">
                  <c:v>8.3333333333333339</c:v>
                </c:pt>
                <c:pt idx="465">
                  <c:v>8.8888888888888893</c:v>
                </c:pt>
                <c:pt idx="466">
                  <c:v>8.8888888888888893</c:v>
                </c:pt>
                <c:pt idx="467">
                  <c:v>8.8888888888888893</c:v>
                </c:pt>
                <c:pt idx="468">
                  <c:v>8.8888888888888893</c:v>
                </c:pt>
                <c:pt idx="469">
                  <c:v>8.3333333333333339</c:v>
                </c:pt>
                <c:pt idx="470">
                  <c:v>8.3333333333333339</c:v>
                </c:pt>
                <c:pt idx="471">
                  <c:v>8.3333333333333339</c:v>
                </c:pt>
                <c:pt idx="472">
                  <c:v>8.3333333333333339</c:v>
                </c:pt>
                <c:pt idx="473">
                  <c:v>8.3333333333333339</c:v>
                </c:pt>
                <c:pt idx="474">
                  <c:v>8.3333333333333339</c:v>
                </c:pt>
                <c:pt idx="475">
                  <c:v>8.3333333333333339</c:v>
                </c:pt>
                <c:pt idx="476">
                  <c:v>8.3333333333333339</c:v>
                </c:pt>
                <c:pt idx="477">
                  <c:v>8.3333333333333339</c:v>
                </c:pt>
                <c:pt idx="478">
                  <c:v>8.3333333333333339</c:v>
                </c:pt>
                <c:pt idx="479">
                  <c:v>8.3333333333333339</c:v>
                </c:pt>
                <c:pt idx="480">
                  <c:v>8.3333333333333339</c:v>
                </c:pt>
                <c:pt idx="481">
                  <c:v>8.3333333333333339</c:v>
                </c:pt>
                <c:pt idx="482">
                  <c:v>8.3333333333333339</c:v>
                </c:pt>
                <c:pt idx="483">
                  <c:v>8.3333333333333339</c:v>
                </c:pt>
                <c:pt idx="484">
                  <c:v>8.3333333333333339</c:v>
                </c:pt>
                <c:pt idx="485">
                  <c:v>8.3333333333333339</c:v>
                </c:pt>
                <c:pt idx="486">
                  <c:v>8.3333333333333339</c:v>
                </c:pt>
                <c:pt idx="487">
                  <c:v>8.8888888888888893</c:v>
                </c:pt>
                <c:pt idx="488">
                  <c:v>8.3333333333333339</c:v>
                </c:pt>
                <c:pt idx="489">
                  <c:v>8.3333333333333339</c:v>
                </c:pt>
                <c:pt idx="490">
                  <c:v>8.3333333333333339</c:v>
                </c:pt>
                <c:pt idx="491">
                  <c:v>8.8888888888888893</c:v>
                </c:pt>
                <c:pt idx="492">
                  <c:v>8.8888888888888893</c:v>
                </c:pt>
                <c:pt idx="493">
                  <c:v>8.3333333333333339</c:v>
                </c:pt>
                <c:pt idx="494">
                  <c:v>8.8888888888888893</c:v>
                </c:pt>
                <c:pt idx="495">
                  <c:v>8.8888888888888893</c:v>
                </c:pt>
                <c:pt idx="496">
                  <c:v>8.3333333333333339</c:v>
                </c:pt>
                <c:pt idx="497">
                  <c:v>7.7777777777777777</c:v>
                </c:pt>
                <c:pt idx="498">
                  <c:v>7.7777777777777777</c:v>
                </c:pt>
                <c:pt idx="499">
                  <c:v>8.3333333333333339</c:v>
                </c:pt>
                <c:pt idx="500">
                  <c:v>7.7777777777777777</c:v>
                </c:pt>
                <c:pt idx="501">
                  <c:v>7.7777777777777777</c:v>
                </c:pt>
                <c:pt idx="502">
                  <c:v>7.7777777777777777</c:v>
                </c:pt>
                <c:pt idx="503">
                  <c:v>7.7777777777777777</c:v>
                </c:pt>
                <c:pt idx="504">
                  <c:v>7.7777777777777777</c:v>
                </c:pt>
                <c:pt idx="505">
                  <c:v>8.3333333333333339</c:v>
                </c:pt>
                <c:pt idx="506">
                  <c:v>8.3333333333333339</c:v>
                </c:pt>
                <c:pt idx="507">
                  <c:v>8.3333333333333339</c:v>
                </c:pt>
                <c:pt idx="508">
                  <c:v>8.3333333333333339</c:v>
                </c:pt>
                <c:pt idx="509">
                  <c:v>8.8888888888888893</c:v>
                </c:pt>
                <c:pt idx="510">
                  <c:v>8.8888888888888893</c:v>
                </c:pt>
                <c:pt idx="511">
                  <c:v>8.8888888888888893</c:v>
                </c:pt>
                <c:pt idx="512">
                  <c:v>9.4444444444444446</c:v>
                </c:pt>
                <c:pt idx="513">
                  <c:v>10</c:v>
                </c:pt>
                <c:pt idx="514">
                  <c:v>10</c:v>
                </c:pt>
                <c:pt idx="515">
                  <c:v>10</c:v>
                </c:pt>
                <c:pt idx="516">
                  <c:v>10</c:v>
                </c:pt>
                <c:pt idx="517">
                  <c:v>10</c:v>
                </c:pt>
                <c:pt idx="518">
                  <c:v>10</c:v>
                </c:pt>
                <c:pt idx="519">
                  <c:v>10</c:v>
                </c:pt>
                <c:pt idx="520">
                  <c:v>10.555555555555555</c:v>
                </c:pt>
                <c:pt idx="521">
                  <c:v>11.111111111111111</c:v>
                </c:pt>
                <c:pt idx="522">
                  <c:v>11.111111111111111</c:v>
                </c:pt>
                <c:pt idx="523">
                  <c:v>11.111111111111111</c:v>
                </c:pt>
                <c:pt idx="524">
                  <c:v>11.111111111111111</c:v>
                </c:pt>
                <c:pt idx="525">
                  <c:v>11.111111111111111</c:v>
                </c:pt>
                <c:pt idx="526">
                  <c:v>11.111111111111111</c:v>
                </c:pt>
                <c:pt idx="527">
                  <c:v>11.111111111111111</c:v>
                </c:pt>
                <c:pt idx="528">
                  <c:v>11.111111111111111</c:v>
                </c:pt>
                <c:pt idx="529">
                  <c:v>11.111111111111111</c:v>
                </c:pt>
                <c:pt idx="530">
                  <c:v>11.111111111111111</c:v>
                </c:pt>
                <c:pt idx="531">
                  <c:v>11.666666666666666</c:v>
                </c:pt>
                <c:pt idx="532">
                  <c:v>11.111111111111111</c:v>
                </c:pt>
                <c:pt idx="533">
                  <c:v>11.666666666666666</c:v>
                </c:pt>
                <c:pt idx="534">
                  <c:v>11.111111111111111</c:v>
                </c:pt>
                <c:pt idx="535">
                  <c:v>11.111111111111111</c:v>
                </c:pt>
                <c:pt idx="536">
                  <c:v>11.111111111111111</c:v>
                </c:pt>
                <c:pt idx="537">
                  <c:v>11.666666666666666</c:v>
                </c:pt>
                <c:pt idx="538">
                  <c:v>12.222222222222221</c:v>
                </c:pt>
                <c:pt idx="539">
                  <c:v>12.777777777777777</c:v>
                </c:pt>
                <c:pt idx="540">
                  <c:v>12.777777777777777</c:v>
                </c:pt>
                <c:pt idx="541">
                  <c:v>12.777777777777777</c:v>
                </c:pt>
                <c:pt idx="542">
                  <c:v>12.222222222222221</c:v>
                </c:pt>
                <c:pt idx="543">
                  <c:v>12.222222222222221</c:v>
                </c:pt>
                <c:pt idx="544">
                  <c:v>11.666666666666666</c:v>
                </c:pt>
                <c:pt idx="545">
                  <c:v>11.666666666666666</c:v>
                </c:pt>
                <c:pt idx="546">
                  <c:v>11.111111111111111</c:v>
                </c:pt>
                <c:pt idx="547">
                  <c:v>10.555555555555555</c:v>
                </c:pt>
                <c:pt idx="548">
                  <c:v>10</c:v>
                </c:pt>
                <c:pt idx="549">
                  <c:v>9.4444444444444446</c:v>
                </c:pt>
                <c:pt idx="550">
                  <c:v>8.3333333333333339</c:v>
                </c:pt>
                <c:pt idx="551">
                  <c:v>7.7777777777777777</c:v>
                </c:pt>
                <c:pt idx="552">
                  <c:v>7.2222222222222223</c:v>
                </c:pt>
                <c:pt idx="553">
                  <c:v>6.6666666666666661</c:v>
                </c:pt>
                <c:pt idx="554">
                  <c:v>6.1111111111111107</c:v>
                </c:pt>
                <c:pt idx="555">
                  <c:v>5</c:v>
                </c:pt>
                <c:pt idx="556">
                  <c:v>4.4444444444444446</c:v>
                </c:pt>
                <c:pt idx="557">
                  <c:v>3.8888888888888888</c:v>
                </c:pt>
                <c:pt idx="558">
                  <c:v>3.333333333333333</c:v>
                </c:pt>
                <c:pt idx="559">
                  <c:v>2.7777777777777777</c:v>
                </c:pt>
                <c:pt idx="560">
                  <c:v>2.7777777777777777</c:v>
                </c:pt>
                <c:pt idx="561">
                  <c:v>2.2222222222222223</c:v>
                </c:pt>
                <c:pt idx="562">
                  <c:v>1.6666666666666665</c:v>
                </c:pt>
                <c:pt idx="563">
                  <c:v>1.6666666666666665</c:v>
                </c:pt>
                <c:pt idx="564">
                  <c:v>1.1111111111111112</c:v>
                </c:pt>
                <c:pt idx="565">
                  <c:v>1.1111111111111112</c:v>
                </c:pt>
                <c:pt idx="566">
                  <c:v>1.1111111111111112</c:v>
                </c:pt>
                <c:pt idx="567">
                  <c:v>0.55555555555555558</c:v>
                </c:pt>
                <c:pt idx="568">
                  <c:v>0.55555555555555558</c:v>
                </c:pt>
                <c:pt idx="569">
                  <c:v>0.55555555555555558</c:v>
                </c:pt>
                <c:pt idx="570">
                  <c:v>0.55555555555555558</c:v>
                </c:pt>
                <c:pt idx="571">
                  <c:v>0.55555555555555558</c:v>
                </c:pt>
                <c:pt idx="572">
                  <c:v>0.55555555555555558</c:v>
                </c:pt>
                <c:pt idx="573">
                  <c:v>1.1111111111111112</c:v>
                </c:pt>
                <c:pt idx="574">
                  <c:v>1.6666666666666665</c:v>
                </c:pt>
                <c:pt idx="575">
                  <c:v>1.6666666666666665</c:v>
                </c:pt>
                <c:pt idx="576">
                  <c:v>1.6666666666666665</c:v>
                </c:pt>
                <c:pt idx="577">
                  <c:v>1.6666666666666665</c:v>
                </c:pt>
                <c:pt idx="578">
                  <c:v>1.6666666666666665</c:v>
                </c:pt>
                <c:pt idx="579">
                  <c:v>1.6666666666666665</c:v>
                </c:pt>
                <c:pt idx="580">
                  <c:v>1.6666666666666665</c:v>
                </c:pt>
                <c:pt idx="581">
                  <c:v>1.6666666666666665</c:v>
                </c:pt>
                <c:pt idx="582">
                  <c:v>1.1111111111111112</c:v>
                </c:pt>
                <c:pt idx="583">
                  <c:v>1.1111111111111112</c:v>
                </c:pt>
                <c:pt idx="584">
                  <c:v>0.55555555555555558</c:v>
                </c:pt>
                <c:pt idx="585">
                  <c:v>0.55555555555555558</c:v>
                </c:pt>
                <c:pt idx="586">
                  <c:v>0</c:v>
                </c:pt>
                <c:pt idx="587">
                  <c:v>0</c:v>
                </c:pt>
                <c:pt idx="588">
                  <c:v>0</c:v>
                </c:pt>
                <c:pt idx="589">
                  <c:v>0</c:v>
                </c:pt>
                <c:pt idx="590">
                  <c:v>0</c:v>
                </c:pt>
                <c:pt idx="591">
                  <c:v>-0.55555555555555558</c:v>
                </c:pt>
                <c:pt idx="592">
                  <c:v>-0.55555555555555558</c:v>
                </c:pt>
                <c:pt idx="593">
                  <c:v>-0.55555555555555558</c:v>
                </c:pt>
                <c:pt idx="594">
                  <c:v>-0.55555555555555558</c:v>
                </c:pt>
                <c:pt idx="595">
                  <c:v>-0.55555555555555558</c:v>
                </c:pt>
                <c:pt idx="596">
                  <c:v>-0.55555555555555558</c:v>
                </c:pt>
                <c:pt idx="597">
                  <c:v>-0.55555555555555558</c:v>
                </c:pt>
                <c:pt idx="598">
                  <c:v>0</c:v>
                </c:pt>
                <c:pt idx="599">
                  <c:v>0</c:v>
                </c:pt>
                <c:pt idx="600">
                  <c:v>0</c:v>
                </c:pt>
                <c:pt idx="601">
                  <c:v>0</c:v>
                </c:pt>
                <c:pt idx="602">
                  <c:v>0</c:v>
                </c:pt>
                <c:pt idx="603">
                  <c:v>0</c:v>
                </c:pt>
                <c:pt idx="604">
                  <c:v>0</c:v>
                </c:pt>
                <c:pt idx="605">
                  <c:v>0</c:v>
                </c:pt>
                <c:pt idx="606">
                  <c:v>-0.55555555555555558</c:v>
                </c:pt>
                <c:pt idx="607">
                  <c:v>-1.1111111111111112</c:v>
                </c:pt>
                <c:pt idx="608">
                  <c:v>-1.6666666666666665</c:v>
                </c:pt>
                <c:pt idx="609">
                  <c:v>-1.6666666666666665</c:v>
                </c:pt>
                <c:pt idx="610">
                  <c:v>-2.2222222222222223</c:v>
                </c:pt>
                <c:pt idx="611">
                  <c:v>-1.6666666666666665</c:v>
                </c:pt>
                <c:pt idx="612">
                  <c:v>-1.6666666666666665</c:v>
                </c:pt>
                <c:pt idx="613">
                  <c:v>-1.6666666666666665</c:v>
                </c:pt>
                <c:pt idx="614">
                  <c:v>-1.6666666666666665</c:v>
                </c:pt>
                <c:pt idx="615">
                  <c:v>-1.6666666666666665</c:v>
                </c:pt>
                <c:pt idx="616">
                  <c:v>-1.6666666666666665</c:v>
                </c:pt>
                <c:pt idx="617">
                  <c:v>-1.6666666666666665</c:v>
                </c:pt>
                <c:pt idx="618">
                  <c:v>-1.1111111111111112</c:v>
                </c:pt>
                <c:pt idx="619">
                  <c:v>0</c:v>
                </c:pt>
                <c:pt idx="620">
                  <c:v>1.1111111111111112</c:v>
                </c:pt>
                <c:pt idx="621">
                  <c:v>2.7777777777777777</c:v>
                </c:pt>
                <c:pt idx="622">
                  <c:v>4.4444444444444446</c:v>
                </c:pt>
                <c:pt idx="623">
                  <c:v>6.1111111111111107</c:v>
                </c:pt>
                <c:pt idx="624">
                  <c:v>7.2222222222222223</c:v>
                </c:pt>
                <c:pt idx="625">
                  <c:v>8.3333333333333339</c:v>
                </c:pt>
                <c:pt idx="626">
                  <c:v>9.4444444444444446</c:v>
                </c:pt>
                <c:pt idx="627">
                  <c:v>10</c:v>
                </c:pt>
                <c:pt idx="628">
                  <c:v>11.111111111111111</c:v>
                </c:pt>
                <c:pt idx="629">
                  <c:v>11.666666666666666</c:v>
                </c:pt>
                <c:pt idx="630">
                  <c:v>12.222222222222221</c:v>
                </c:pt>
                <c:pt idx="631">
                  <c:v>12.777777777777777</c:v>
                </c:pt>
                <c:pt idx="632">
                  <c:v>12.777777777777777</c:v>
                </c:pt>
                <c:pt idx="633">
                  <c:v>13.333333333333332</c:v>
                </c:pt>
                <c:pt idx="634">
                  <c:v>13.888888888888889</c:v>
                </c:pt>
                <c:pt idx="635">
                  <c:v>13.888888888888889</c:v>
                </c:pt>
                <c:pt idx="636">
                  <c:v>13.888888888888889</c:v>
                </c:pt>
                <c:pt idx="637">
                  <c:v>13.888888888888889</c:v>
                </c:pt>
                <c:pt idx="638">
                  <c:v>14.444444444444445</c:v>
                </c:pt>
                <c:pt idx="639">
                  <c:v>14.444444444444445</c:v>
                </c:pt>
                <c:pt idx="640">
                  <c:v>14.444444444444445</c:v>
                </c:pt>
                <c:pt idx="641">
                  <c:v>15</c:v>
                </c:pt>
                <c:pt idx="642">
                  <c:v>15</c:v>
                </c:pt>
                <c:pt idx="643">
                  <c:v>15.555555555555555</c:v>
                </c:pt>
                <c:pt idx="644">
                  <c:v>15.555555555555555</c:v>
                </c:pt>
                <c:pt idx="645">
                  <c:v>16.111111111111111</c:v>
                </c:pt>
                <c:pt idx="646">
                  <c:v>16.666666666666668</c:v>
                </c:pt>
                <c:pt idx="647">
                  <c:v>16.666666666666668</c:v>
                </c:pt>
                <c:pt idx="648">
                  <c:v>17.222222222222221</c:v>
                </c:pt>
                <c:pt idx="649">
                  <c:v>17.777777777777779</c:v>
                </c:pt>
                <c:pt idx="650">
                  <c:v>18.333333333333332</c:v>
                </c:pt>
                <c:pt idx="651">
                  <c:v>17.777777777777779</c:v>
                </c:pt>
                <c:pt idx="652">
                  <c:v>17.222222222222221</c:v>
                </c:pt>
                <c:pt idx="653">
                  <c:v>16.666666666666668</c:v>
                </c:pt>
                <c:pt idx="654">
                  <c:v>16.111111111111111</c:v>
                </c:pt>
                <c:pt idx="655">
                  <c:v>16.111111111111111</c:v>
                </c:pt>
                <c:pt idx="656">
                  <c:v>16.666666666666668</c:v>
                </c:pt>
                <c:pt idx="657">
                  <c:v>17.222222222222221</c:v>
                </c:pt>
                <c:pt idx="658">
                  <c:v>16.666666666666668</c:v>
                </c:pt>
                <c:pt idx="659">
                  <c:v>16.666666666666668</c:v>
                </c:pt>
                <c:pt idx="660">
                  <c:v>17.222222222222221</c:v>
                </c:pt>
                <c:pt idx="661">
                  <c:v>17.777777777777779</c:v>
                </c:pt>
                <c:pt idx="662">
                  <c:v>17.777777777777779</c:v>
                </c:pt>
                <c:pt idx="663">
                  <c:v>17.777777777777779</c:v>
                </c:pt>
                <c:pt idx="664">
                  <c:v>17.777777777777779</c:v>
                </c:pt>
                <c:pt idx="665">
                  <c:v>17.222222222222221</c:v>
                </c:pt>
                <c:pt idx="666">
                  <c:v>17.222222222222221</c:v>
                </c:pt>
                <c:pt idx="667">
                  <c:v>17.777777777777779</c:v>
                </c:pt>
                <c:pt idx="668">
                  <c:v>17.777777777777779</c:v>
                </c:pt>
                <c:pt idx="669">
                  <c:v>17.777777777777779</c:v>
                </c:pt>
                <c:pt idx="670">
                  <c:v>17.777777777777779</c:v>
                </c:pt>
                <c:pt idx="671">
                  <c:v>17.777777777777779</c:v>
                </c:pt>
                <c:pt idx="672">
                  <c:v>17.777777777777779</c:v>
                </c:pt>
                <c:pt idx="673">
                  <c:v>17.222222222222221</c:v>
                </c:pt>
                <c:pt idx="674">
                  <c:v>17.222222222222221</c:v>
                </c:pt>
                <c:pt idx="675">
                  <c:v>17.222222222222221</c:v>
                </c:pt>
                <c:pt idx="676">
                  <c:v>17.222222222222221</c:v>
                </c:pt>
                <c:pt idx="677">
                  <c:v>17.222222222222221</c:v>
                </c:pt>
                <c:pt idx="678">
                  <c:v>18.333333333333332</c:v>
                </c:pt>
                <c:pt idx="679">
                  <c:v>18.333333333333332</c:v>
                </c:pt>
                <c:pt idx="680">
                  <c:v>18.333333333333332</c:v>
                </c:pt>
                <c:pt idx="681">
                  <c:v>18.333333333333332</c:v>
                </c:pt>
                <c:pt idx="682">
                  <c:v>17.777777777777779</c:v>
                </c:pt>
                <c:pt idx="683">
                  <c:v>17.777777777777779</c:v>
                </c:pt>
                <c:pt idx="684">
                  <c:v>18.888888888888889</c:v>
                </c:pt>
                <c:pt idx="685">
                  <c:v>19.444444444444443</c:v>
                </c:pt>
                <c:pt idx="686">
                  <c:v>19.444444444444443</c:v>
                </c:pt>
                <c:pt idx="687">
                  <c:v>19.444444444444443</c:v>
                </c:pt>
                <c:pt idx="688">
                  <c:v>18.888888888888889</c:v>
                </c:pt>
                <c:pt idx="689">
                  <c:v>18.333333333333332</c:v>
                </c:pt>
                <c:pt idx="690">
                  <c:v>17.777777777777779</c:v>
                </c:pt>
                <c:pt idx="691">
                  <c:v>17.777777777777779</c:v>
                </c:pt>
                <c:pt idx="692">
                  <c:v>17.222222222222221</c:v>
                </c:pt>
                <c:pt idx="693">
                  <c:v>16.666666666666668</c:v>
                </c:pt>
                <c:pt idx="694">
                  <c:v>16.111111111111111</c:v>
                </c:pt>
                <c:pt idx="695">
                  <c:v>15.555555555555555</c:v>
                </c:pt>
                <c:pt idx="696">
                  <c:v>15</c:v>
                </c:pt>
                <c:pt idx="697">
                  <c:v>14.444444444444445</c:v>
                </c:pt>
                <c:pt idx="698">
                  <c:v>13.888888888888889</c:v>
                </c:pt>
                <c:pt idx="699">
                  <c:v>13.333333333333332</c:v>
                </c:pt>
                <c:pt idx="700">
                  <c:v>12.777777777777777</c:v>
                </c:pt>
                <c:pt idx="701">
                  <c:v>12.777777777777777</c:v>
                </c:pt>
                <c:pt idx="702">
                  <c:v>12.777777777777777</c:v>
                </c:pt>
                <c:pt idx="703">
                  <c:v>12.222222222222221</c:v>
                </c:pt>
                <c:pt idx="704">
                  <c:v>12.222222222222221</c:v>
                </c:pt>
                <c:pt idx="705">
                  <c:v>11.666666666666666</c:v>
                </c:pt>
                <c:pt idx="706">
                  <c:v>11.666666666666666</c:v>
                </c:pt>
                <c:pt idx="707">
                  <c:v>11.111111111111111</c:v>
                </c:pt>
                <c:pt idx="708">
                  <c:v>11.111111111111111</c:v>
                </c:pt>
                <c:pt idx="709">
                  <c:v>11.111111111111111</c:v>
                </c:pt>
                <c:pt idx="710">
                  <c:v>11.111111111111111</c:v>
                </c:pt>
                <c:pt idx="711">
                  <c:v>11.111111111111111</c:v>
                </c:pt>
                <c:pt idx="712">
                  <c:v>11.111111111111111</c:v>
                </c:pt>
                <c:pt idx="713">
                  <c:v>10.555555555555555</c:v>
                </c:pt>
                <c:pt idx="714">
                  <c:v>10.555555555555555</c:v>
                </c:pt>
                <c:pt idx="715">
                  <c:v>10.555555555555555</c:v>
                </c:pt>
                <c:pt idx="716">
                  <c:v>10.555555555555555</c:v>
                </c:pt>
                <c:pt idx="717">
                  <c:v>11.111111111111111</c:v>
                </c:pt>
                <c:pt idx="718">
                  <c:v>11.111111111111111</c:v>
                </c:pt>
                <c:pt idx="719">
                  <c:v>11.11111111111111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73F4-4DD9-BA8C-E90539049534}"/>
            </c:ext>
          </c:extLst>
        </c:ser>
        <c:ser>
          <c:idx val="1"/>
          <c:order val="1"/>
          <c:tx>
            <c:strRef>
              <c:f>Sunhigh_1!$D$1</c:f>
              <c:strCache>
                <c:ptCount val="1"/>
                <c:pt idx="0">
                  <c:v>Redhaven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xVal>
            <c:numRef>
              <c:f>Sunhigh_1!$B$2:$B$721</c:f>
              <c:numCache>
                <c:formatCode>m/d;@</c:formatCode>
                <c:ptCount val="720"/>
                <c:pt idx="0">
                  <c:v>43936</c:v>
                </c:pt>
                <c:pt idx="1">
                  <c:v>43936.006944444445</c:v>
                </c:pt>
                <c:pt idx="2">
                  <c:v>43936.013888888891</c:v>
                </c:pt>
                <c:pt idx="3">
                  <c:v>43936.020833333336</c:v>
                </c:pt>
                <c:pt idx="4">
                  <c:v>43936.027777777781</c:v>
                </c:pt>
                <c:pt idx="5">
                  <c:v>43936.034722222219</c:v>
                </c:pt>
                <c:pt idx="6">
                  <c:v>43936.041666666664</c:v>
                </c:pt>
                <c:pt idx="7">
                  <c:v>43936.048611111109</c:v>
                </c:pt>
                <c:pt idx="8">
                  <c:v>43936.055555555555</c:v>
                </c:pt>
                <c:pt idx="9">
                  <c:v>43936.0625</c:v>
                </c:pt>
                <c:pt idx="10">
                  <c:v>43936.069444444445</c:v>
                </c:pt>
                <c:pt idx="11">
                  <c:v>43936.076388888891</c:v>
                </c:pt>
                <c:pt idx="12">
                  <c:v>43936.083333333336</c:v>
                </c:pt>
                <c:pt idx="13">
                  <c:v>43936.090277777781</c:v>
                </c:pt>
                <c:pt idx="14">
                  <c:v>43936.097222222219</c:v>
                </c:pt>
                <c:pt idx="15">
                  <c:v>43936.104166666664</c:v>
                </c:pt>
                <c:pt idx="16">
                  <c:v>43936.111111111109</c:v>
                </c:pt>
                <c:pt idx="17">
                  <c:v>43936.118055555555</c:v>
                </c:pt>
                <c:pt idx="18">
                  <c:v>43936.125</c:v>
                </c:pt>
                <c:pt idx="19">
                  <c:v>43936.131944444445</c:v>
                </c:pt>
                <c:pt idx="20">
                  <c:v>43936.138888888891</c:v>
                </c:pt>
                <c:pt idx="21">
                  <c:v>43936.145833333336</c:v>
                </c:pt>
                <c:pt idx="22">
                  <c:v>43936.152777777781</c:v>
                </c:pt>
                <c:pt idx="23">
                  <c:v>43936.159722222219</c:v>
                </c:pt>
                <c:pt idx="24">
                  <c:v>43936.166666666664</c:v>
                </c:pt>
                <c:pt idx="25">
                  <c:v>43936.173611111109</c:v>
                </c:pt>
                <c:pt idx="26">
                  <c:v>43936.180555555555</c:v>
                </c:pt>
                <c:pt idx="27">
                  <c:v>43936.1875</c:v>
                </c:pt>
                <c:pt idx="28">
                  <c:v>43936.194444444445</c:v>
                </c:pt>
                <c:pt idx="29">
                  <c:v>43936.201388888891</c:v>
                </c:pt>
                <c:pt idx="30">
                  <c:v>43936.208333333336</c:v>
                </c:pt>
                <c:pt idx="31">
                  <c:v>43936.215277777781</c:v>
                </c:pt>
                <c:pt idx="32">
                  <c:v>43936.222222222219</c:v>
                </c:pt>
                <c:pt idx="33">
                  <c:v>43936.229166666664</c:v>
                </c:pt>
                <c:pt idx="34">
                  <c:v>43936.236111111109</c:v>
                </c:pt>
                <c:pt idx="35">
                  <c:v>43936.243055555555</c:v>
                </c:pt>
                <c:pt idx="36">
                  <c:v>43936.25</c:v>
                </c:pt>
                <c:pt idx="37">
                  <c:v>43936.256944444445</c:v>
                </c:pt>
                <c:pt idx="38">
                  <c:v>43936.263888888891</c:v>
                </c:pt>
                <c:pt idx="39">
                  <c:v>43936.270833333336</c:v>
                </c:pt>
                <c:pt idx="40">
                  <c:v>43936.277777777781</c:v>
                </c:pt>
                <c:pt idx="41">
                  <c:v>43936.284722222219</c:v>
                </c:pt>
                <c:pt idx="42">
                  <c:v>43936.291666666664</c:v>
                </c:pt>
                <c:pt idx="43">
                  <c:v>43936.298611111109</c:v>
                </c:pt>
                <c:pt idx="44">
                  <c:v>43936.305555555555</c:v>
                </c:pt>
                <c:pt idx="45">
                  <c:v>43936.3125</c:v>
                </c:pt>
                <c:pt idx="46">
                  <c:v>43936.319444444445</c:v>
                </c:pt>
                <c:pt idx="47">
                  <c:v>43936.326388888891</c:v>
                </c:pt>
                <c:pt idx="48">
                  <c:v>43936.333333333336</c:v>
                </c:pt>
                <c:pt idx="49">
                  <c:v>43936.340277777781</c:v>
                </c:pt>
                <c:pt idx="50">
                  <c:v>43936.347222222219</c:v>
                </c:pt>
                <c:pt idx="51">
                  <c:v>43936.354166666664</c:v>
                </c:pt>
                <c:pt idx="52">
                  <c:v>43936.361111111109</c:v>
                </c:pt>
                <c:pt idx="53">
                  <c:v>43936.368055555555</c:v>
                </c:pt>
                <c:pt idx="54">
                  <c:v>43936.375</c:v>
                </c:pt>
                <c:pt idx="55">
                  <c:v>43936.381944444445</c:v>
                </c:pt>
                <c:pt idx="56">
                  <c:v>43936.388888888891</c:v>
                </c:pt>
                <c:pt idx="57">
                  <c:v>43936.395833333336</c:v>
                </c:pt>
                <c:pt idx="58">
                  <c:v>43936.402777777781</c:v>
                </c:pt>
                <c:pt idx="59">
                  <c:v>43936.409722222219</c:v>
                </c:pt>
                <c:pt idx="60">
                  <c:v>43936.416666666664</c:v>
                </c:pt>
                <c:pt idx="61">
                  <c:v>43936.423611111109</c:v>
                </c:pt>
                <c:pt idx="62">
                  <c:v>43936.430555555555</c:v>
                </c:pt>
                <c:pt idx="63">
                  <c:v>43936.4375</c:v>
                </c:pt>
                <c:pt idx="64">
                  <c:v>43936.444444444445</c:v>
                </c:pt>
                <c:pt idx="65">
                  <c:v>43936.451388888891</c:v>
                </c:pt>
                <c:pt idx="66">
                  <c:v>43936.458333333336</c:v>
                </c:pt>
                <c:pt idx="67">
                  <c:v>43936.465277777781</c:v>
                </c:pt>
                <c:pt idx="68">
                  <c:v>43936.472222222219</c:v>
                </c:pt>
                <c:pt idx="69">
                  <c:v>43936.479166666664</c:v>
                </c:pt>
                <c:pt idx="70">
                  <c:v>43936.486111111109</c:v>
                </c:pt>
                <c:pt idx="71">
                  <c:v>43936.493055555555</c:v>
                </c:pt>
                <c:pt idx="72">
                  <c:v>43936.5</c:v>
                </c:pt>
                <c:pt idx="73">
                  <c:v>43936.506944444445</c:v>
                </c:pt>
                <c:pt idx="74">
                  <c:v>43936.513888888891</c:v>
                </c:pt>
                <c:pt idx="75">
                  <c:v>43936.520833333336</c:v>
                </c:pt>
                <c:pt idx="76">
                  <c:v>43936.527777777781</c:v>
                </c:pt>
                <c:pt idx="77">
                  <c:v>43936.534722222219</c:v>
                </c:pt>
                <c:pt idx="78">
                  <c:v>43936.541666666664</c:v>
                </c:pt>
                <c:pt idx="79">
                  <c:v>43936.548611111109</c:v>
                </c:pt>
                <c:pt idx="80">
                  <c:v>43936.555555555555</c:v>
                </c:pt>
                <c:pt idx="81">
                  <c:v>43936.5625</c:v>
                </c:pt>
                <c:pt idx="82">
                  <c:v>43936.569444444445</c:v>
                </c:pt>
                <c:pt idx="83">
                  <c:v>43936.576388888891</c:v>
                </c:pt>
                <c:pt idx="84">
                  <c:v>43936.583333333336</c:v>
                </c:pt>
                <c:pt idx="85">
                  <c:v>43936.590277777781</c:v>
                </c:pt>
                <c:pt idx="86">
                  <c:v>43936.597222222219</c:v>
                </c:pt>
                <c:pt idx="87">
                  <c:v>43936.604166666664</c:v>
                </c:pt>
                <c:pt idx="88">
                  <c:v>43936.611111111109</c:v>
                </c:pt>
                <c:pt idx="89">
                  <c:v>43936.618055555555</c:v>
                </c:pt>
                <c:pt idx="90">
                  <c:v>43936.625</c:v>
                </c:pt>
                <c:pt idx="91">
                  <c:v>43936.631944444445</c:v>
                </c:pt>
                <c:pt idx="92">
                  <c:v>43936.638888888891</c:v>
                </c:pt>
                <c:pt idx="93">
                  <c:v>43936.645833333336</c:v>
                </c:pt>
                <c:pt idx="94">
                  <c:v>43936.652777777781</c:v>
                </c:pt>
                <c:pt idx="95">
                  <c:v>43936.659722222219</c:v>
                </c:pt>
                <c:pt idx="96">
                  <c:v>43936.666666666664</c:v>
                </c:pt>
                <c:pt idx="97">
                  <c:v>43936.673611111109</c:v>
                </c:pt>
                <c:pt idx="98">
                  <c:v>43936.680555555555</c:v>
                </c:pt>
                <c:pt idx="99">
                  <c:v>43936.6875</c:v>
                </c:pt>
                <c:pt idx="100">
                  <c:v>43936.694444444445</c:v>
                </c:pt>
                <c:pt idx="101">
                  <c:v>43936.701388888891</c:v>
                </c:pt>
                <c:pt idx="102">
                  <c:v>43936.708333333336</c:v>
                </c:pt>
                <c:pt idx="103">
                  <c:v>43936.715277777781</c:v>
                </c:pt>
                <c:pt idx="104">
                  <c:v>43936.722222222219</c:v>
                </c:pt>
                <c:pt idx="105">
                  <c:v>43936.729166666664</c:v>
                </c:pt>
                <c:pt idx="106">
                  <c:v>43936.736111111109</c:v>
                </c:pt>
                <c:pt idx="107">
                  <c:v>43936.743055555555</c:v>
                </c:pt>
                <c:pt idx="108">
                  <c:v>43936.75</c:v>
                </c:pt>
                <c:pt idx="109">
                  <c:v>43936.756944444445</c:v>
                </c:pt>
                <c:pt idx="110">
                  <c:v>43936.763888888891</c:v>
                </c:pt>
                <c:pt idx="111">
                  <c:v>43936.770833333336</c:v>
                </c:pt>
                <c:pt idx="112">
                  <c:v>43936.777777777781</c:v>
                </c:pt>
                <c:pt idx="113">
                  <c:v>43936.784722222219</c:v>
                </c:pt>
                <c:pt idx="114">
                  <c:v>43936.791666666664</c:v>
                </c:pt>
                <c:pt idx="115">
                  <c:v>43936.798611111109</c:v>
                </c:pt>
                <c:pt idx="116">
                  <c:v>43936.805555555555</c:v>
                </c:pt>
                <c:pt idx="117">
                  <c:v>43936.8125</c:v>
                </c:pt>
                <c:pt idx="118">
                  <c:v>43936.819444444445</c:v>
                </c:pt>
                <c:pt idx="119">
                  <c:v>43936.826388888891</c:v>
                </c:pt>
                <c:pt idx="120">
                  <c:v>43936.833333333336</c:v>
                </c:pt>
                <c:pt idx="121">
                  <c:v>43936.840277777781</c:v>
                </c:pt>
                <c:pt idx="122">
                  <c:v>43936.847222222219</c:v>
                </c:pt>
                <c:pt idx="123">
                  <c:v>43936.854166666664</c:v>
                </c:pt>
                <c:pt idx="124">
                  <c:v>43936.861111111109</c:v>
                </c:pt>
                <c:pt idx="125">
                  <c:v>43936.868055555555</c:v>
                </c:pt>
                <c:pt idx="126">
                  <c:v>43936.875</c:v>
                </c:pt>
                <c:pt idx="127">
                  <c:v>43936.881944444445</c:v>
                </c:pt>
                <c:pt idx="128">
                  <c:v>43936.888888888891</c:v>
                </c:pt>
                <c:pt idx="129">
                  <c:v>43936.895833333336</c:v>
                </c:pt>
                <c:pt idx="130">
                  <c:v>43936.902777777781</c:v>
                </c:pt>
                <c:pt idx="131">
                  <c:v>43936.909722222219</c:v>
                </c:pt>
                <c:pt idx="132">
                  <c:v>43936.916666666664</c:v>
                </c:pt>
                <c:pt idx="133">
                  <c:v>43936.923611111109</c:v>
                </c:pt>
                <c:pt idx="134">
                  <c:v>43936.930555555555</c:v>
                </c:pt>
                <c:pt idx="135">
                  <c:v>43936.9375</c:v>
                </c:pt>
                <c:pt idx="136">
                  <c:v>43936.944444444445</c:v>
                </c:pt>
                <c:pt idx="137">
                  <c:v>43936.951388888891</c:v>
                </c:pt>
                <c:pt idx="138">
                  <c:v>43936.958333333336</c:v>
                </c:pt>
                <c:pt idx="139">
                  <c:v>43936.965277777781</c:v>
                </c:pt>
                <c:pt idx="140">
                  <c:v>43936.972222222219</c:v>
                </c:pt>
                <c:pt idx="141">
                  <c:v>43936.979166666664</c:v>
                </c:pt>
                <c:pt idx="142">
                  <c:v>43936.986111111109</c:v>
                </c:pt>
                <c:pt idx="143">
                  <c:v>43936.993055555555</c:v>
                </c:pt>
                <c:pt idx="144">
                  <c:v>43937</c:v>
                </c:pt>
                <c:pt idx="145">
                  <c:v>43937.006944444445</c:v>
                </c:pt>
                <c:pt idx="146">
                  <c:v>43937.013888888891</c:v>
                </c:pt>
                <c:pt idx="147">
                  <c:v>43937.020833333336</c:v>
                </c:pt>
                <c:pt idx="148">
                  <c:v>43937.027777777781</c:v>
                </c:pt>
                <c:pt idx="149">
                  <c:v>43937.034722222219</c:v>
                </c:pt>
                <c:pt idx="150">
                  <c:v>43937.041666666664</c:v>
                </c:pt>
                <c:pt idx="151">
                  <c:v>43937.048611111109</c:v>
                </c:pt>
                <c:pt idx="152">
                  <c:v>43937.055555555555</c:v>
                </c:pt>
                <c:pt idx="153">
                  <c:v>43937.0625</c:v>
                </c:pt>
                <c:pt idx="154">
                  <c:v>43937.069444444445</c:v>
                </c:pt>
                <c:pt idx="155">
                  <c:v>43937.076388888891</c:v>
                </c:pt>
                <c:pt idx="156">
                  <c:v>43937.083333333336</c:v>
                </c:pt>
                <c:pt idx="157">
                  <c:v>43937.090277777781</c:v>
                </c:pt>
                <c:pt idx="158">
                  <c:v>43937.097222222219</c:v>
                </c:pt>
                <c:pt idx="159">
                  <c:v>43937.104166666664</c:v>
                </c:pt>
                <c:pt idx="160">
                  <c:v>43937.111111111109</c:v>
                </c:pt>
                <c:pt idx="161">
                  <c:v>43937.118055555555</c:v>
                </c:pt>
                <c:pt idx="162">
                  <c:v>43937.125</c:v>
                </c:pt>
                <c:pt idx="163">
                  <c:v>43937.131944444445</c:v>
                </c:pt>
                <c:pt idx="164">
                  <c:v>43937.138888888891</c:v>
                </c:pt>
                <c:pt idx="165">
                  <c:v>43937.145833333336</c:v>
                </c:pt>
                <c:pt idx="166">
                  <c:v>43937.152777777781</c:v>
                </c:pt>
                <c:pt idx="167">
                  <c:v>43937.159722222219</c:v>
                </c:pt>
                <c:pt idx="168">
                  <c:v>43937.166666666664</c:v>
                </c:pt>
                <c:pt idx="169">
                  <c:v>43937.173611111109</c:v>
                </c:pt>
                <c:pt idx="170">
                  <c:v>43937.180555555555</c:v>
                </c:pt>
                <c:pt idx="171">
                  <c:v>43937.1875</c:v>
                </c:pt>
                <c:pt idx="172">
                  <c:v>43937.194444444445</c:v>
                </c:pt>
                <c:pt idx="173">
                  <c:v>43937.201388888891</c:v>
                </c:pt>
                <c:pt idx="174">
                  <c:v>43937.208333333336</c:v>
                </c:pt>
                <c:pt idx="175">
                  <c:v>43937.215277777781</c:v>
                </c:pt>
                <c:pt idx="176">
                  <c:v>43937.222222222219</c:v>
                </c:pt>
                <c:pt idx="177">
                  <c:v>43937.229166666664</c:v>
                </c:pt>
                <c:pt idx="178">
                  <c:v>43937.236111111109</c:v>
                </c:pt>
                <c:pt idx="179">
                  <c:v>43937.243055555555</c:v>
                </c:pt>
                <c:pt idx="180">
                  <c:v>43937.25</c:v>
                </c:pt>
                <c:pt idx="181">
                  <c:v>43937.256944444445</c:v>
                </c:pt>
                <c:pt idx="182">
                  <c:v>43937.263888888891</c:v>
                </c:pt>
                <c:pt idx="183">
                  <c:v>43937.270833333336</c:v>
                </c:pt>
                <c:pt idx="184">
                  <c:v>43937.277777777781</c:v>
                </c:pt>
                <c:pt idx="185">
                  <c:v>43937.284722222219</c:v>
                </c:pt>
                <c:pt idx="186">
                  <c:v>43937.291666666664</c:v>
                </c:pt>
                <c:pt idx="187">
                  <c:v>43937.298611111109</c:v>
                </c:pt>
                <c:pt idx="188">
                  <c:v>43937.305555555555</c:v>
                </c:pt>
                <c:pt idx="189">
                  <c:v>43937.3125</c:v>
                </c:pt>
                <c:pt idx="190">
                  <c:v>43937.319444444445</c:v>
                </c:pt>
                <c:pt idx="191">
                  <c:v>43937.326388888891</c:v>
                </c:pt>
                <c:pt idx="192">
                  <c:v>43937.333333333336</c:v>
                </c:pt>
                <c:pt idx="193">
                  <c:v>43937.340277777781</c:v>
                </c:pt>
                <c:pt idx="194">
                  <c:v>43937.347222222219</c:v>
                </c:pt>
                <c:pt idx="195">
                  <c:v>43937.354166666664</c:v>
                </c:pt>
                <c:pt idx="196">
                  <c:v>43937.361111111109</c:v>
                </c:pt>
                <c:pt idx="197">
                  <c:v>43937.368055555555</c:v>
                </c:pt>
                <c:pt idx="198">
                  <c:v>43937.375</c:v>
                </c:pt>
                <c:pt idx="199">
                  <c:v>43937.381944444445</c:v>
                </c:pt>
                <c:pt idx="200">
                  <c:v>43937.388888888891</c:v>
                </c:pt>
                <c:pt idx="201">
                  <c:v>43937.395833333336</c:v>
                </c:pt>
                <c:pt idx="202">
                  <c:v>43937.402777777781</c:v>
                </c:pt>
                <c:pt idx="203">
                  <c:v>43937.409722222219</c:v>
                </c:pt>
                <c:pt idx="204">
                  <c:v>43937.416666666664</c:v>
                </c:pt>
                <c:pt idx="205">
                  <c:v>43937.423611111109</c:v>
                </c:pt>
                <c:pt idx="206">
                  <c:v>43937.430555555555</c:v>
                </c:pt>
                <c:pt idx="207">
                  <c:v>43937.4375</c:v>
                </c:pt>
                <c:pt idx="208">
                  <c:v>43937.444444444445</c:v>
                </c:pt>
                <c:pt idx="209">
                  <c:v>43937.451388888891</c:v>
                </c:pt>
                <c:pt idx="210">
                  <c:v>43937.458333333336</c:v>
                </c:pt>
                <c:pt idx="211">
                  <c:v>43937.465277777781</c:v>
                </c:pt>
                <c:pt idx="212">
                  <c:v>43937.472222222219</c:v>
                </c:pt>
                <c:pt idx="213">
                  <c:v>43937.479166666664</c:v>
                </c:pt>
                <c:pt idx="214">
                  <c:v>43937.486111111109</c:v>
                </c:pt>
                <c:pt idx="215">
                  <c:v>43937.493055555555</c:v>
                </c:pt>
                <c:pt idx="216">
                  <c:v>43937.5</c:v>
                </c:pt>
                <c:pt idx="217">
                  <c:v>43937.506944444445</c:v>
                </c:pt>
                <c:pt idx="218">
                  <c:v>43937.513888888891</c:v>
                </c:pt>
                <c:pt idx="219">
                  <c:v>43937.520833333336</c:v>
                </c:pt>
                <c:pt idx="220">
                  <c:v>43937.527777777781</c:v>
                </c:pt>
                <c:pt idx="221">
                  <c:v>43937.534722222219</c:v>
                </c:pt>
                <c:pt idx="222">
                  <c:v>43937.541666666664</c:v>
                </c:pt>
                <c:pt idx="223">
                  <c:v>43937.548611111109</c:v>
                </c:pt>
                <c:pt idx="224">
                  <c:v>43937.555555555555</c:v>
                </c:pt>
                <c:pt idx="225">
                  <c:v>43937.5625</c:v>
                </c:pt>
                <c:pt idx="226">
                  <c:v>43937.569444444445</c:v>
                </c:pt>
                <c:pt idx="227">
                  <c:v>43937.576388888891</c:v>
                </c:pt>
                <c:pt idx="228">
                  <c:v>43937.583333333336</c:v>
                </c:pt>
                <c:pt idx="229">
                  <c:v>43937.590277777781</c:v>
                </c:pt>
                <c:pt idx="230">
                  <c:v>43937.597222222219</c:v>
                </c:pt>
                <c:pt idx="231">
                  <c:v>43937.604166666664</c:v>
                </c:pt>
                <c:pt idx="232">
                  <c:v>43937.611111111109</c:v>
                </c:pt>
                <c:pt idx="233">
                  <c:v>43937.618055555555</c:v>
                </c:pt>
                <c:pt idx="234">
                  <c:v>43937.625</c:v>
                </c:pt>
                <c:pt idx="235">
                  <c:v>43937.631944444445</c:v>
                </c:pt>
                <c:pt idx="236">
                  <c:v>43937.638888888891</c:v>
                </c:pt>
                <c:pt idx="237">
                  <c:v>43937.645833333336</c:v>
                </c:pt>
                <c:pt idx="238">
                  <c:v>43937.652777777781</c:v>
                </c:pt>
                <c:pt idx="239">
                  <c:v>43937.659722222219</c:v>
                </c:pt>
                <c:pt idx="240">
                  <c:v>43937.666666666664</c:v>
                </c:pt>
                <c:pt idx="241">
                  <c:v>43937.673611111109</c:v>
                </c:pt>
                <c:pt idx="242">
                  <c:v>43937.680555555555</c:v>
                </c:pt>
                <c:pt idx="243">
                  <c:v>43937.6875</c:v>
                </c:pt>
                <c:pt idx="244">
                  <c:v>43937.694444444445</c:v>
                </c:pt>
                <c:pt idx="245">
                  <c:v>43937.701388888891</c:v>
                </c:pt>
                <c:pt idx="246">
                  <c:v>43937.708333333336</c:v>
                </c:pt>
                <c:pt idx="247">
                  <c:v>43937.715277777781</c:v>
                </c:pt>
                <c:pt idx="248">
                  <c:v>43937.722222222219</c:v>
                </c:pt>
                <c:pt idx="249">
                  <c:v>43937.729166666664</c:v>
                </c:pt>
                <c:pt idx="250">
                  <c:v>43937.736111111109</c:v>
                </c:pt>
                <c:pt idx="251">
                  <c:v>43937.743055555555</c:v>
                </c:pt>
                <c:pt idx="252">
                  <c:v>43937.75</c:v>
                </c:pt>
                <c:pt idx="253">
                  <c:v>43937.756944444445</c:v>
                </c:pt>
                <c:pt idx="254">
                  <c:v>43937.763888888891</c:v>
                </c:pt>
                <c:pt idx="255">
                  <c:v>43937.770833333336</c:v>
                </c:pt>
                <c:pt idx="256">
                  <c:v>43937.777777777781</c:v>
                </c:pt>
                <c:pt idx="257">
                  <c:v>43937.784722222219</c:v>
                </c:pt>
                <c:pt idx="258">
                  <c:v>43937.791666666664</c:v>
                </c:pt>
                <c:pt idx="259">
                  <c:v>43937.798611111109</c:v>
                </c:pt>
                <c:pt idx="260">
                  <c:v>43937.805555555555</c:v>
                </c:pt>
                <c:pt idx="261">
                  <c:v>43937.8125</c:v>
                </c:pt>
                <c:pt idx="262">
                  <c:v>43937.819444444445</c:v>
                </c:pt>
                <c:pt idx="263">
                  <c:v>43937.826388888891</c:v>
                </c:pt>
                <c:pt idx="264">
                  <c:v>43937.833333333336</c:v>
                </c:pt>
                <c:pt idx="265">
                  <c:v>43937.840277777781</c:v>
                </c:pt>
                <c:pt idx="266">
                  <c:v>43937.847222222219</c:v>
                </c:pt>
                <c:pt idx="267">
                  <c:v>43937.854166666664</c:v>
                </c:pt>
                <c:pt idx="268">
                  <c:v>43937.861111111109</c:v>
                </c:pt>
                <c:pt idx="269">
                  <c:v>43937.868055555555</c:v>
                </c:pt>
                <c:pt idx="270">
                  <c:v>43937.875</c:v>
                </c:pt>
                <c:pt idx="271">
                  <c:v>43937.881944444445</c:v>
                </c:pt>
                <c:pt idx="272">
                  <c:v>43937.888888888891</c:v>
                </c:pt>
                <c:pt idx="273">
                  <c:v>43937.895833333336</c:v>
                </c:pt>
                <c:pt idx="274">
                  <c:v>43937.902777777781</c:v>
                </c:pt>
                <c:pt idx="275">
                  <c:v>43937.909722222219</c:v>
                </c:pt>
                <c:pt idx="276">
                  <c:v>43937.916666666664</c:v>
                </c:pt>
                <c:pt idx="277">
                  <c:v>43937.923611111109</c:v>
                </c:pt>
                <c:pt idx="278">
                  <c:v>43937.930555555555</c:v>
                </c:pt>
                <c:pt idx="279">
                  <c:v>43937.9375</c:v>
                </c:pt>
                <c:pt idx="280">
                  <c:v>43937.944444444445</c:v>
                </c:pt>
                <c:pt idx="281">
                  <c:v>43937.951388888891</c:v>
                </c:pt>
                <c:pt idx="282">
                  <c:v>43937.958333333336</c:v>
                </c:pt>
                <c:pt idx="283">
                  <c:v>43937.965277777781</c:v>
                </c:pt>
                <c:pt idx="284">
                  <c:v>43937.972222222219</c:v>
                </c:pt>
                <c:pt idx="285">
                  <c:v>43937.979166666664</c:v>
                </c:pt>
                <c:pt idx="286">
                  <c:v>43937.986111111109</c:v>
                </c:pt>
                <c:pt idx="287">
                  <c:v>43937.993055555555</c:v>
                </c:pt>
                <c:pt idx="288">
                  <c:v>43938</c:v>
                </c:pt>
                <c:pt idx="289">
                  <c:v>43938.006944444445</c:v>
                </c:pt>
                <c:pt idx="290">
                  <c:v>43938.013888888891</c:v>
                </c:pt>
                <c:pt idx="291">
                  <c:v>43938.020833333336</c:v>
                </c:pt>
                <c:pt idx="292">
                  <c:v>43938.027777777781</c:v>
                </c:pt>
                <c:pt idx="293">
                  <c:v>43938.034722222219</c:v>
                </c:pt>
                <c:pt idx="294">
                  <c:v>43938.041666666664</c:v>
                </c:pt>
                <c:pt idx="295">
                  <c:v>43938.048611111109</c:v>
                </c:pt>
                <c:pt idx="296">
                  <c:v>43938.055555555555</c:v>
                </c:pt>
                <c:pt idx="297">
                  <c:v>43938.0625</c:v>
                </c:pt>
                <c:pt idx="298">
                  <c:v>43938.069444444445</c:v>
                </c:pt>
                <c:pt idx="299">
                  <c:v>43938.076388888891</c:v>
                </c:pt>
                <c:pt idx="300">
                  <c:v>43938.083333333336</c:v>
                </c:pt>
                <c:pt idx="301">
                  <c:v>43938.090277777781</c:v>
                </c:pt>
                <c:pt idx="302">
                  <c:v>43938.097222222219</c:v>
                </c:pt>
                <c:pt idx="303">
                  <c:v>43938.104166666664</c:v>
                </c:pt>
                <c:pt idx="304">
                  <c:v>43938.111111111109</c:v>
                </c:pt>
                <c:pt idx="305">
                  <c:v>43938.118055555555</c:v>
                </c:pt>
                <c:pt idx="306">
                  <c:v>43938.125</c:v>
                </c:pt>
                <c:pt idx="307">
                  <c:v>43938.131944444445</c:v>
                </c:pt>
                <c:pt idx="308">
                  <c:v>43938.138888888891</c:v>
                </c:pt>
                <c:pt idx="309">
                  <c:v>43938.145833333336</c:v>
                </c:pt>
                <c:pt idx="310">
                  <c:v>43938.152777777781</c:v>
                </c:pt>
                <c:pt idx="311">
                  <c:v>43938.159722222219</c:v>
                </c:pt>
                <c:pt idx="312">
                  <c:v>43938.166666666664</c:v>
                </c:pt>
                <c:pt idx="313">
                  <c:v>43938.173611111109</c:v>
                </c:pt>
                <c:pt idx="314">
                  <c:v>43938.180555555555</c:v>
                </c:pt>
                <c:pt idx="315">
                  <c:v>43938.1875</c:v>
                </c:pt>
                <c:pt idx="316">
                  <c:v>43938.194444444445</c:v>
                </c:pt>
                <c:pt idx="317">
                  <c:v>43938.201388888891</c:v>
                </c:pt>
                <c:pt idx="318">
                  <c:v>43938.208333333336</c:v>
                </c:pt>
                <c:pt idx="319">
                  <c:v>43938.215277777781</c:v>
                </c:pt>
                <c:pt idx="320">
                  <c:v>43938.222222222219</c:v>
                </c:pt>
                <c:pt idx="321">
                  <c:v>43938.229166666664</c:v>
                </c:pt>
                <c:pt idx="322">
                  <c:v>43938.236111111109</c:v>
                </c:pt>
                <c:pt idx="323">
                  <c:v>43938.243055555555</c:v>
                </c:pt>
                <c:pt idx="324">
                  <c:v>43938.25</c:v>
                </c:pt>
                <c:pt idx="325">
                  <c:v>43938.256944444445</c:v>
                </c:pt>
                <c:pt idx="326">
                  <c:v>43938.263888888891</c:v>
                </c:pt>
                <c:pt idx="327">
                  <c:v>43938.270833333336</c:v>
                </c:pt>
                <c:pt idx="328">
                  <c:v>43938.277777777781</c:v>
                </c:pt>
                <c:pt idx="329">
                  <c:v>43938.284722222219</c:v>
                </c:pt>
                <c:pt idx="330">
                  <c:v>43938.291666666664</c:v>
                </c:pt>
                <c:pt idx="331">
                  <c:v>43938.298611111109</c:v>
                </c:pt>
                <c:pt idx="332">
                  <c:v>43938.305555555555</c:v>
                </c:pt>
                <c:pt idx="333">
                  <c:v>43938.3125</c:v>
                </c:pt>
                <c:pt idx="334">
                  <c:v>43938.319444444445</c:v>
                </c:pt>
                <c:pt idx="335">
                  <c:v>43938.326388888891</c:v>
                </c:pt>
                <c:pt idx="336">
                  <c:v>43938.333333333336</c:v>
                </c:pt>
                <c:pt idx="337">
                  <c:v>43938.340277777781</c:v>
                </c:pt>
                <c:pt idx="338">
                  <c:v>43938.347222222219</c:v>
                </c:pt>
                <c:pt idx="339">
                  <c:v>43938.354166666664</c:v>
                </c:pt>
                <c:pt idx="340">
                  <c:v>43938.361111111109</c:v>
                </c:pt>
                <c:pt idx="341">
                  <c:v>43938.368055555555</c:v>
                </c:pt>
                <c:pt idx="342">
                  <c:v>43938.375</c:v>
                </c:pt>
                <c:pt idx="343">
                  <c:v>43938.381944444445</c:v>
                </c:pt>
                <c:pt idx="344">
                  <c:v>43938.388888888891</c:v>
                </c:pt>
                <c:pt idx="345">
                  <c:v>43938.395833333336</c:v>
                </c:pt>
                <c:pt idx="346">
                  <c:v>43938.402777777781</c:v>
                </c:pt>
                <c:pt idx="347">
                  <c:v>43938.409722222219</c:v>
                </c:pt>
                <c:pt idx="348">
                  <c:v>43938.416666666664</c:v>
                </c:pt>
                <c:pt idx="349">
                  <c:v>43938.423611111109</c:v>
                </c:pt>
                <c:pt idx="350">
                  <c:v>43938.430555555555</c:v>
                </c:pt>
                <c:pt idx="351">
                  <c:v>43938.4375</c:v>
                </c:pt>
                <c:pt idx="352">
                  <c:v>43938.444444444445</c:v>
                </c:pt>
                <c:pt idx="353">
                  <c:v>43938.451388888891</c:v>
                </c:pt>
                <c:pt idx="354">
                  <c:v>43938.458333333336</c:v>
                </c:pt>
                <c:pt idx="355">
                  <c:v>43938.465277777781</c:v>
                </c:pt>
                <c:pt idx="356">
                  <c:v>43938.472222222219</c:v>
                </c:pt>
                <c:pt idx="357">
                  <c:v>43938.479166666664</c:v>
                </c:pt>
                <c:pt idx="358">
                  <c:v>43938.486111111109</c:v>
                </c:pt>
                <c:pt idx="359">
                  <c:v>43938.493055555555</c:v>
                </c:pt>
                <c:pt idx="360">
                  <c:v>43938.5</c:v>
                </c:pt>
                <c:pt idx="361">
                  <c:v>43938.506944444445</c:v>
                </c:pt>
                <c:pt idx="362">
                  <c:v>43938.513888888891</c:v>
                </c:pt>
                <c:pt idx="363">
                  <c:v>43938.520833333336</c:v>
                </c:pt>
                <c:pt idx="364">
                  <c:v>43938.527777777781</c:v>
                </c:pt>
                <c:pt idx="365">
                  <c:v>43938.534722222219</c:v>
                </c:pt>
                <c:pt idx="366">
                  <c:v>43938.541666666664</c:v>
                </c:pt>
                <c:pt idx="367">
                  <c:v>43938.548611111109</c:v>
                </c:pt>
                <c:pt idx="368">
                  <c:v>43938.555555555555</c:v>
                </c:pt>
                <c:pt idx="369">
                  <c:v>43938.5625</c:v>
                </c:pt>
                <c:pt idx="370">
                  <c:v>43938.569444444445</c:v>
                </c:pt>
                <c:pt idx="371">
                  <c:v>43938.576388888891</c:v>
                </c:pt>
                <c:pt idx="372">
                  <c:v>43938.583333333336</c:v>
                </c:pt>
                <c:pt idx="373">
                  <c:v>43938.590277777781</c:v>
                </c:pt>
                <c:pt idx="374">
                  <c:v>43938.597222222219</c:v>
                </c:pt>
                <c:pt idx="375">
                  <c:v>43938.604166666664</c:v>
                </c:pt>
                <c:pt idx="376">
                  <c:v>43938.611111111109</c:v>
                </c:pt>
                <c:pt idx="377">
                  <c:v>43938.618055555555</c:v>
                </c:pt>
                <c:pt idx="378">
                  <c:v>43938.625</c:v>
                </c:pt>
                <c:pt idx="379">
                  <c:v>43938.631944444445</c:v>
                </c:pt>
                <c:pt idx="380">
                  <c:v>43938.638888888891</c:v>
                </c:pt>
                <c:pt idx="381">
                  <c:v>43938.645833333336</c:v>
                </c:pt>
                <c:pt idx="382">
                  <c:v>43938.652777777781</c:v>
                </c:pt>
                <c:pt idx="383">
                  <c:v>43938.659722222219</c:v>
                </c:pt>
                <c:pt idx="384">
                  <c:v>43938.666666666664</c:v>
                </c:pt>
                <c:pt idx="385">
                  <c:v>43938.673611111109</c:v>
                </c:pt>
                <c:pt idx="386">
                  <c:v>43938.680555555555</c:v>
                </c:pt>
                <c:pt idx="387">
                  <c:v>43938.6875</c:v>
                </c:pt>
                <c:pt idx="388">
                  <c:v>43938.694444444445</c:v>
                </c:pt>
                <c:pt idx="389">
                  <c:v>43938.701388888891</c:v>
                </c:pt>
                <c:pt idx="390">
                  <c:v>43938.708333333336</c:v>
                </c:pt>
                <c:pt idx="391">
                  <c:v>43938.715277777781</c:v>
                </c:pt>
                <c:pt idx="392">
                  <c:v>43938.722222222219</c:v>
                </c:pt>
                <c:pt idx="393">
                  <c:v>43938.729166666664</c:v>
                </c:pt>
                <c:pt idx="394">
                  <c:v>43938.736111111109</c:v>
                </c:pt>
                <c:pt idx="395">
                  <c:v>43938.743055555555</c:v>
                </c:pt>
                <c:pt idx="396">
                  <c:v>43938.75</c:v>
                </c:pt>
                <c:pt idx="397">
                  <c:v>43938.756944444445</c:v>
                </c:pt>
                <c:pt idx="398">
                  <c:v>43938.763888888891</c:v>
                </c:pt>
                <c:pt idx="399">
                  <c:v>43938.770833333336</c:v>
                </c:pt>
                <c:pt idx="400">
                  <c:v>43938.777777777781</c:v>
                </c:pt>
                <c:pt idx="401">
                  <c:v>43938.784722222219</c:v>
                </c:pt>
                <c:pt idx="402">
                  <c:v>43938.791666666664</c:v>
                </c:pt>
                <c:pt idx="403">
                  <c:v>43938.798611111109</c:v>
                </c:pt>
                <c:pt idx="404">
                  <c:v>43938.805555555555</c:v>
                </c:pt>
                <c:pt idx="405">
                  <c:v>43938.8125</c:v>
                </c:pt>
                <c:pt idx="406">
                  <c:v>43938.819444444445</c:v>
                </c:pt>
                <c:pt idx="407">
                  <c:v>43938.826388888891</c:v>
                </c:pt>
                <c:pt idx="408">
                  <c:v>43938.833333333336</c:v>
                </c:pt>
                <c:pt idx="409">
                  <c:v>43938.840277777781</c:v>
                </c:pt>
                <c:pt idx="410">
                  <c:v>43938.847222222219</c:v>
                </c:pt>
                <c:pt idx="411">
                  <c:v>43938.854166666664</c:v>
                </c:pt>
                <c:pt idx="412">
                  <c:v>43938.861111111109</c:v>
                </c:pt>
                <c:pt idx="413">
                  <c:v>43938.868055555555</c:v>
                </c:pt>
                <c:pt idx="414">
                  <c:v>43938.875</c:v>
                </c:pt>
                <c:pt idx="415">
                  <c:v>43938.881944444445</c:v>
                </c:pt>
                <c:pt idx="416">
                  <c:v>43938.888888888891</c:v>
                </c:pt>
                <c:pt idx="417">
                  <c:v>43938.895833333336</c:v>
                </c:pt>
                <c:pt idx="418">
                  <c:v>43938.902777777781</c:v>
                </c:pt>
                <c:pt idx="419">
                  <c:v>43938.909722222219</c:v>
                </c:pt>
                <c:pt idx="420">
                  <c:v>43938.916666666664</c:v>
                </c:pt>
                <c:pt idx="421">
                  <c:v>43938.923611111109</c:v>
                </c:pt>
                <c:pt idx="422">
                  <c:v>43938.930555555555</c:v>
                </c:pt>
                <c:pt idx="423">
                  <c:v>43938.9375</c:v>
                </c:pt>
                <c:pt idx="424">
                  <c:v>43938.944444444445</c:v>
                </c:pt>
                <c:pt idx="425">
                  <c:v>43938.951388888891</c:v>
                </c:pt>
                <c:pt idx="426">
                  <c:v>43938.958333333336</c:v>
                </c:pt>
                <c:pt idx="427">
                  <c:v>43938.965277777781</c:v>
                </c:pt>
                <c:pt idx="428">
                  <c:v>43938.972222222219</c:v>
                </c:pt>
                <c:pt idx="429">
                  <c:v>43938.979166666664</c:v>
                </c:pt>
                <c:pt idx="430">
                  <c:v>43938.986111111109</c:v>
                </c:pt>
                <c:pt idx="431">
                  <c:v>43938.993055555555</c:v>
                </c:pt>
                <c:pt idx="432">
                  <c:v>43939</c:v>
                </c:pt>
                <c:pt idx="433">
                  <c:v>43939.006944444445</c:v>
                </c:pt>
                <c:pt idx="434">
                  <c:v>43939.013888888891</c:v>
                </c:pt>
                <c:pt idx="435">
                  <c:v>43939.020833333336</c:v>
                </c:pt>
                <c:pt idx="436">
                  <c:v>43939.027777777781</c:v>
                </c:pt>
                <c:pt idx="437">
                  <c:v>43939.034722222219</c:v>
                </c:pt>
                <c:pt idx="438">
                  <c:v>43939.041666666664</c:v>
                </c:pt>
                <c:pt idx="439">
                  <c:v>43939.048611111109</c:v>
                </c:pt>
                <c:pt idx="440">
                  <c:v>43939.055555555555</c:v>
                </c:pt>
                <c:pt idx="441">
                  <c:v>43939.0625</c:v>
                </c:pt>
                <c:pt idx="442">
                  <c:v>43939.069444444445</c:v>
                </c:pt>
                <c:pt idx="443">
                  <c:v>43939.076388888891</c:v>
                </c:pt>
                <c:pt idx="444">
                  <c:v>43939.083333333336</c:v>
                </c:pt>
                <c:pt idx="445">
                  <c:v>43939.090277777781</c:v>
                </c:pt>
                <c:pt idx="446">
                  <c:v>43939.097222222219</c:v>
                </c:pt>
                <c:pt idx="447">
                  <c:v>43939.104166666664</c:v>
                </c:pt>
                <c:pt idx="448">
                  <c:v>43939.111111111109</c:v>
                </c:pt>
                <c:pt idx="449">
                  <c:v>43939.118055555555</c:v>
                </c:pt>
                <c:pt idx="450">
                  <c:v>43939.125</c:v>
                </c:pt>
                <c:pt idx="451">
                  <c:v>43939.131944444445</c:v>
                </c:pt>
                <c:pt idx="452">
                  <c:v>43939.138888888891</c:v>
                </c:pt>
                <c:pt idx="453">
                  <c:v>43939.145833333336</c:v>
                </c:pt>
                <c:pt idx="454">
                  <c:v>43939.152777777781</c:v>
                </c:pt>
                <c:pt idx="455">
                  <c:v>43939.159722222219</c:v>
                </c:pt>
                <c:pt idx="456">
                  <c:v>43939.166666666664</c:v>
                </c:pt>
                <c:pt idx="457">
                  <c:v>43939.173611111109</c:v>
                </c:pt>
                <c:pt idx="458">
                  <c:v>43939.180555555555</c:v>
                </c:pt>
                <c:pt idx="459">
                  <c:v>43939.1875</c:v>
                </c:pt>
                <c:pt idx="460">
                  <c:v>43939.194444444445</c:v>
                </c:pt>
                <c:pt idx="461">
                  <c:v>43939.201388888891</c:v>
                </c:pt>
                <c:pt idx="462">
                  <c:v>43939.208333333336</c:v>
                </c:pt>
                <c:pt idx="463">
                  <c:v>43939.215277777781</c:v>
                </c:pt>
                <c:pt idx="464">
                  <c:v>43939.222222222219</c:v>
                </c:pt>
                <c:pt idx="465">
                  <c:v>43939.229166666664</c:v>
                </c:pt>
                <c:pt idx="466">
                  <c:v>43939.236111111109</c:v>
                </c:pt>
                <c:pt idx="467">
                  <c:v>43939.243055555555</c:v>
                </c:pt>
                <c:pt idx="468">
                  <c:v>43939.25</c:v>
                </c:pt>
                <c:pt idx="469">
                  <c:v>43939.256944444445</c:v>
                </c:pt>
                <c:pt idx="470">
                  <c:v>43939.263888888891</c:v>
                </c:pt>
                <c:pt idx="471">
                  <c:v>43939.270833333336</c:v>
                </c:pt>
                <c:pt idx="472">
                  <c:v>43939.277777777781</c:v>
                </c:pt>
                <c:pt idx="473">
                  <c:v>43939.284722222219</c:v>
                </c:pt>
                <c:pt idx="474">
                  <c:v>43939.291666666664</c:v>
                </c:pt>
                <c:pt idx="475">
                  <c:v>43939.298611111109</c:v>
                </c:pt>
                <c:pt idx="476">
                  <c:v>43939.305555555555</c:v>
                </c:pt>
                <c:pt idx="477">
                  <c:v>43939.3125</c:v>
                </c:pt>
                <c:pt idx="478">
                  <c:v>43939.319444444445</c:v>
                </c:pt>
                <c:pt idx="479">
                  <c:v>43939.326388888891</c:v>
                </c:pt>
                <c:pt idx="480">
                  <c:v>43939.333333333336</c:v>
                </c:pt>
                <c:pt idx="481">
                  <c:v>43939.340277777781</c:v>
                </c:pt>
                <c:pt idx="482">
                  <c:v>43939.347222222219</c:v>
                </c:pt>
                <c:pt idx="483">
                  <c:v>43939.354166666664</c:v>
                </c:pt>
                <c:pt idx="484">
                  <c:v>43939.361111111109</c:v>
                </c:pt>
                <c:pt idx="485">
                  <c:v>43939.368055555555</c:v>
                </c:pt>
                <c:pt idx="486">
                  <c:v>43939.375</c:v>
                </c:pt>
                <c:pt idx="487">
                  <c:v>43939.381944444445</c:v>
                </c:pt>
                <c:pt idx="488">
                  <c:v>43939.388888888891</c:v>
                </c:pt>
                <c:pt idx="489">
                  <c:v>43939.395833333336</c:v>
                </c:pt>
                <c:pt idx="490">
                  <c:v>43939.402777777781</c:v>
                </c:pt>
                <c:pt idx="491">
                  <c:v>43939.409722222219</c:v>
                </c:pt>
                <c:pt idx="492">
                  <c:v>43939.416666666664</c:v>
                </c:pt>
                <c:pt idx="493">
                  <c:v>43939.423611111109</c:v>
                </c:pt>
                <c:pt idx="494">
                  <c:v>43939.430555555555</c:v>
                </c:pt>
                <c:pt idx="495">
                  <c:v>43939.4375</c:v>
                </c:pt>
                <c:pt idx="496">
                  <c:v>43939.444444444445</c:v>
                </c:pt>
                <c:pt idx="497">
                  <c:v>43939.451388888891</c:v>
                </c:pt>
                <c:pt idx="498">
                  <c:v>43939.458333333336</c:v>
                </c:pt>
                <c:pt idx="499">
                  <c:v>43939.465277777781</c:v>
                </c:pt>
                <c:pt idx="500">
                  <c:v>43939.472222222219</c:v>
                </c:pt>
                <c:pt idx="501">
                  <c:v>43939.479166666664</c:v>
                </c:pt>
                <c:pt idx="502">
                  <c:v>43939.486111111109</c:v>
                </c:pt>
                <c:pt idx="503">
                  <c:v>43939.493055555555</c:v>
                </c:pt>
                <c:pt idx="504">
                  <c:v>43939.5</c:v>
                </c:pt>
                <c:pt idx="505">
                  <c:v>43939.506944444445</c:v>
                </c:pt>
                <c:pt idx="506">
                  <c:v>43939.513888888891</c:v>
                </c:pt>
                <c:pt idx="507">
                  <c:v>43939.520833333336</c:v>
                </c:pt>
                <c:pt idx="508">
                  <c:v>43939.527777777781</c:v>
                </c:pt>
                <c:pt idx="509">
                  <c:v>43939.534722222219</c:v>
                </c:pt>
                <c:pt idx="510">
                  <c:v>43939.541666666664</c:v>
                </c:pt>
                <c:pt idx="511">
                  <c:v>43939.548611111109</c:v>
                </c:pt>
                <c:pt idx="512">
                  <c:v>43939.555555555555</c:v>
                </c:pt>
                <c:pt idx="513">
                  <c:v>43939.5625</c:v>
                </c:pt>
                <c:pt idx="514">
                  <c:v>43939.569444444445</c:v>
                </c:pt>
                <c:pt idx="515">
                  <c:v>43939.576388888891</c:v>
                </c:pt>
                <c:pt idx="516">
                  <c:v>43939.583333333336</c:v>
                </c:pt>
                <c:pt idx="517">
                  <c:v>43939.590277777781</c:v>
                </c:pt>
                <c:pt idx="518">
                  <c:v>43939.597222222219</c:v>
                </c:pt>
                <c:pt idx="519">
                  <c:v>43939.604166666664</c:v>
                </c:pt>
                <c:pt idx="520">
                  <c:v>43939.611111111109</c:v>
                </c:pt>
                <c:pt idx="521">
                  <c:v>43939.618055555555</c:v>
                </c:pt>
                <c:pt idx="522">
                  <c:v>43939.625</c:v>
                </c:pt>
                <c:pt idx="523">
                  <c:v>43939.631944444445</c:v>
                </c:pt>
                <c:pt idx="524">
                  <c:v>43939.638888888891</c:v>
                </c:pt>
                <c:pt idx="525">
                  <c:v>43939.645833333336</c:v>
                </c:pt>
                <c:pt idx="526">
                  <c:v>43939.652777777781</c:v>
                </c:pt>
                <c:pt idx="527">
                  <c:v>43939.659722222219</c:v>
                </c:pt>
                <c:pt idx="528">
                  <c:v>43939.666666666664</c:v>
                </c:pt>
                <c:pt idx="529">
                  <c:v>43939.673611111109</c:v>
                </c:pt>
                <c:pt idx="530">
                  <c:v>43939.680555555555</c:v>
                </c:pt>
                <c:pt idx="531">
                  <c:v>43939.6875</c:v>
                </c:pt>
                <c:pt idx="532">
                  <c:v>43939.694444444445</c:v>
                </c:pt>
                <c:pt idx="533">
                  <c:v>43939.701388888891</c:v>
                </c:pt>
                <c:pt idx="534">
                  <c:v>43939.708333333336</c:v>
                </c:pt>
                <c:pt idx="535">
                  <c:v>43939.715277777781</c:v>
                </c:pt>
                <c:pt idx="536">
                  <c:v>43939.722222222219</c:v>
                </c:pt>
                <c:pt idx="537">
                  <c:v>43939.729166666664</c:v>
                </c:pt>
                <c:pt idx="538">
                  <c:v>43939.736111111109</c:v>
                </c:pt>
                <c:pt idx="539">
                  <c:v>43939.743055555555</c:v>
                </c:pt>
                <c:pt idx="540">
                  <c:v>43939.75</c:v>
                </c:pt>
                <c:pt idx="541">
                  <c:v>43939.756944444445</c:v>
                </c:pt>
                <c:pt idx="542">
                  <c:v>43939.763888888891</c:v>
                </c:pt>
                <c:pt idx="543">
                  <c:v>43939.770833333336</c:v>
                </c:pt>
                <c:pt idx="544">
                  <c:v>43939.777777777781</c:v>
                </c:pt>
                <c:pt idx="545">
                  <c:v>43939.784722222219</c:v>
                </c:pt>
                <c:pt idx="546">
                  <c:v>43939.791666666664</c:v>
                </c:pt>
                <c:pt idx="547">
                  <c:v>43939.798611111109</c:v>
                </c:pt>
                <c:pt idx="548">
                  <c:v>43939.805555555555</c:v>
                </c:pt>
                <c:pt idx="549">
                  <c:v>43939.8125</c:v>
                </c:pt>
                <c:pt idx="550">
                  <c:v>43939.819444444445</c:v>
                </c:pt>
                <c:pt idx="551">
                  <c:v>43939.826388888891</c:v>
                </c:pt>
                <c:pt idx="552">
                  <c:v>43939.833333333336</c:v>
                </c:pt>
                <c:pt idx="553">
                  <c:v>43939.840277777781</c:v>
                </c:pt>
                <c:pt idx="554">
                  <c:v>43939.847222222219</c:v>
                </c:pt>
                <c:pt idx="555">
                  <c:v>43939.854166666664</c:v>
                </c:pt>
                <c:pt idx="556">
                  <c:v>43939.861111111109</c:v>
                </c:pt>
                <c:pt idx="557">
                  <c:v>43939.868055555555</c:v>
                </c:pt>
                <c:pt idx="558">
                  <c:v>43939.875</c:v>
                </c:pt>
                <c:pt idx="559">
                  <c:v>43939.881944444445</c:v>
                </c:pt>
                <c:pt idx="560">
                  <c:v>43939.888888888891</c:v>
                </c:pt>
                <c:pt idx="561">
                  <c:v>43939.895833333336</c:v>
                </c:pt>
                <c:pt idx="562">
                  <c:v>43939.902777777781</c:v>
                </c:pt>
                <c:pt idx="563">
                  <c:v>43939.909722222219</c:v>
                </c:pt>
                <c:pt idx="564">
                  <c:v>43939.916666666664</c:v>
                </c:pt>
                <c:pt idx="565">
                  <c:v>43939.923611111109</c:v>
                </c:pt>
                <c:pt idx="566">
                  <c:v>43939.930555555555</c:v>
                </c:pt>
                <c:pt idx="567">
                  <c:v>43939.9375</c:v>
                </c:pt>
                <c:pt idx="568">
                  <c:v>43939.944444444445</c:v>
                </c:pt>
                <c:pt idx="569">
                  <c:v>43939.951388888891</c:v>
                </c:pt>
                <c:pt idx="570">
                  <c:v>43939.958333333336</c:v>
                </c:pt>
                <c:pt idx="571">
                  <c:v>43939.965277777781</c:v>
                </c:pt>
                <c:pt idx="572">
                  <c:v>43939.972222222219</c:v>
                </c:pt>
                <c:pt idx="573">
                  <c:v>43939.979166666664</c:v>
                </c:pt>
                <c:pt idx="574">
                  <c:v>43939.986111111109</c:v>
                </c:pt>
                <c:pt idx="575">
                  <c:v>43939.993055555555</c:v>
                </c:pt>
                <c:pt idx="576">
                  <c:v>43940</c:v>
                </c:pt>
                <c:pt idx="577">
                  <c:v>43940.006944444445</c:v>
                </c:pt>
                <c:pt idx="578">
                  <c:v>43940.013888888891</c:v>
                </c:pt>
                <c:pt idx="579">
                  <c:v>43940.020833333336</c:v>
                </c:pt>
                <c:pt idx="580">
                  <c:v>43940.027777777781</c:v>
                </c:pt>
                <c:pt idx="581">
                  <c:v>43940.034722222219</c:v>
                </c:pt>
                <c:pt idx="582">
                  <c:v>43940.041666666664</c:v>
                </c:pt>
                <c:pt idx="583">
                  <c:v>43940.048611111109</c:v>
                </c:pt>
                <c:pt idx="584">
                  <c:v>43940.055555555555</c:v>
                </c:pt>
                <c:pt idx="585">
                  <c:v>43940.0625</c:v>
                </c:pt>
                <c:pt idx="586">
                  <c:v>43940.069444444445</c:v>
                </c:pt>
                <c:pt idx="587">
                  <c:v>43940.076388888891</c:v>
                </c:pt>
                <c:pt idx="588">
                  <c:v>43940.083333333336</c:v>
                </c:pt>
                <c:pt idx="589">
                  <c:v>43940.090277777781</c:v>
                </c:pt>
                <c:pt idx="590">
                  <c:v>43940.097222222219</c:v>
                </c:pt>
                <c:pt idx="591">
                  <c:v>43940.104166666664</c:v>
                </c:pt>
                <c:pt idx="592">
                  <c:v>43940.111111111109</c:v>
                </c:pt>
                <c:pt idx="593">
                  <c:v>43940.118055555555</c:v>
                </c:pt>
                <c:pt idx="594">
                  <c:v>43940.125</c:v>
                </c:pt>
                <c:pt idx="595">
                  <c:v>43940.131944444445</c:v>
                </c:pt>
                <c:pt idx="596">
                  <c:v>43940.138888888891</c:v>
                </c:pt>
                <c:pt idx="597">
                  <c:v>43940.145833333336</c:v>
                </c:pt>
                <c:pt idx="598">
                  <c:v>43940.152777777781</c:v>
                </c:pt>
                <c:pt idx="599">
                  <c:v>43940.159722222219</c:v>
                </c:pt>
                <c:pt idx="600">
                  <c:v>43940.166666666664</c:v>
                </c:pt>
                <c:pt idx="601">
                  <c:v>43940.173611111109</c:v>
                </c:pt>
                <c:pt idx="602">
                  <c:v>43940.180555555555</c:v>
                </c:pt>
                <c:pt idx="603">
                  <c:v>43940.1875</c:v>
                </c:pt>
                <c:pt idx="604">
                  <c:v>43940.194444444445</c:v>
                </c:pt>
                <c:pt idx="605">
                  <c:v>43940.201388888891</c:v>
                </c:pt>
                <c:pt idx="606">
                  <c:v>43940.208333333336</c:v>
                </c:pt>
                <c:pt idx="607">
                  <c:v>43940.215277777781</c:v>
                </c:pt>
                <c:pt idx="608">
                  <c:v>43940.222222222219</c:v>
                </c:pt>
                <c:pt idx="609">
                  <c:v>43940.229166666664</c:v>
                </c:pt>
                <c:pt idx="610">
                  <c:v>43940.236111111109</c:v>
                </c:pt>
                <c:pt idx="611">
                  <c:v>43940.243055555555</c:v>
                </c:pt>
                <c:pt idx="612">
                  <c:v>43940.25</c:v>
                </c:pt>
                <c:pt idx="613">
                  <c:v>43940.256944444445</c:v>
                </c:pt>
                <c:pt idx="614">
                  <c:v>43940.263888888891</c:v>
                </c:pt>
                <c:pt idx="615">
                  <c:v>43940.270833333336</c:v>
                </c:pt>
                <c:pt idx="616">
                  <c:v>43940.277777777781</c:v>
                </c:pt>
                <c:pt idx="617">
                  <c:v>43940.284722222219</c:v>
                </c:pt>
                <c:pt idx="618">
                  <c:v>43940.291666666664</c:v>
                </c:pt>
                <c:pt idx="619">
                  <c:v>43940.298611111109</c:v>
                </c:pt>
                <c:pt idx="620">
                  <c:v>43940.305555555555</c:v>
                </c:pt>
                <c:pt idx="621">
                  <c:v>43940.3125</c:v>
                </c:pt>
                <c:pt idx="622">
                  <c:v>43940.319444444445</c:v>
                </c:pt>
                <c:pt idx="623">
                  <c:v>43940.326388888891</c:v>
                </c:pt>
                <c:pt idx="624">
                  <c:v>43940.333333333336</c:v>
                </c:pt>
                <c:pt idx="625">
                  <c:v>43940.340277777781</c:v>
                </c:pt>
                <c:pt idx="626">
                  <c:v>43940.347222222219</c:v>
                </c:pt>
                <c:pt idx="627">
                  <c:v>43940.354166666664</c:v>
                </c:pt>
                <c:pt idx="628">
                  <c:v>43940.361111111109</c:v>
                </c:pt>
                <c:pt idx="629">
                  <c:v>43940.368055555555</c:v>
                </c:pt>
                <c:pt idx="630">
                  <c:v>43940.375</c:v>
                </c:pt>
                <c:pt idx="631">
                  <c:v>43940.381944444445</c:v>
                </c:pt>
                <c:pt idx="632">
                  <c:v>43940.388888888891</c:v>
                </c:pt>
                <c:pt idx="633">
                  <c:v>43940.395833333336</c:v>
                </c:pt>
                <c:pt idx="634">
                  <c:v>43940.402777777781</c:v>
                </c:pt>
                <c:pt idx="635">
                  <c:v>43940.409722222219</c:v>
                </c:pt>
                <c:pt idx="636">
                  <c:v>43940.416666666664</c:v>
                </c:pt>
                <c:pt idx="637">
                  <c:v>43940.423611111109</c:v>
                </c:pt>
                <c:pt idx="638">
                  <c:v>43940.430555555555</c:v>
                </c:pt>
                <c:pt idx="639">
                  <c:v>43940.4375</c:v>
                </c:pt>
                <c:pt idx="640">
                  <c:v>43940.444444444445</c:v>
                </c:pt>
                <c:pt idx="641">
                  <c:v>43940.451388888891</c:v>
                </c:pt>
                <c:pt idx="642">
                  <c:v>43940.458333333336</c:v>
                </c:pt>
                <c:pt idx="643">
                  <c:v>43940.465277777781</c:v>
                </c:pt>
                <c:pt idx="644">
                  <c:v>43940.472222222219</c:v>
                </c:pt>
                <c:pt idx="645">
                  <c:v>43940.479166666664</c:v>
                </c:pt>
                <c:pt idx="646">
                  <c:v>43940.486111111109</c:v>
                </c:pt>
                <c:pt idx="647">
                  <c:v>43940.493055555555</c:v>
                </c:pt>
                <c:pt idx="648">
                  <c:v>43940.5</c:v>
                </c:pt>
                <c:pt idx="649">
                  <c:v>43940.506944444445</c:v>
                </c:pt>
                <c:pt idx="650">
                  <c:v>43940.513888888891</c:v>
                </c:pt>
                <c:pt idx="651">
                  <c:v>43940.520833333336</c:v>
                </c:pt>
                <c:pt idx="652">
                  <c:v>43940.527777777781</c:v>
                </c:pt>
                <c:pt idx="653">
                  <c:v>43940.534722222219</c:v>
                </c:pt>
                <c:pt idx="654">
                  <c:v>43940.541666666664</c:v>
                </c:pt>
                <c:pt idx="655">
                  <c:v>43940.548611111109</c:v>
                </c:pt>
                <c:pt idx="656">
                  <c:v>43940.555555555555</c:v>
                </c:pt>
                <c:pt idx="657">
                  <c:v>43940.5625</c:v>
                </c:pt>
                <c:pt idx="658">
                  <c:v>43940.569444444445</c:v>
                </c:pt>
                <c:pt idx="659">
                  <c:v>43940.576388888891</c:v>
                </c:pt>
                <c:pt idx="660">
                  <c:v>43940.583333333336</c:v>
                </c:pt>
                <c:pt idx="661">
                  <c:v>43940.590277777781</c:v>
                </c:pt>
                <c:pt idx="662">
                  <c:v>43940.597222222219</c:v>
                </c:pt>
                <c:pt idx="663">
                  <c:v>43940.604166666664</c:v>
                </c:pt>
                <c:pt idx="664">
                  <c:v>43940.611111111109</c:v>
                </c:pt>
                <c:pt idx="665">
                  <c:v>43940.618055555555</c:v>
                </c:pt>
                <c:pt idx="666">
                  <c:v>43940.625</c:v>
                </c:pt>
                <c:pt idx="667">
                  <c:v>43940.631944444445</c:v>
                </c:pt>
                <c:pt idx="668">
                  <c:v>43940.638888888891</c:v>
                </c:pt>
                <c:pt idx="669">
                  <c:v>43940.645833333336</c:v>
                </c:pt>
                <c:pt idx="670">
                  <c:v>43940.652777777781</c:v>
                </c:pt>
                <c:pt idx="671">
                  <c:v>43940.659722222219</c:v>
                </c:pt>
                <c:pt idx="672">
                  <c:v>43940.666666666664</c:v>
                </c:pt>
                <c:pt idx="673">
                  <c:v>43940.673611111109</c:v>
                </c:pt>
                <c:pt idx="674">
                  <c:v>43940.680555555555</c:v>
                </c:pt>
                <c:pt idx="675">
                  <c:v>43940.6875</c:v>
                </c:pt>
                <c:pt idx="676">
                  <c:v>43940.694444444445</c:v>
                </c:pt>
                <c:pt idx="677">
                  <c:v>43940.701388888891</c:v>
                </c:pt>
                <c:pt idx="678">
                  <c:v>43940.708333333336</c:v>
                </c:pt>
                <c:pt idx="679">
                  <c:v>43940.715277777781</c:v>
                </c:pt>
                <c:pt idx="680">
                  <c:v>43940.722222222219</c:v>
                </c:pt>
                <c:pt idx="681">
                  <c:v>43940.729166666664</c:v>
                </c:pt>
                <c:pt idx="682">
                  <c:v>43940.736111111109</c:v>
                </c:pt>
                <c:pt idx="683">
                  <c:v>43940.743055555555</c:v>
                </c:pt>
                <c:pt idx="684">
                  <c:v>43940.75</c:v>
                </c:pt>
                <c:pt idx="685">
                  <c:v>43940.756944444445</c:v>
                </c:pt>
                <c:pt idx="686">
                  <c:v>43940.763888888891</c:v>
                </c:pt>
                <c:pt idx="687">
                  <c:v>43940.770833333336</c:v>
                </c:pt>
                <c:pt idx="688">
                  <c:v>43940.777777777781</c:v>
                </c:pt>
                <c:pt idx="689">
                  <c:v>43940.784722222219</c:v>
                </c:pt>
                <c:pt idx="690">
                  <c:v>43940.791666666664</c:v>
                </c:pt>
                <c:pt idx="691">
                  <c:v>43940.798611111109</c:v>
                </c:pt>
                <c:pt idx="692">
                  <c:v>43940.805555555555</c:v>
                </c:pt>
                <c:pt idx="693">
                  <c:v>43940.8125</c:v>
                </c:pt>
                <c:pt idx="694">
                  <c:v>43940.819444444445</c:v>
                </c:pt>
                <c:pt idx="695">
                  <c:v>43940.826388888891</c:v>
                </c:pt>
                <c:pt idx="696">
                  <c:v>43940.833333333336</c:v>
                </c:pt>
                <c:pt idx="697">
                  <c:v>43940.840277777781</c:v>
                </c:pt>
                <c:pt idx="698">
                  <c:v>43940.847222222219</c:v>
                </c:pt>
                <c:pt idx="699">
                  <c:v>43940.854166666664</c:v>
                </c:pt>
                <c:pt idx="700">
                  <c:v>43940.861111111109</c:v>
                </c:pt>
                <c:pt idx="701">
                  <c:v>43940.868055555555</c:v>
                </c:pt>
                <c:pt idx="702">
                  <c:v>43940.875</c:v>
                </c:pt>
                <c:pt idx="703">
                  <c:v>43940.881944444445</c:v>
                </c:pt>
                <c:pt idx="704">
                  <c:v>43940.888888888891</c:v>
                </c:pt>
                <c:pt idx="705">
                  <c:v>43940.895833333336</c:v>
                </c:pt>
                <c:pt idx="706">
                  <c:v>43940.902777777781</c:v>
                </c:pt>
                <c:pt idx="707">
                  <c:v>43940.909722222219</c:v>
                </c:pt>
                <c:pt idx="708">
                  <c:v>43940.916666666664</c:v>
                </c:pt>
                <c:pt idx="709">
                  <c:v>43940.923611111109</c:v>
                </c:pt>
                <c:pt idx="710">
                  <c:v>43940.930555555555</c:v>
                </c:pt>
                <c:pt idx="711">
                  <c:v>43940.9375</c:v>
                </c:pt>
                <c:pt idx="712">
                  <c:v>43940.944444444445</c:v>
                </c:pt>
                <c:pt idx="713">
                  <c:v>43940.951388888891</c:v>
                </c:pt>
                <c:pt idx="714">
                  <c:v>43940.958333333336</c:v>
                </c:pt>
                <c:pt idx="715">
                  <c:v>43940.965277777781</c:v>
                </c:pt>
                <c:pt idx="716">
                  <c:v>43940.972222222219</c:v>
                </c:pt>
                <c:pt idx="717">
                  <c:v>43940.979166666664</c:v>
                </c:pt>
                <c:pt idx="718">
                  <c:v>43940.986111111109</c:v>
                </c:pt>
                <c:pt idx="719">
                  <c:v>43940.993055555555</c:v>
                </c:pt>
              </c:numCache>
            </c:numRef>
          </c:xVal>
          <c:yVal>
            <c:numRef>
              <c:f>Sunhigh_1!$D$2:$D$721</c:f>
              <c:numCache>
                <c:formatCode>0.0</c:formatCode>
                <c:ptCount val="720"/>
                <c:pt idx="0">
                  <c:v>2.7777777777777777</c:v>
                </c:pt>
                <c:pt idx="1">
                  <c:v>2.7777777777777777</c:v>
                </c:pt>
                <c:pt idx="2">
                  <c:v>2.7777777777777777</c:v>
                </c:pt>
                <c:pt idx="3">
                  <c:v>2.7777777777777777</c:v>
                </c:pt>
                <c:pt idx="4">
                  <c:v>2.2222222222222223</c:v>
                </c:pt>
                <c:pt idx="5">
                  <c:v>2.2222222222222223</c:v>
                </c:pt>
                <c:pt idx="6">
                  <c:v>2.2222222222222223</c:v>
                </c:pt>
                <c:pt idx="7">
                  <c:v>2.2222222222222223</c:v>
                </c:pt>
                <c:pt idx="8">
                  <c:v>2.2222222222222223</c:v>
                </c:pt>
                <c:pt idx="9">
                  <c:v>2.2222222222222223</c:v>
                </c:pt>
                <c:pt idx="10">
                  <c:v>2.2222222222222223</c:v>
                </c:pt>
                <c:pt idx="11">
                  <c:v>2.2222222222222223</c:v>
                </c:pt>
                <c:pt idx="12">
                  <c:v>2.2222222222222223</c:v>
                </c:pt>
                <c:pt idx="13">
                  <c:v>2.2222222222222223</c:v>
                </c:pt>
                <c:pt idx="14">
                  <c:v>2.2222222222222223</c:v>
                </c:pt>
                <c:pt idx="15">
                  <c:v>2.2222222222222223</c:v>
                </c:pt>
                <c:pt idx="16">
                  <c:v>2.2222222222222223</c:v>
                </c:pt>
                <c:pt idx="17">
                  <c:v>2.2222222222222223</c:v>
                </c:pt>
                <c:pt idx="18">
                  <c:v>2.2222222222222223</c:v>
                </c:pt>
                <c:pt idx="19">
                  <c:v>2.2222222222222223</c:v>
                </c:pt>
                <c:pt idx="20">
                  <c:v>2.2222222222222223</c:v>
                </c:pt>
                <c:pt idx="21">
                  <c:v>2.2222222222222223</c:v>
                </c:pt>
                <c:pt idx="22">
                  <c:v>2.2222222222222223</c:v>
                </c:pt>
                <c:pt idx="23">
                  <c:v>2.2222222222222223</c:v>
                </c:pt>
                <c:pt idx="24">
                  <c:v>2.2222222222222223</c:v>
                </c:pt>
                <c:pt idx="25">
                  <c:v>2.2222222222222223</c:v>
                </c:pt>
                <c:pt idx="26">
                  <c:v>1.6666666666666665</c:v>
                </c:pt>
                <c:pt idx="27">
                  <c:v>1.6666666666666665</c:v>
                </c:pt>
                <c:pt idx="28">
                  <c:v>1.6666666666666665</c:v>
                </c:pt>
                <c:pt idx="29">
                  <c:v>1.6666666666666665</c:v>
                </c:pt>
                <c:pt idx="30">
                  <c:v>1.6666666666666665</c:v>
                </c:pt>
                <c:pt idx="31">
                  <c:v>1.6666666666666665</c:v>
                </c:pt>
                <c:pt idx="32">
                  <c:v>1.1111111111111112</c:v>
                </c:pt>
                <c:pt idx="33">
                  <c:v>1.6666666666666665</c:v>
                </c:pt>
                <c:pt idx="34">
                  <c:v>1.1111111111111112</c:v>
                </c:pt>
                <c:pt idx="35">
                  <c:v>1.1111111111111112</c:v>
                </c:pt>
                <c:pt idx="36">
                  <c:v>1.1111111111111112</c:v>
                </c:pt>
                <c:pt idx="37">
                  <c:v>0.55555555555555558</c:v>
                </c:pt>
                <c:pt idx="38">
                  <c:v>0.55555555555555558</c:v>
                </c:pt>
                <c:pt idx="39">
                  <c:v>0.55555555555555558</c:v>
                </c:pt>
                <c:pt idx="40">
                  <c:v>0.55555555555555558</c:v>
                </c:pt>
                <c:pt idx="41">
                  <c:v>0.55555555555555558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.55555555555555558</c:v>
                </c:pt>
                <c:pt idx="46">
                  <c:v>1.1111111111111112</c:v>
                </c:pt>
                <c:pt idx="47">
                  <c:v>1.6666666666666665</c:v>
                </c:pt>
                <c:pt idx="48">
                  <c:v>2.2222222222222223</c:v>
                </c:pt>
                <c:pt idx="49">
                  <c:v>2.7777777777777777</c:v>
                </c:pt>
                <c:pt idx="50">
                  <c:v>3.333333333333333</c:v>
                </c:pt>
                <c:pt idx="51">
                  <c:v>3.333333333333333</c:v>
                </c:pt>
                <c:pt idx="52">
                  <c:v>3.8888888888888888</c:v>
                </c:pt>
                <c:pt idx="53">
                  <c:v>3.8888888888888888</c:v>
                </c:pt>
                <c:pt idx="54">
                  <c:v>3.8888888888888888</c:v>
                </c:pt>
                <c:pt idx="55">
                  <c:v>3.8888888888888888</c:v>
                </c:pt>
                <c:pt idx="56">
                  <c:v>3.8888888888888888</c:v>
                </c:pt>
                <c:pt idx="57">
                  <c:v>4.4444444444444446</c:v>
                </c:pt>
                <c:pt idx="58">
                  <c:v>4.4444444444444446</c:v>
                </c:pt>
                <c:pt idx="59">
                  <c:v>4.4444444444444446</c:v>
                </c:pt>
                <c:pt idx="60">
                  <c:v>5</c:v>
                </c:pt>
                <c:pt idx="61">
                  <c:v>5</c:v>
                </c:pt>
                <c:pt idx="62">
                  <c:v>5.5555555555555554</c:v>
                </c:pt>
                <c:pt idx="63">
                  <c:v>5</c:v>
                </c:pt>
                <c:pt idx="64">
                  <c:v>5.5555555555555554</c:v>
                </c:pt>
                <c:pt idx="65">
                  <c:v>5.5555555555555554</c:v>
                </c:pt>
                <c:pt idx="66">
                  <c:v>6.1111111111111107</c:v>
                </c:pt>
                <c:pt idx="67">
                  <c:v>6.6666666666666661</c:v>
                </c:pt>
                <c:pt idx="68">
                  <c:v>6.6666666666666661</c:v>
                </c:pt>
                <c:pt idx="69">
                  <c:v>6.6666666666666661</c:v>
                </c:pt>
                <c:pt idx="70">
                  <c:v>7.2222222222222223</c:v>
                </c:pt>
                <c:pt idx="71">
                  <c:v>7.2222222222222223</c:v>
                </c:pt>
                <c:pt idx="72">
                  <c:v>7.2222222222222223</c:v>
                </c:pt>
                <c:pt idx="73">
                  <c:v>7.2222222222222223</c:v>
                </c:pt>
                <c:pt idx="74">
                  <c:v>7.2222222222222223</c:v>
                </c:pt>
                <c:pt idx="75">
                  <c:v>7.2222222222222223</c:v>
                </c:pt>
                <c:pt idx="76">
                  <c:v>7.7777777777777777</c:v>
                </c:pt>
                <c:pt idx="77">
                  <c:v>8.3333333333333339</c:v>
                </c:pt>
                <c:pt idx="78">
                  <c:v>8.3333333333333339</c:v>
                </c:pt>
                <c:pt idx="79">
                  <c:v>8.8888888888888893</c:v>
                </c:pt>
                <c:pt idx="80">
                  <c:v>8.8888888888888893</c:v>
                </c:pt>
                <c:pt idx="81">
                  <c:v>9.4444444444444446</c:v>
                </c:pt>
                <c:pt idx="82">
                  <c:v>9.4444444444444446</c:v>
                </c:pt>
                <c:pt idx="83">
                  <c:v>9.4444444444444446</c:v>
                </c:pt>
                <c:pt idx="84">
                  <c:v>10</c:v>
                </c:pt>
                <c:pt idx="85">
                  <c:v>10.555555555555555</c:v>
                </c:pt>
                <c:pt idx="86">
                  <c:v>10.555555555555555</c:v>
                </c:pt>
                <c:pt idx="87">
                  <c:v>11.111111111111111</c:v>
                </c:pt>
                <c:pt idx="88">
                  <c:v>11.111111111111111</c:v>
                </c:pt>
                <c:pt idx="89">
                  <c:v>11.111111111111111</c:v>
                </c:pt>
                <c:pt idx="90">
                  <c:v>10.555555555555555</c:v>
                </c:pt>
                <c:pt idx="91">
                  <c:v>10.555555555555555</c:v>
                </c:pt>
                <c:pt idx="92">
                  <c:v>10</c:v>
                </c:pt>
                <c:pt idx="93">
                  <c:v>10.555555555555555</c:v>
                </c:pt>
                <c:pt idx="94">
                  <c:v>10.555555555555555</c:v>
                </c:pt>
                <c:pt idx="95">
                  <c:v>11.111111111111111</c:v>
                </c:pt>
                <c:pt idx="96">
                  <c:v>11.666666666666666</c:v>
                </c:pt>
                <c:pt idx="97">
                  <c:v>11.666666666666666</c:v>
                </c:pt>
                <c:pt idx="98">
                  <c:v>11.666666666666666</c:v>
                </c:pt>
                <c:pt idx="99">
                  <c:v>11.666666666666666</c:v>
                </c:pt>
                <c:pt idx="100">
                  <c:v>12.222222222222221</c:v>
                </c:pt>
                <c:pt idx="101">
                  <c:v>12.777777777777777</c:v>
                </c:pt>
                <c:pt idx="102">
                  <c:v>13.333333333333332</c:v>
                </c:pt>
                <c:pt idx="103">
                  <c:v>13.333333333333332</c:v>
                </c:pt>
                <c:pt idx="104">
                  <c:v>13.333333333333332</c:v>
                </c:pt>
                <c:pt idx="105">
                  <c:v>12.777777777777777</c:v>
                </c:pt>
                <c:pt idx="106">
                  <c:v>12.777777777777777</c:v>
                </c:pt>
                <c:pt idx="107">
                  <c:v>13.333333333333332</c:v>
                </c:pt>
                <c:pt idx="108">
                  <c:v>12.777777777777777</c:v>
                </c:pt>
                <c:pt idx="109">
                  <c:v>12.777777777777777</c:v>
                </c:pt>
                <c:pt idx="110">
                  <c:v>12.777777777777777</c:v>
                </c:pt>
                <c:pt idx="111">
                  <c:v>12.777777777777777</c:v>
                </c:pt>
                <c:pt idx="112">
                  <c:v>12.777777777777777</c:v>
                </c:pt>
                <c:pt idx="113">
                  <c:v>12.222222222222221</c:v>
                </c:pt>
                <c:pt idx="114">
                  <c:v>11.666666666666666</c:v>
                </c:pt>
                <c:pt idx="115">
                  <c:v>11.111111111111111</c:v>
                </c:pt>
                <c:pt idx="116">
                  <c:v>10.555555555555555</c:v>
                </c:pt>
                <c:pt idx="117">
                  <c:v>9.4444444444444446</c:v>
                </c:pt>
                <c:pt idx="118">
                  <c:v>8.8888888888888893</c:v>
                </c:pt>
                <c:pt idx="119">
                  <c:v>8.3333333333333339</c:v>
                </c:pt>
                <c:pt idx="120">
                  <c:v>7.7777777777777777</c:v>
                </c:pt>
                <c:pt idx="121">
                  <c:v>7.2222222222222223</c:v>
                </c:pt>
                <c:pt idx="122">
                  <c:v>6.6666666666666661</c:v>
                </c:pt>
                <c:pt idx="123">
                  <c:v>6.1111111111111107</c:v>
                </c:pt>
                <c:pt idx="124">
                  <c:v>6.1111111111111107</c:v>
                </c:pt>
                <c:pt idx="125">
                  <c:v>5.5555555555555554</c:v>
                </c:pt>
                <c:pt idx="126">
                  <c:v>5</c:v>
                </c:pt>
                <c:pt idx="127">
                  <c:v>5</c:v>
                </c:pt>
                <c:pt idx="128">
                  <c:v>4.4444444444444446</c:v>
                </c:pt>
                <c:pt idx="129">
                  <c:v>4.4444444444444446</c:v>
                </c:pt>
                <c:pt idx="130">
                  <c:v>4.4444444444444446</c:v>
                </c:pt>
                <c:pt idx="131">
                  <c:v>4.4444444444444446</c:v>
                </c:pt>
                <c:pt idx="132">
                  <c:v>4.4444444444444446</c:v>
                </c:pt>
                <c:pt idx="133">
                  <c:v>4.4444444444444446</c:v>
                </c:pt>
                <c:pt idx="134">
                  <c:v>4.4444444444444446</c:v>
                </c:pt>
                <c:pt idx="135">
                  <c:v>4.4444444444444446</c:v>
                </c:pt>
                <c:pt idx="136">
                  <c:v>5</c:v>
                </c:pt>
                <c:pt idx="137">
                  <c:v>5</c:v>
                </c:pt>
                <c:pt idx="138">
                  <c:v>5</c:v>
                </c:pt>
                <c:pt idx="139">
                  <c:v>5</c:v>
                </c:pt>
                <c:pt idx="140">
                  <c:v>4.4444444444444446</c:v>
                </c:pt>
                <c:pt idx="141">
                  <c:v>4.4444444444444446</c:v>
                </c:pt>
                <c:pt idx="142">
                  <c:v>3.8888888888888888</c:v>
                </c:pt>
                <c:pt idx="143">
                  <c:v>4.4444444444444446</c:v>
                </c:pt>
                <c:pt idx="144">
                  <c:v>5.5555555555555554</c:v>
                </c:pt>
                <c:pt idx="145">
                  <c:v>6.1111111111111107</c:v>
                </c:pt>
                <c:pt idx="146">
                  <c:v>6.6666666666666661</c:v>
                </c:pt>
                <c:pt idx="147">
                  <c:v>6.6666666666666661</c:v>
                </c:pt>
                <c:pt idx="148">
                  <c:v>7.2222222222222223</c:v>
                </c:pt>
                <c:pt idx="149">
                  <c:v>7.2222222222222223</c:v>
                </c:pt>
                <c:pt idx="150">
                  <c:v>7.2222222222222223</c:v>
                </c:pt>
                <c:pt idx="151">
                  <c:v>7.2222222222222223</c:v>
                </c:pt>
                <c:pt idx="152">
                  <c:v>6.6666666666666661</c:v>
                </c:pt>
                <c:pt idx="153">
                  <c:v>6.1111111111111107</c:v>
                </c:pt>
                <c:pt idx="154">
                  <c:v>5.5555555555555554</c:v>
                </c:pt>
                <c:pt idx="155">
                  <c:v>5</c:v>
                </c:pt>
                <c:pt idx="156">
                  <c:v>4.4444444444444446</c:v>
                </c:pt>
                <c:pt idx="157">
                  <c:v>4.4444444444444446</c:v>
                </c:pt>
                <c:pt idx="158">
                  <c:v>4.4444444444444446</c:v>
                </c:pt>
                <c:pt idx="159">
                  <c:v>4.4444444444444446</c:v>
                </c:pt>
                <c:pt idx="160">
                  <c:v>4.4444444444444446</c:v>
                </c:pt>
                <c:pt idx="161">
                  <c:v>3.8888888888888888</c:v>
                </c:pt>
                <c:pt idx="162">
                  <c:v>3.8888888888888888</c:v>
                </c:pt>
                <c:pt idx="163">
                  <c:v>3.333333333333333</c:v>
                </c:pt>
                <c:pt idx="164">
                  <c:v>3.333333333333333</c:v>
                </c:pt>
                <c:pt idx="165">
                  <c:v>3.333333333333333</c:v>
                </c:pt>
                <c:pt idx="166">
                  <c:v>3.333333333333333</c:v>
                </c:pt>
                <c:pt idx="167">
                  <c:v>3.333333333333333</c:v>
                </c:pt>
                <c:pt idx="168">
                  <c:v>3.333333333333333</c:v>
                </c:pt>
                <c:pt idx="169">
                  <c:v>3.333333333333333</c:v>
                </c:pt>
                <c:pt idx="170">
                  <c:v>2.7777777777777777</c:v>
                </c:pt>
                <c:pt idx="171">
                  <c:v>2.7777777777777777</c:v>
                </c:pt>
                <c:pt idx="172">
                  <c:v>2.7777777777777777</c:v>
                </c:pt>
                <c:pt idx="173">
                  <c:v>2.7777777777777777</c:v>
                </c:pt>
                <c:pt idx="174">
                  <c:v>2.7777777777777777</c:v>
                </c:pt>
                <c:pt idx="175">
                  <c:v>2.7777777777777777</c:v>
                </c:pt>
                <c:pt idx="176">
                  <c:v>2.2222222222222223</c:v>
                </c:pt>
                <c:pt idx="177">
                  <c:v>2.2222222222222223</c:v>
                </c:pt>
                <c:pt idx="178">
                  <c:v>2.2222222222222223</c:v>
                </c:pt>
                <c:pt idx="179">
                  <c:v>2.2222222222222223</c:v>
                </c:pt>
                <c:pt idx="180">
                  <c:v>2.2222222222222223</c:v>
                </c:pt>
                <c:pt idx="181">
                  <c:v>2.2222222222222223</c:v>
                </c:pt>
                <c:pt idx="182">
                  <c:v>2.2222222222222223</c:v>
                </c:pt>
                <c:pt idx="183">
                  <c:v>2.2222222222222223</c:v>
                </c:pt>
                <c:pt idx="184">
                  <c:v>2.2222222222222223</c:v>
                </c:pt>
                <c:pt idx="185">
                  <c:v>2.2222222222222223</c:v>
                </c:pt>
                <c:pt idx="186">
                  <c:v>2.2222222222222223</c:v>
                </c:pt>
                <c:pt idx="187">
                  <c:v>2.2222222222222223</c:v>
                </c:pt>
                <c:pt idx="188">
                  <c:v>2.2222222222222223</c:v>
                </c:pt>
                <c:pt idx="189">
                  <c:v>2.7777777777777777</c:v>
                </c:pt>
                <c:pt idx="190">
                  <c:v>2.7777777777777777</c:v>
                </c:pt>
                <c:pt idx="191">
                  <c:v>3.333333333333333</c:v>
                </c:pt>
                <c:pt idx="192">
                  <c:v>3.333333333333333</c:v>
                </c:pt>
                <c:pt idx="193">
                  <c:v>3.8888888888888888</c:v>
                </c:pt>
                <c:pt idx="194">
                  <c:v>3.8888888888888888</c:v>
                </c:pt>
                <c:pt idx="195">
                  <c:v>4.4444444444444446</c:v>
                </c:pt>
                <c:pt idx="196">
                  <c:v>5</c:v>
                </c:pt>
                <c:pt idx="197">
                  <c:v>5</c:v>
                </c:pt>
                <c:pt idx="198">
                  <c:v>5</c:v>
                </c:pt>
                <c:pt idx="199">
                  <c:v>5</c:v>
                </c:pt>
                <c:pt idx="200">
                  <c:v>5</c:v>
                </c:pt>
                <c:pt idx="201">
                  <c:v>5</c:v>
                </c:pt>
                <c:pt idx="202">
                  <c:v>4.4444444444444446</c:v>
                </c:pt>
                <c:pt idx="203">
                  <c:v>5</c:v>
                </c:pt>
                <c:pt idx="204">
                  <c:v>5</c:v>
                </c:pt>
                <c:pt idx="205">
                  <c:v>5.5555555555555554</c:v>
                </c:pt>
                <c:pt idx="206">
                  <c:v>5.5555555555555554</c:v>
                </c:pt>
                <c:pt idx="207">
                  <c:v>5.5555555555555554</c:v>
                </c:pt>
                <c:pt idx="208">
                  <c:v>6.1111111111111107</c:v>
                </c:pt>
                <c:pt idx="209">
                  <c:v>6.1111111111111107</c:v>
                </c:pt>
                <c:pt idx="210">
                  <c:v>6.1111111111111107</c:v>
                </c:pt>
                <c:pt idx="211">
                  <c:v>6.6666666666666661</c:v>
                </c:pt>
                <c:pt idx="212">
                  <c:v>6.1111111111111107</c:v>
                </c:pt>
                <c:pt idx="213">
                  <c:v>6.1111111111111107</c:v>
                </c:pt>
                <c:pt idx="214">
                  <c:v>6.6666666666666661</c:v>
                </c:pt>
                <c:pt idx="215">
                  <c:v>6.1111111111111107</c:v>
                </c:pt>
                <c:pt idx="216">
                  <c:v>6.1111111111111107</c:v>
                </c:pt>
                <c:pt idx="217">
                  <c:v>6.6666666666666661</c:v>
                </c:pt>
                <c:pt idx="218">
                  <c:v>6.6666666666666661</c:v>
                </c:pt>
                <c:pt idx="219">
                  <c:v>7.2222222222222223</c:v>
                </c:pt>
                <c:pt idx="220">
                  <c:v>7.2222222222222223</c:v>
                </c:pt>
                <c:pt idx="221">
                  <c:v>7.7777777777777777</c:v>
                </c:pt>
                <c:pt idx="222">
                  <c:v>7.2222222222222223</c:v>
                </c:pt>
                <c:pt idx="223">
                  <c:v>7.7777777777777777</c:v>
                </c:pt>
                <c:pt idx="224">
                  <c:v>7.7777777777777777</c:v>
                </c:pt>
                <c:pt idx="225">
                  <c:v>8.3333333333333339</c:v>
                </c:pt>
                <c:pt idx="226">
                  <c:v>8.3333333333333339</c:v>
                </c:pt>
                <c:pt idx="227">
                  <c:v>8.8888888888888893</c:v>
                </c:pt>
                <c:pt idx="228">
                  <c:v>9.4444444444444446</c:v>
                </c:pt>
                <c:pt idx="229">
                  <c:v>8.8888888888888893</c:v>
                </c:pt>
                <c:pt idx="230">
                  <c:v>8.3333333333333339</c:v>
                </c:pt>
                <c:pt idx="231">
                  <c:v>8.8888888888888893</c:v>
                </c:pt>
                <c:pt idx="232">
                  <c:v>10</c:v>
                </c:pt>
                <c:pt idx="233">
                  <c:v>10</c:v>
                </c:pt>
                <c:pt idx="234">
                  <c:v>9.4444444444444446</c:v>
                </c:pt>
                <c:pt idx="235">
                  <c:v>9.4444444444444446</c:v>
                </c:pt>
                <c:pt idx="236">
                  <c:v>9.4444444444444446</c:v>
                </c:pt>
                <c:pt idx="237">
                  <c:v>9.4444444444444446</c:v>
                </c:pt>
                <c:pt idx="238">
                  <c:v>9.4444444444444446</c:v>
                </c:pt>
                <c:pt idx="239">
                  <c:v>9.4444444444444446</c:v>
                </c:pt>
                <c:pt idx="240">
                  <c:v>10</c:v>
                </c:pt>
                <c:pt idx="241">
                  <c:v>10</c:v>
                </c:pt>
                <c:pt idx="242">
                  <c:v>10.555555555555555</c:v>
                </c:pt>
                <c:pt idx="243">
                  <c:v>10.555555555555555</c:v>
                </c:pt>
                <c:pt idx="244">
                  <c:v>10</c:v>
                </c:pt>
                <c:pt idx="245">
                  <c:v>10</c:v>
                </c:pt>
                <c:pt idx="246">
                  <c:v>10</c:v>
                </c:pt>
                <c:pt idx="247">
                  <c:v>10.555555555555555</c:v>
                </c:pt>
                <c:pt idx="248">
                  <c:v>10</c:v>
                </c:pt>
                <c:pt idx="249">
                  <c:v>10</c:v>
                </c:pt>
                <c:pt idx="250">
                  <c:v>10</c:v>
                </c:pt>
                <c:pt idx="251">
                  <c:v>9.4444444444444446</c:v>
                </c:pt>
                <c:pt idx="252">
                  <c:v>9.4444444444444446</c:v>
                </c:pt>
                <c:pt idx="253">
                  <c:v>9.4444444444444446</c:v>
                </c:pt>
                <c:pt idx="254">
                  <c:v>10</c:v>
                </c:pt>
                <c:pt idx="255">
                  <c:v>9.4444444444444446</c:v>
                </c:pt>
                <c:pt idx="256">
                  <c:v>9.4444444444444446</c:v>
                </c:pt>
                <c:pt idx="257">
                  <c:v>8.8888888888888893</c:v>
                </c:pt>
                <c:pt idx="258">
                  <c:v>8.8888888888888893</c:v>
                </c:pt>
                <c:pt idx="259">
                  <c:v>8.3333333333333339</c:v>
                </c:pt>
                <c:pt idx="260">
                  <c:v>8.3333333333333339</c:v>
                </c:pt>
                <c:pt idx="261">
                  <c:v>7.7777777777777777</c:v>
                </c:pt>
                <c:pt idx="262">
                  <c:v>7.2222222222222223</c:v>
                </c:pt>
                <c:pt idx="263">
                  <c:v>6.6666666666666661</c:v>
                </c:pt>
                <c:pt idx="264">
                  <c:v>6.6666666666666661</c:v>
                </c:pt>
                <c:pt idx="265">
                  <c:v>6.1111111111111107</c:v>
                </c:pt>
                <c:pt idx="266">
                  <c:v>6.1111111111111107</c:v>
                </c:pt>
                <c:pt idx="267">
                  <c:v>6.1111111111111107</c:v>
                </c:pt>
                <c:pt idx="268">
                  <c:v>5.5555555555555554</c:v>
                </c:pt>
                <c:pt idx="269">
                  <c:v>5.5555555555555554</c:v>
                </c:pt>
                <c:pt idx="270">
                  <c:v>5</c:v>
                </c:pt>
                <c:pt idx="271">
                  <c:v>5</c:v>
                </c:pt>
                <c:pt idx="272">
                  <c:v>5</c:v>
                </c:pt>
                <c:pt idx="273">
                  <c:v>4.4444444444444446</c:v>
                </c:pt>
                <c:pt idx="274">
                  <c:v>4.4444444444444446</c:v>
                </c:pt>
                <c:pt idx="275">
                  <c:v>3.8888888888888888</c:v>
                </c:pt>
                <c:pt idx="276">
                  <c:v>3.8888888888888888</c:v>
                </c:pt>
                <c:pt idx="277">
                  <c:v>3.333333333333333</c:v>
                </c:pt>
                <c:pt idx="278">
                  <c:v>3.333333333333333</c:v>
                </c:pt>
                <c:pt idx="279">
                  <c:v>3.333333333333333</c:v>
                </c:pt>
                <c:pt idx="280">
                  <c:v>3.333333333333333</c:v>
                </c:pt>
                <c:pt idx="281">
                  <c:v>3.333333333333333</c:v>
                </c:pt>
                <c:pt idx="282">
                  <c:v>3.333333333333333</c:v>
                </c:pt>
                <c:pt idx="283">
                  <c:v>2.7777777777777777</c:v>
                </c:pt>
                <c:pt idx="284">
                  <c:v>2.7777777777777777</c:v>
                </c:pt>
                <c:pt idx="285">
                  <c:v>2.7777777777777777</c:v>
                </c:pt>
                <c:pt idx="286">
                  <c:v>2.7777777777777777</c:v>
                </c:pt>
                <c:pt idx="287">
                  <c:v>2.2222222222222223</c:v>
                </c:pt>
                <c:pt idx="288">
                  <c:v>2.2222222222222223</c:v>
                </c:pt>
                <c:pt idx="289">
                  <c:v>2.2222222222222223</c:v>
                </c:pt>
                <c:pt idx="290">
                  <c:v>2.2222222222222223</c:v>
                </c:pt>
                <c:pt idx="291">
                  <c:v>2.2222222222222223</c:v>
                </c:pt>
                <c:pt idx="292">
                  <c:v>2.2222222222222223</c:v>
                </c:pt>
                <c:pt idx="293">
                  <c:v>2.2222222222222223</c:v>
                </c:pt>
                <c:pt idx="294">
                  <c:v>2.2222222222222223</c:v>
                </c:pt>
                <c:pt idx="295">
                  <c:v>2.2222222222222223</c:v>
                </c:pt>
                <c:pt idx="296">
                  <c:v>2.7777777777777777</c:v>
                </c:pt>
                <c:pt idx="297">
                  <c:v>2.7777777777777777</c:v>
                </c:pt>
                <c:pt idx="298">
                  <c:v>2.7777777777777777</c:v>
                </c:pt>
                <c:pt idx="299">
                  <c:v>2.7777777777777777</c:v>
                </c:pt>
                <c:pt idx="300">
                  <c:v>2.2222222222222223</c:v>
                </c:pt>
                <c:pt idx="301">
                  <c:v>1.6666666666666665</c:v>
                </c:pt>
                <c:pt idx="302">
                  <c:v>1.6666666666666665</c:v>
                </c:pt>
                <c:pt idx="303">
                  <c:v>1.1111111111111112</c:v>
                </c:pt>
                <c:pt idx="304">
                  <c:v>1.1111111111111112</c:v>
                </c:pt>
                <c:pt idx="305">
                  <c:v>1.1111111111111112</c:v>
                </c:pt>
                <c:pt idx="306">
                  <c:v>0.55555555555555558</c:v>
                </c:pt>
                <c:pt idx="307">
                  <c:v>0.55555555555555558</c:v>
                </c:pt>
                <c:pt idx="308">
                  <c:v>0</c:v>
                </c:pt>
                <c:pt idx="309">
                  <c:v>0</c:v>
                </c:pt>
                <c:pt idx="310">
                  <c:v>0</c:v>
                </c:pt>
                <c:pt idx="311">
                  <c:v>0</c:v>
                </c:pt>
                <c:pt idx="312">
                  <c:v>0</c:v>
                </c:pt>
                <c:pt idx="313">
                  <c:v>0</c:v>
                </c:pt>
                <c:pt idx="314">
                  <c:v>0</c:v>
                </c:pt>
                <c:pt idx="315">
                  <c:v>0</c:v>
                </c:pt>
                <c:pt idx="316">
                  <c:v>-0.55555555555555558</c:v>
                </c:pt>
                <c:pt idx="317">
                  <c:v>0</c:v>
                </c:pt>
                <c:pt idx="318">
                  <c:v>0</c:v>
                </c:pt>
                <c:pt idx="319">
                  <c:v>0.55555555555555558</c:v>
                </c:pt>
                <c:pt idx="320">
                  <c:v>0.55555555555555558</c:v>
                </c:pt>
                <c:pt idx="321">
                  <c:v>0.55555555555555558</c:v>
                </c:pt>
                <c:pt idx="322">
                  <c:v>0.55555555555555558</c:v>
                </c:pt>
                <c:pt idx="323">
                  <c:v>0.55555555555555558</c:v>
                </c:pt>
                <c:pt idx="324">
                  <c:v>0.55555555555555558</c:v>
                </c:pt>
                <c:pt idx="325">
                  <c:v>0</c:v>
                </c:pt>
                <c:pt idx="326">
                  <c:v>0</c:v>
                </c:pt>
                <c:pt idx="327">
                  <c:v>0</c:v>
                </c:pt>
                <c:pt idx="328">
                  <c:v>0</c:v>
                </c:pt>
                <c:pt idx="329">
                  <c:v>0</c:v>
                </c:pt>
                <c:pt idx="330">
                  <c:v>-0.55555555555555558</c:v>
                </c:pt>
                <c:pt idx="331">
                  <c:v>0</c:v>
                </c:pt>
                <c:pt idx="332">
                  <c:v>0.55555555555555558</c:v>
                </c:pt>
                <c:pt idx="333">
                  <c:v>1.1111111111111112</c:v>
                </c:pt>
                <c:pt idx="334">
                  <c:v>2.2222222222222223</c:v>
                </c:pt>
                <c:pt idx="335">
                  <c:v>2.7777777777777777</c:v>
                </c:pt>
                <c:pt idx="336">
                  <c:v>3.333333333333333</c:v>
                </c:pt>
                <c:pt idx="337">
                  <c:v>3.8888888888888888</c:v>
                </c:pt>
                <c:pt idx="338">
                  <c:v>4.4444444444444446</c:v>
                </c:pt>
                <c:pt idx="339">
                  <c:v>5</c:v>
                </c:pt>
                <c:pt idx="340">
                  <c:v>5.5555555555555554</c:v>
                </c:pt>
                <c:pt idx="341">
                  <c:v>5.5555555555555554</c:v>
                </c:pt>
                <c:pt idx="342">
                  <c:v>6.1111111111111107</c:v>
                </c:pt>
                <c:pt idx="343">
                  <c:v>6.1111111111111107</c:v>
                </c:pt>
                <c:pt idx="344">
                  <c:v>6.6666666666666661</c:v>
                </c:pt>
                <c:pt idx="345">
                  <c:v>6.6666666666666661</c:v>
                </c:pt>
                <c:pt idx="346">
                  <c:v>6.6666666666666661</c:v>
                </c:pt>
                <c:pt idx="347">
                  <c:v>6.6666666666666661</c:v>
                </c:pt>
                <c:pt idx="348">
                  <c:v>6.6666666666666661</c:v>
                </c:pt>
                <c:pt idx="349">
                  <c:v>7.2222222222222223</c:v>
                </c:pt>
                <c:pt idx="350">
                  <c:v>8.3333333333333339</c:v>
                </c:pt>
                <c:pt idx="351">
                  <c:v>8.3333333333333339</c:v>
                </c:pt>
                <c:pt idx="352">
                  <c:v>8.8888888888888893</c:v>
                </c:pt>
                <c:pt idx="353">
                  <c:v>10</c:v>
                </c:pt>
                <c:pt idx="354">
                  <c:v>10.555555555555555</c:v>
                </c:pt>
                <c:pt idx="355">
                  <c:v>11.111111111111111</c:v>
                </c:pt>
                <c:pt idx="356">
                  <c:v>12.222222222222221</c:v>
                </c:pt>
                <c:pt idx="357">
                  <c:v>12.777777777777777</c:v>
                </c:pt>
                <c:pt idx="358">
                  <c:v>12.777777777777777</c:v>
                </c:pt>
                <c:pt idx="359">
                  <c:v>12.777777777777777</c:v>
                </c:pt>
                <c:pt idx="360">
                  <c:v>13.333333333333332</c:v>
                </c:pt>
                <c:pt idx="361">
                  <c:v>13.888888888888889</c:v>
                </c:pt>
                <c:pt idx="362">
                  <c:v>13.888888888888889</c:v>
                </c:pt>
                <c:pt idx="363">
                  <c:v>13.888888888888889</c:v>
                </c:pt>
                <c:pt idx="364">
                  <c:v>13.888888888888889</c:v>
                </c:pt>
                <c:pt idx="365">
                  <c:v>13.888888888888889</c:v>
                </c:pt>
                <c:pt idx="366">
                  <c:v>13.333333333333332</c:v>
                </c:pt>
                <c:pt idx="367">
                  <c:v>13.333333333333332</c:v>
                </c:pt>
                <c:pt idx="368">
                  <c:v>13.333333333333332</c:v>
                </c:pt>
                <c:pt idx="369">
                  <c:v>13.888888888888889</c:v>
                </c:pt>
                <c:pt idx="370">
                  <c:v>13.888888888888889</c:v>
                </c:pt>
                <c:pt idx="371">
                  <c:v>13.888888888888889</c:v>
                </c:pt>
                <c:pt idx="372">
                  <c:v>13.888888888888889</c:v>
                </c:pt>
                <c:pt idx="373">
                  <c:v>13.888888888888889</c:v>
                </c:pt>
                <c:pt idx="374">
                  <c:v>13.888888888888889</c:v>
                </c:pt>
                <c:pt idx="375">
                  <c:v>13.888888888888889</c:v>
                </c:pt>
                <c:pt idx="376">
                  <c:v>13.888888888888889</c:v>
                </c:pt>
                <c:pt idx="377">
                  <c:v>13.888888888888889</c:v>
                </c:pt>
                <c:pt idx="378">
                  <c:v>13.888888888888889</c:v>
                </c:pt>
                <c:pt idx="379">
                  <c:v>13.888888888888889</c:v>
                </c:pt>
                <c:pt idx="380">
                  <c:v>14.444444444444445</c:v>
                </c:pt>
                <c:pt idx="381">
                  <c:v>15</c:v>
                </c:pt>
                <c:pt idx="382">
                  <c:v>15</c:v>
                </c:pt>
                <c:pt idx="383">
                  <c:v>15.555555555555555</c:v>
                </c:pt>
                <c:pt idx="384">
                  <c:v>15.555555555555555</c:v>
                </c:pt>
                <c:pt idx="385">
                  <c:v>15.555555555555555</c:v>
                </c:pt>
                <c:pt idx="386">
                  <c:v>15.555555555555555</c:v>
                </c:pt>
                <c:pt idx="387">
                  <c:v>15.555555555555555</c:v>
                </c:pt>
                <c:pt idx="388">
                  <c:v>16.111111111111111</c:v>
                </c:pt>
                <c:pt idx="389">
                  <c:v>16.111111111111111</c:v>
                </c:pt>
                <c:pt idx="390">
                  <c:v>15.555555555555555</c:v>
                </c:pt>
                <c:pt idx="391">
                  <c:v>16.111111111111111</c:v>
                </c:pt>
                <c:pt idx="392">
                  <c:v>15.555555555555555</c:v>
                </c:pt>
                <c:pt idx="393">
                  <c:v>15.555555555555555</c:v>
                </c:pt>
                <c:pt idx="394">
                  <c:v>15</c:v>
                </c:pt>
                <c:pt idx="395">
                  <c:v>14.444444444444445</c:v>
                </c:pt>
                <c:pt idx="396">
                  <c:v>13.888888888888889</c:v>
                </c:pt>
                <c:pt idx="397">
                  <c:v>13.888888888888889</c:v>
                </c:pt>
                <c:pt idx="398">
                  <c:v>13.333333333333332</c:v>
                </c:pt>
                <c:pt idx="399">
                  <c:v>13.333333333333332</c:v>
                </c:pt>
                <c:pt idx="400">
                  <c:v>13.333333333333332</c:v>
                </c:pt>
                <c:pt idx="401">
                  <c:v>12.777777777777777</c:v>
                </c:pt>
                <c:pt idx="402">
                  <c:v>12.777777777777777</c:v>
                </c:pt>
                <c:pt idx="403">
                  <c:v>12.222222222222221</c:v>
                </c:pt>
                <c:pt idx="404">
                  <c:v>12.222222222222221</c:v>
                </c:pt>
                <c:pt idx="405">
                  <c:v>11.666666666666666</c:v>
                </c:pt>
                <c:pt idx="406">
                  <c:v>11.666666666666666</c:v>
                </c:pt>
                <c:pt idx="407">
                  <c:v>11.666666666666666</c:v>
                </c:pt>
                <c:pt idx="408">
                  <c:v>11.111111111111111</c:v>
                </c:pt>
                <c:pt idx="409">
                  <c:v>11.111111111111111</c:v>
                </c:pt>
                <c:pt idx="410">
                  <c:v>11.111111111111111</c:v>
                </c:pt>
                <c:pt idx="411">
                  <c:v>11.111111111111111</c:v>
                </c:pt>
                <c:pt idx="412">
                  <c:v>11.111111111111111</c:v>
                </c:pt>
                <c:pt idx="413">
                  <c:v>10.555555555555555</c:v>
                </c:pt>
                <c:pt idx="414">
                  <c:v>10.555555555555555</c:v>
                </c:pt>
                <c:pt idx="415">
                  <c:v>10.555555555555555</c:v>
                </c:pt>
                <c:pt idx="416">
                  <c:v>10.555555555555555</c:v>
                </c:pt>
                <c:pt idx="417">
                  <c:v>10.555555555555555</c:v>
                </c:pt>
                <c:pt idx="418">
                  <c:v>10.555555555555555</c:v>
                </c:pt>
                <c:pt idx="419">
                  <c:v>10.555555555555555</c:v>
                </c:pt>
                <c:pt idx="420">
                  <c:v>10.555555555555555</c:v>
                </c:pt>
                <c:pt idx="421">
                  <c:v>10.555555555555555</c:v>
                </c:pt>
                <c:pt idx="422">
                  <c:v>10</c:v>
                </c:pt>
                <c:pt idx="423">
                  <c:v>10</c:v>
                </c:pt>
                <c:pt idx="424">
                  <c:v>10</c:v>
                </c:pt>
                <c:pt idx="425">
                  <c:v>10</c:v>
                </c:pt>
                <c:pt idx="426">
                  <c:v>9.4444444444444446</c:v>
                </c:pt>
                <c:pt idx="427">
                  <c:v>9.4444444444444446</c:v>
                </c:pt>
                <c:pt idx="428">
                  <c:v>9.4444444444444446</c:v>
                </c:pt>
                <c:pt idx="429">
                  <c:v>9.4444444444444446</c:v>
                </c:pt>
                <c:pt idx="430">
                  <c:v>8.8888888888888893</c:v>
                </c:pt>
                <c:pt idx="431">
                  <c:v>8.8888888888888893</c:v>
                </c:pt>
                <c:pt idx="432">
                  <c:v>8.8888888888888893</c:v>
                </c:pt>
                <c:pt idx="433">
                  <c:v>8.8888888888888893</c:v>
                </c:pt>
                <c:pt idx="434">
                  <c:v>8.3333333333333339</c:v>
                </c:pt>
                <c:pt idx="435">
                  <c:v>8.3333333333333339</c:v>
                </c:pt>
                <c:pt idx="436">
                  <c:v>8.3333333333333339</c:v>
                </c:pt>
                <c:pt idx="437">
                  <c:v>8.3333333333333339</c:v>
                </c:pt>
                <c:pt idx="438">
                  <c:v>7.7777777777777777</c:v>
                </c:pt>
                <c:pt idx="439">
                  <c:v>7.7777777777777777</c:v>
                </c:pt>
                <c:pt idx="440">
                  <c:v>7.7777777777777777</c:v>
                </c:pt>
                <c:pt idx="441">
                  <c:v>7.7777777777777777</c:v>
                </c:pt>
                <c:pt idx="442">
                  <c:v>7.7777777777777777</c:v>
                </c:pt>
                <c:pt idx="443">
                  <c:v>7.7777777777777777</c:v>
                </c:pt>
                <c:pt idx="444">
                  <c:v>7.7777777777777777</c:v>
                </c:pt>
                <c:pt idx="445">
                  <c:v>7.7777777777777777</c:v>
                </c:pt>
                <c:pt idx="446">
                  <c:v>8.3333333333333339</c:v>
                </c:pt>
                <c:pt idx="447">
                  <c:v>7.7777777777777777</c:v>
                </c:pt>
                <c:pt idx="448">
                  <c:v>7.7777777777777777</c:v>
                </c:pt>
                <c:pt idx="449">
                  <c:v>8.3333333333333339</c:v>
                </c:pt>
                <c:pt idx="450">
                  <c:v>7.7777777777777777</c:v>
                </c:pt>
                <c:pt idx="451">
                  <c:v>7.7777777777777777</c:v>
                </c:pt>
                <c:pt idx="452">
                  <c:v>7.7777777777777777</c:v>
                </c:pt>
                <c:pt idx="453">
                  <c:v>7.7777777777777777</c:v>
                </c:pt>
                <c:pt idx="454">
                  <c:v>7.7777777777777777</c:v>
                </c:pt>
                <c:pt idx="455">
                  <c:v>7.7777777777777777</c:v>
                </c:pt>
                <c:pt idx="456">
                  <c:v>7.7777777777777777</c:v>
                </c:pt>
                <c:pt idx="457">
                  <c:v>7.7777777777777777</c:v>
                </c:pt>
                <c:pt idx="458">
                  <c:v>7.7777777777777777</c:v>
                </c:pt>
                <c:pt idx="459">
                  <c:v>7.7777777777777777</c:v>
                </c:pt>
                <c:pt idx="460">
                  <c:v>7.7777777777777777</c:v>
                </c:pt>
                <c:pt idx="461">
                  <c:v>8.3333333333333339</c:v>
                </c:pt>
                <c:pt idx="462">
                  <c:v>8.3333333333333339</c:v>
                </c:pt>
                <c:pt idx="463">
                  <c:v>8.8888888888888893</c:v>
                </c:pt>
                <c:pt idx="464">
                  <c:v>8.8888888888888893</c:v>
                </c:pt>
                <c:pt idx="465">
                  <c:v>8.8888888888888893</c:v>
                </c:pt>
                <c:pt idx="466">
                  <c:v>8.8888888888888893</c:v>
                </c:pt>
                <c:pt idx="467">
                  <c:v>8.8888888888888893</c:v>
                </c:pt>
                <c:pt idx="468">
                  <c:v>8.8888888888888893</c:v>
                </c:pt>
                <c:pt idx="469">
                  <c:v>8.3333333333333339</c:v>
                </c:pt>
                <c:pt idx="470">
                  <c:v>8.3333333333333339</c:v>
                </c:pt>
                <c:pt idx="471">
                  <c:v>8.3333333333333339</c:v>
                </c:pt>
                <c:pt idx="472">
                  <c:v>8.3333333333333339</c:v>
                </c:pt>
                <c:pt idx="473">
                  <c:v>8.3333333333333339</c:v>
                </c:pt>
                <c:pt idx="474">
                  <c:v>7.7777777777777777</c:v>
                </c:pt>
                <c:pt idx="475">
                  <c:v>7.7777777777777777</c:v>
                </c:pt>
                <c:pt idx="476">
                  <c:v>7.7777777777777777</c:v>
                </c:pt>
                <c:pt idx="477">
                  <c:v>8.3333333333333339</c:v>
                </c:pt>
                <c:pt idx="478">
                  <c:v>8.3333333333333339</c:v>
                </c:pt>
                <c:pt idx="479">
                  <c:v>8.3333333333333339</c:v>
                </c:pt>
                <c:pt idx="480">
                  <c:v>8.3333333333333339</c:v>
                </c:pt>
                <c:pt idx="481">
                  <c:v>8.3333333333333339</c:v>
                </c:pt>
                <c:pt idx="482">
                  <c:v>7.7777777777777777</c:v>
                </c:pt>
                <c:pt idx="483">
                  <c:v>7.7777777777777777</c:v>
                </c:pt>
                <c:pt idx="484">
                  <c:v>7.7777777777777777</c:v>
                </c:pt>
                <c:pt idx="485">
                  <c:v>7.7777777777777777</c:v>
                </c:pt>
                <c:pt idx="486">
                  <c:v>7.7777777777777777</c:v>
                </c:pt>
                <c:pt idx="487">
                  <c:v>7.7777777777777777</c:v>
                </c:pt>
                <c:pt idx="488">
                  <c:v>7.2222222222222223</c:v>
                </c:pt>
                <c:pt idx="489">
                  <c:v>7.2222222222222223</c:v>
                </c:pt>
                <c:pt idx="490">
                  <c:v>7.7777777777777777</c:v>
                </c:pt>
                <c:pt idx="491">
                  <c:v>7.7777777777777777</c:v>
                </c:pt>
                <c:pt idx="492">
                  <c:v>7.7777777777777777</c:v>
                </c:pt>
                <c:pt idx="493">
                  <c:v>7.2222222222222223</c:v>
                </c:pt>
                <c:pt idx="494">
                  <c:v>7.7777777777777777</c:v>
                </c:pt>
                <c:pt idx="495">
                  <c:v>7.2222222222222223</c:v>
                </c:pt>
                <c:pt idx="496">
                  <c:v>6.6666666666666661</c:v>
                </c:pt>
                <c:pt idx="497">
                  <c:v>6.6666666666666661</c:v>
                </c:pt>
                <c:pt idx="498">
                  <c:v>6.6666666666666661</c:v>
                </c:pt>
                <c:pt idx="499">
                  <c:v>6.6666666666666661</c:v>
                </c:pt>
                <c:pt idx="500">
                  <c:v>6.1111111111111107</c:v>
                </c:pt>
                <c:pt idx="501">
                  <c:v>6.1111111111111107</c:v>
                </c:pt>
                <c:pt idx="502">
                  <c:v>6.1111111111111107</c:v>
                </c:pt>
                <c:pt idx="503">
                  <c:v>6.1111111111111107</c:v>
                </c:pt>
                <c:pt idx="504">
                  <c:v>6.1111111111111107</c:v>
                </c:pt>
                <c:pt idx="505">
                  <c:v>6.6666666666666661</c:v>
                </c:pt>
                <c:pt idx="506">
                  <c:v>6.6666666666666661</c:v>
                </c:pt>
                <c:pt idx="507">
                  <c:v>6.1111111111111107</c:v>
                </c:pt>
                <c:pt idx="508">
                  <c:v>6.6666666666666661</c:v>
                </c:pt>
                <c:pt idx="509">
                  <c:v>7.2222222222222223</c:v>
                </c:pt>
                <c:pt idx="510">
                  <c:v>7.2222222222222223</c:v>
                </c:pt>
                <c:pt idx="511">
                  <c:v>6.6666666666666661</c:v>
                </c:pt>
                <c:pt idx="512">
                  <c:v>7.7777777777777777</c:v>
                </c:pt>
                <c:pt idx="513">
                  <c:v>7.7777777777777777</c:v>
                </c:pt>
                <c:pt idx="514">
                  <c:v>7.7777777777777777</c:v>
                </c:pt>
                <c:pt idx="515">
                  <c:v>7.7777777777777777</c:v>
                </c:pt>
                <c:pt idx="516">
                  <c:v>7.7777777777777777</c:v>
                </c:pt>
                <c:pt idx="517">
                  <c:v>7.7777777777777777</c:v>
                </c:pt>
                <c:pt idx="518">
                  <c:v>8.3333333333333339</c:v>
                </c:pt>
                <c:pt idx="519">
                  <c:v>8.3333333333333339</c:v>
                </c:pt>
                <c:pt idx="520">
                  <c:v>8.3333333333333339</c:v>
                </c:pt>
                <c:pt idx="521">
                  <c:v>8.3333333333333339</c:v>
                </c:pt>
                <c:pt idx="522">
                  <c:v>8.8888888888888893</c:v>
                </c:pt>
                <c:pt idx="523">
                  <c:v>9.4444444444444446</c:v>
                </c:pt>
                <c:pt idx="524">
                  <c:v>8.8888888888888893</c:v>
                </c:pt>
                <c:pt idx="525">
                  <c:v>8.8888888888888893</c:v>
                </c:pt>
                <c:pt idx="526">
                  <c:v>9.4444444444444446</c:v>
                </c:pt>
                <c:pt idx="527">
                  <c:v>9.4444444444444446</c:v>
                </c:pt>
                <c:pt idx="528">
                  <c:v>9.4444444444444446</c:v>
                </c:pt>
                <c:pt idx="529">
                  <c:v>9.4444444444444446</c:v>
                </c:pt>
                <c:pt idx="530">
                  <c:v>10</c:v>
                </c:pt>
                <c:pt idx="531">
                  <c:v>10</c:v>
                </c:pt>
                <c:pt idx="532">
                  <c:v>9.4444444444444446</c:v>
                </c:pt>
                <c:pt idx="533">
                  <c:v>10</c:v>
                </c:pt>
                <c:pt idx="534">
                  <c:v>9.4444444444444446</c:v>
                </c:pt>
                <c:pt idx="535">
                  <c:v>10</c:v>
                </c:pt>
                <c:pt idx="536">
                  <c:v>10</c:v>
                </c:pt>
                <c:pt idx="537">
                  <c:v>10.555555555555555</c:v>
                </c:pt>
                <c:pt idx="538">
                  <c:v>11.111111111111111</c:v>
                </c:pt>
                <c:pt idx="539">
                  <c:v>11.666666666666666</c:v>
                </c:pt>
                <c:pt idx="540">
                  <c:v>11.111111111111111</c:v>
                </c:pt>
                <c:pt idx="541">
                  <c:v>10.555555555555555</c:v>
                </c:pt>
                <c:pt idx="542">
                  <c:v>10.555555555555555</c:v>
                </c:pt>
                <c:pt idx="543">
                  <c:v>10</c:v>
                </c:pt>
                <c:pt idx="544">
                  <c:v>10</c:v>
                </c:pt>
                <c:pt idx="545">
                  <c:v>9.4444444444444446</c:v>
                </c:pt>
                <c:pt idx="546">
                  <c:v>8.8888888888888893</c:v>
                </c:pt>
                <c:pt idx="547">
                  <c:v>8.8888888888888893</c:v>
                </c:pt>
                <c:pt idx="548">
                  <c:v>8.8888888888888893</c:v>
                </c:pt>
                <c:pt idx="549">
                  <c:v>8.3333333333333339</c:v>
                </c:pt>
                <c:pt idx="550">
                  <c:v>7.7777777777777777</c:v>
                </c:pt>
                <c:pt idx="551">
                  <c:v>7.7777777777777777</c:v>
                </c:pt>
                <c:pt idx="552">
                  <c:v>6.6666666666666661</c:v>
                </c:pt>
                <c:pt idx="553">
                  <c:v>6.6666666666666661</c:v>
                </c:pt>
                <c:pt idx="554">
                  <c:v>6.1111111111111107</c:v>
                </c:pt>
                <c:pt idx="555">
                  <c:v>5.5555555555555554</c:v>
                </c:pt>
                <c:pt idx="556">
                  <c:v>5.5555555555555554</c:v>
                </c:pt>
                <c:pt idx="557">
                  <c:v>5.5555555555555554</c:v>
                </c:pt>
                <c:pt idx="558">
                  <c:v>5</c:v>
                </c:pt>
                <c:pt idx="559">
                  <c:v>5</c:v>
                </c:pt>
                <c:pt idx="560">
                  <c:v>4.4444444444444446</c:v>
                </c:pt>
                <c:pt idx="561">
                  <c:v>4.4444444444444446</c:v>
                </c:pt>
                <c:pt idx="562">
                  <c:v>4.4444444444444446</c:v>
                </c:pt>
                <c:pt idx="563">
                  <c:v>3.8888888888888888</c:v>
                </c:pt>
                <c:pt idx="564">
                  <c:v>3.333333333333333</c:v>
                </c:pt>
                <c:pt idx="565">
                  <c:v>3.333333333333333</c:v>
                </c:pt>
                <c:pt idx="566">
                  <c:v>3.333333333333333</c:v>
                </c:pt>
                <c:pt idx="567">
                  <c:v>3.333333333333333</c:v>
                </c:pt>
                <c:pt idx="568">
                  <c:v>2.7777777777777777</c:v>
                </c:pt>
                <c:pt idx="569">
                  <c:v>2.7777777777777777</c:v>
                </c:pt>
                <c:pt idx="570">
                  <c:v>2.7777777777777777</c:v>
                </c:pt>
                <c:pt idx="571">
                  <c:v>2.7777777777777777</c:v>
                </c:pt>
                <c:pt idx="572">
                  <c:v>2.7777777777777777</c:v>
                </c:pt>
                <c:pt idx="573">
                  <c:v>2.7777777777777777</c:v>
                </c:pt>
                <c:pt idx="574">
                  <c:v>2.7777777777777777</c:v>
                </c:pt>
                <c:pt idx="575">
                  <c:v>2.7777777777777777</c:v>
                </c:pt>
                <c:pt idx="576">
                  <c:v>2.7777777777777777</c:v>
                </c:pt>
                <c:pt idx="577">
                  <c:v>2.7777777777777777</c:v>
                </c:pt>
                <c:pt idx="578">
                  <c:v>2.7777777777777777</c:v>
                </c:pt>
                <c:pt idx="579">
                  <c:v>2.7777777777777777</c:v>
                </c:pt>
                <c:pt idx="580">
                  <c:v>2.7777777777777777</c:v>
                </c:pt>
                <c:pt idx="581">
                  <c:v>2.7777777777777777</c:v>
                </c:pt>
                <c:pt idx="582">
                  <c:v>2.2222222222222223</c:v>
                </c:pt>
                <c:pt idx="583">
                  <c:v>1.6666666666666665</c:v>
                </c:pt>
                <c:pt idx="584">
                  <c:v>1.6666666666666665</c:v>
                </c:pt>
                <c:pt idx="585">
                  <c:v>1.6666666666666665</c:v>
                </c:pt>
                <c:pt idx="586">
                  <c:v>1.6666666666666665</c:v>
                </c:pt>
                <c:pt idx="587">
                  <c:v>1.1111111111111112</c:v>
                </c:pt>
                <c:pt idx="588">
                  <c:v>1.1111111111111112</c:v>
                </c:pt>
                <c:pt idx="589">
                  <c:v>1.1111111111111112</c:v>
                </c:pt>
                <c:pt idx="590">
                  <c:v>1.1111111111111112</c:v>
                </c:pt>
                <c:pt idx="591">
                  <c:v>0.55555555555555558</c:v>
                </c:pt>
                <c:pt idx="592">
                  <c:v>0.55555555555555558</c:v>
                </c:pt>
                <c:pt idx="593">
                  <c:v>1.1111111111111112</c:v>
                </c:pt>
                <c:pt idx="594">
                  <c:v>1.1111111111111112</c:v>
                </c:pt>
                <c:pt idx="595">
                  <c:v>0.55555555555555558</c:v>
                </c:pt>
                <c:pt idx="596">
                  <c:v>0.55555555555555558</c:v>
                </c:pt>
                <c:pt idx="597">
                  <c:v>1.1111111111111112</c:v>
                </c:pt>
                <c:pt idx="598">
                  <c:v>1.1111111111111112</c:v>
                </c:pt>
                <c:pt idx="599">
                  <c:v>1.1111111111111112</c:v>
                </c:pt>
                <c:pt idx="600">
                  <c:v>1.1111111111111112</c:v>
                </c:pt>
                <c:pt idx="601">
                  <c:v>1.1111111111111112</c:v>
                </c:pt>
                <c:pt idx="602">
                  <c:v>1.1111111111111112</c:v>
                </c:pt>
                <c:pt idx="603">
                  <c:v>1.1111111111111112</c:v>
                </c:pt>
                <c:pt idx="604">
                  <c:v>1.1111111111111112</c:v>
                </c:pt>
                <c:pt idx="605">
                  <c:v>0.55555555555555558</c:v>
                </c:pt>
                <c:pt idx="606">
                  <c:v>0</c:v>
                </c:pt>
                <c:pt idx="607">
                  <c:v>-0.55555555555555558</c:v>
                </c:pt>
                <c:pt idx="608">
                  <c:v>-0.55555555555555558</c:v>
                </c:pt>
                <c:pt idx="609">
                  <c:v>-0.55555555555555558</c:v>
                </c:pt>
                <c:pt idx="610">
                  <c:v>-0.55555555555555558</c:v>
                </c:pt>
                <c:pt idx="611">
                  <c:v>0</c:v>
                </c:pt>
                <c:pt idx="612">
                  <c:v>0</c:v>
                </c:pt>
                <c:pt idx="613">
                  <c:v>-0.55555555555555558</c:v>
                </c:pt>
                <c:pt idx="614">
                  <c:v>-0.55555555555555558</c:v>
                </c:pt>
                <c:pt idx="615">
                  <c:v>-0.55555555555555558</c:v>
                </c:pt>
                <c:pt idx="616">
                  <c:v>-0.55555555555555558</c:v>
                </c:pt>
                <c:pt idx="617">
                  <c:v>0</c:v>
                </c:pt>
                <c:pt idx="618">
                  <c:v>0</c:v>
                </c:pt>
                <c:pt idx="619">
                  <c:v>0.55555555555555558</c:v>
                </c:pt>
                <c:pt idx="620">
                  <c:v>0.55555555555555558</c:v>
                </c:pt>
                <c:pt idx="621">
                  <c:v>1.6666666666666665</c:v>
                </c:pt>
                <c:pt idx="622">
                  <c:v>2.7777777777777777</c:v>
                </c:pt>
                <c:pt idx="623">
                  <c:v>3.333333333333333</c:v>
                </c:pt>
                <c:pt idx="624">
                  <c:v>3.8888888888888888</c:v>
                </c:pt>
                <c:pt idx="625">
                  <c:v>4.4444444444444446</c:v>
                </c:pt>
                <c:pt idx="626">
                  <c:v>5</c:v>
                </c:pt>
                <c:pt idx="627">
                  <c:v>5.5555555555555554</c:v>
                </c:pt>
                <c:pt idx="628">
                  <c:v>6.6666666666666661</c:v>
                </c:pt>
                <c:pt idx="629">
                  <c:v>7.7777777777777777</c:v>
                </c:pt>
                <c:pt idx="630">
                  <c:v>8.3333333333333339</c:v>
                </c:pt>
                <c:pt idx="631">
                  <c:v>8.8888888888888893</c:v>
                </c:pt>
                <c:pt idx="632">
                  <c:v>9.4444444444444446</c:v>
                </c:pt>
                <c:pt idx="633">
                  <c:v>9.4444444444444446</c:v>
                </c:pt>
                <c:pt idx="634">
                  <c:v>10</c:v>
                </c:pt>
                <c:pt idx="635">
                  <c:v>10</c:v>
                </c:pt>
                <c:pt idx="636">
                  <c:v>10.555555555555555</c:v>
                </c:pt>
                <c:pt idx="637">
                  <c:v>11.111111111111111</c:v>
                </c:pt>
                <c:pt idx="638">
                  <c:v>11.666666666666666</c:v>
                </c:pt>
                <c:pt idx="639">
                  <c:v>12.777777777777777</c:v>
                </c:pt>
                <c:pt idx="640">
                  <c:v>12.777777777777777</c:v>
                </c:pt>
                <c:pt idx="641">
                  <c:v>13.888888888888889</c:v>
                </c:pt>
                <c:pt idx="642">
                  <c:v>14.444444444444445</c:v>
                </c:pt>
                <c:pt idx="643">
                  <c:v>15</c:v>
                </c:pt>
                <c:pt idx="644">
                  <c:v>15.555555555555555</c:v>
                </c:pt>
                <c:pt idx="645">
                  <c:v>15.555555555555555</c:v>
                </c:pt>
                <c:pt idx="646">
                  <c:v>16.111111111111111</c:v>
                </c:pt>
                <c:pt idx="647">
                  <c:v>16.111111111111111</c:v>
                </c:pt>
                <c:pt idx="648">
                  <c:v>16.666666666666668</c:v>
                </c:pt>
                <c:pt idx="649">
                  <c:v>16.666666666666668</c:v>
                </c:pt>
                <c:pt idx="650">
                  <c:v>17.222222222222221</c:v>
                </c:pt>
                <c:pt idx="651">
                  <c:v>16.666666666666668</c:v>
                </c:pt>
                <c:pt idx="652">
                  <c:v>16.111111111111111</c:v>
                </c:pt>
                <c:pt idx="653">
                  <c:v>15.555555555555555</c:v>
                </c:pt>
                <c:pt idx="654">
                  <c:v>15.555555555555555</c:v>
                </c:pt>
                <c:pt idx="655">
                  <c:v>16.111111111111111</c:v>
                </c:pt>
                <c:pt idx="656">
                  <c:v>16.111111111111111</c:v>
                </c:pt>
                <c:pt idx="657">
                  <c:v>16.666666666666668</c:v>
                </c:pt>
                <c:pt idx="658">
                  <c:v>16.111111111111111</c:v>
                </c:pt>
                <c:pt idx="659">
                  <c:v>16.666666666666668</c:v>
                </c:pt>
                <c:pt idx="660">
                  <c:v>17.222222222222221</c:v>
                </c:pt>
                <c:pt idx="661">
                  <c:v>17.777777777777779</c:v>
                </c:pt>
                <c:pt idx="662">
                  <c:v>17.777777777777779</c:v>
                </c:pt>
                <c:pt idx="663">
                  <c:v>17.777777777777779</c:v>
                </c:pt>
                <c:pt idx="664">
                  <c:v>17.222222222222221</c:v>
                </c:pt>
                <c:pt idx="665">
                  <c:v>17.222222222222221</c:v>
                </c:pt>
                <c:pt idx="666">
                  <c:v>17.777777777777779</c:v>
                </c:pt>
                <c:pt idx="667">
                  <c:v>17.777777777777779</c:v>
                </c:pt>
                <c:pt idx="668">
                  <c:v>17.777777777777779</c:v>
                </c:pt>
                <c:pt idx="669">
                  <c:v>17.777777777777779</c:v>
                </c:pt>
                <c:pt idx="670">
                  <c:v>17.777777777777779</c:v>
                </c:pt>
                <c:pt idx="671">
                  <c:v>17.777777777777779</c:v>
                </c:pt>
                <c:pt idx="672">
                  <c:v>17.222222222222221</c:v>
                </c:pt>
                <c:pt idx="673">
                  <c:v>17.222222222222221</c:v>
                </c:pt>
                <c:pt idx="674">
                  <c:v>17.222222222222221</c:v>
                </c:pt>
                <c:pt idx="675">
                  <c:v>17.222222222222221</c:v>
                </c:pt>
                <c:pt idx="676">
                  <c:v>17.222222222222221</c:v>
                </c:pt>
                <c:pt idx="677">
                  <c:v>17.222222222222221</c:v>
                </c:pt>
                <c:pt idx="678">
                  <c:v>18.333333333333332</c:v>
                </c:pt>
                <c:pt idx="679">
                  <c:v>18.888888888888889</c:v>
                </c:pt>
                <c:pt idx="680">
                  <c:v>18.888888888888889</c:v>
                </c:pt>
                <c:pt idx="681">
                  <c:v>18.333333333333332</c:v>
                </c:pt>
                <c:pt idx="682">
                  <c:v>17.777777777777779</c:v>
                </c:pt>
                <c:pt idx="683">
                  <c:v>18.333333333333332</c:v>
                </c:pt>
                <c:pt idx="684">
                  <c:v>19.444444444444443</c:v>
                </c:pt>
                <c:pt idx="685">
                  <c:v>20</c:v>
                </c:pt>
                <c:pt idx="686">
                  <c:v>19.444444444444443</c:v>
                </c:pt>
                <c:pt idx="687">
                  <c:v>18.888888888888889</c:v>
                </c:pt>
                <c:pt idx="688">
                  <c:v>18.333333333333332</c:v>
                </c:pt>
                <c:pt idx="689">
                  <c:v>17.777777777777779</c:v>
                </c:pt>
                <c:pt idx="690">
                  <c:v>17.777777777777779</c:v>
                </c:pt>
                <c:pt idx="691">
                  <c:v>17.222222222222221</c:v>
                </c:pt>
                <c:pt idx="692">
                  <c:v>17.222222222222221</c:v>
                </c:pt>
                <c:pt idx="693">
                  <c:v>16.666666666666668</c:v>
                </c:pt>
                <c:pt idx="694">
                  <c:v>16.111111111111111</c:v>
                </c:pt>
                <c:pt idx="695">
                  <c:v>15.555555555555555</c:v>
                </c:pt>
                <c:pt idx="696">
                  <c:v>15</c:v>
                </c:pt>
                <c:pt idx="697">
                  <c:v>14.444444444444445</c:v>
                </c:pt>
                <c:pt idx="698">
                  <c:v>13.888888888888889</c:v>
                </c:pt>
                <c:pt idx="699">
                  <c:v>13.333333333333332</c:v>
                </c:pt>
                <c:pt idx="700">
                  <c:v>13.333333333333332</c:v>
                </c:pt>
                <c:pt idx="701">
                  <c:v>13.333333333333332</c:v>
                </c:pt>
                <c:pt idx="702">
                  <c:v>12.777777777777777</c:v>
                </c:pt>
                <c:pt idx="703">
                  <c:v>12.777777777777777</c:v>
                </c:pt>
                <c:pt idx="704">
                  <c:v>12.777777777777777</c:v>
                </c:pt>
                <c:pt idx="705">
                  <c:v>12.777777777777777</c:v>
                </c:pt>
                <c:pt idx="706">
                  <c:v>12.777777777777777</c:v>
                </c:pt>
                <c:pt idx="707">
                  <c:v>12.777777777777777</c:v>
                </c:pt>
                <c:pt idx="708">
                  <c:v>12.222222222222221</c:v>
                </c:pt>
                <c:pt idx="709">
                  <c:v>12.222222222222221</c:v>
                </c:pt>
                <c:pt idx="710">
                  <c:v>12.222222222222221</c:v>
                </c:pt>
                <c:pt idx="711">
                  <c:v>12.222222222222221</c:v>
                </c:pt>
                <c:pt idx="712">
                  <c:v>12.222222222222221</c:v>
                </c:pt>
                <c:pt idx="713">
                  <c:v>11.666666666666666</c:v>
                </c:pt>
                <c:pt idx="714">
                  <c:v>11.666666666666666</c:v>
                </c:pt>
                <c:pt idx="715">
                  <c:v>11.666666666666666</c:v>
                </c:pt>
                <c:pt idx="716">
                  <c:v>11.666666666666666</c:v>
                </c:pt>
                <c:pt idx="717">
                  <c:v>12.222222222222221</c:v>
                </c:pt>
                <c:pt idx="718">
                  <c:v>12.222222222222221</c:v>
                </c:pt>
                <c:pt idx="719">
                  <c:v>12.22222222222222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73F4-4DD9-BA8C-E9053904953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462273456"/>
        <c:axId val="1017923920"/>
      </c:scatterChart>
      <c:valAx>
        <c:axId val="1462273456"/>
        <c:scaling>
          <c:orientation val="minMax"/>
          <c:max val="43941"/>
          <c:min val="43936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b="1"/>
                  <a:t>Date (2020)</a:t>
                </a:r>
              </a:p>
            </c:rich>
          </c:tx>
          <c:layout>
            <c:manualLayout>
              <c:xMode val="edge"/>
              <c:yMode val="edge"/>
              <c:x val="0.4480423916878401"/>
              <c:y val="0.8336192445860127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m/d;@" sourceLinked="1"/>
        <c:majorTickMark val="in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017923920"/>
        <c:crossesAt val="-10"/>
        <c:crossBetween val="midCat"/>
        <c:majorUnit val="1"/>
      </c:valAx>
      <c:valAx>
        <c:axId val="1017923920"/>
        <c:scaling>
          <c:orientation val="minMax"/>
          <c:max val="20"/>
          <c:min val="-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b="1"/>
                  <a:t>Temperature (°C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0" sourceLinked="0"/>
        <c:majorTickMark val="in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462273456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10830385186021546"/>
          <c:y val="5.6793497015332199E-2"/>
          <c:w val="0.28256351744911928"/>
          <c:h val="0.1304356558452110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2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9605</cdr:x>
      <cdr:y>0.58903</cdr:y>
    </cdr:from>
    <cdr:to>
      <cdr:x>0.95734</cdr:x>
      <cdr:y>0.58903</cdr:y>
    </cdr:to>
    <cdr:cxnSp macro="">
      <cdr:nvCxnSpPr>
        <cdr:cNvPr id="3" name="Straight Connector 2">
          <a:extLst xmlns:a="http://schemas.openxmlformats.org/drawingml/2006/main">
            <a:ext uri="{FF2B5EF4-FFF2-40B4-BE49-F238E27FC236}">
              <a16:creationId xmlns:a16="http://schemas.microsoft.com/office/drawing/2014/main" id="{0AC0230E-AA76-40DB-BC5E-E70E35EC31B0}"/>
            </a:ext>
          </a:extLst>
        </cdr:cNvPr>
        <cdr:cNvCxnSpPr/>
      </cdr:nvCxnSpPr>
      <cdr:spPr>
        <a:xfrm xmlns:a="http://schemas.openxmlformats.org/drawingml/2006/main">
          <a:off x="610335" y="2014173"/>
          <a:ext cx="5473211" cy="0"/>
        </a:xfrm>
        <a:prstGeom xmlns:a="http://schemas.openxmlformats.org/drawingml/2006/main" prst="line">
          <a:avLst/>
        </a:prstGeom>
        <a:ln xmlns:a="http://schemas.openxmlformats.org/drawingml/2006/main" w="15875"/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BCC636-8A45-4FCF-AFDD-AE755CF071E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A173F6D-A00D-40A2-8AD1-8A5DBBBE16A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C1B6197-B011-44C3-91D3-7EAC6EA805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F0D08-22C3-40D4-8EF8-6E2F98D1D8F4}" type="datetimeFigureOut">
              <a:rPr lang="en-US" smtClean="0"/>
              <a:t>6/1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A6BF9AB-A71A-4273-9385-0F9474DD84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A1F2DEC-66E4-4D64-90C3-5D0F100D24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A96118-116D-41BC-BE60-D5FA251985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30299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8AFE3A-05EE-4770-A27C-8DF140E63F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46633D4-D64C-44FC-866C-A421D65AB2C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3D3A7B4-6D9C-461E-9A8C-D87A5C3C3E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F0D08-22C3-40D4-8EF8-6E2F98D1D8F4}" type="datetimeFigureOut">
              <a:rPr lang="en-US" smtClean="0"/>
              <a:t>6/1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F9D90A3-BDA9-4C53-913E-B8BB84EC01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28E054-AE00-4639-89B8-220ED9B7AB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A96118-116D-41BC-BE60-D5FA251985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81297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2858054-5226-48F8-8E1E-C8B6E032B80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8284D62-9F21-4DC1-83A2-98DA7A1C4B7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A19E8C2-F921-46CF-BA47-F845E3CEC8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F0D08-22C3-40D4-8EF8-6E2F98D1D8F4}" type="datetimeFigureOut">
              <a:rPr lang="en-US" smtClean="0"/>
              <a:t>6/1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3A9662-F733-459D-933A-BE2E319FA9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61BDC4-77B3-4E05-BFC6-0B8BC30557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A96118-116D-41BC-BE60-D5FA251985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14457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F3E80E-6191-4330-BBB3-84E3D91FB4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8807439-D399-46D9-8D3A-BB740A54F34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CDADC6B-421C-4743-96FB-43040C1A4A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F0D08-22C3-40D4-8EF8-6E2F98D1D8F4}" type="datetimeFigureOut">
              <a:rPr lang="en-US" smtClean="0"/>
              <a:t>6/1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0B4CDCA-9B0D-4DBF-BC82-E6D0147195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06B9E1E-0F9F-4409-B6AD-2732A0D2B1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A96118-116D-41BC-BE60-D5FA251985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50331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8B1FA4-ABA0-4BEF-9603-52896BD84E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5D7EBCF-06E0-456B-A86F-C0040ECA64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4929A2-8741-4997-A34D-CE34CEC3FD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F0D08-22C3-40D4-8EF8-6E2F98D1D8F4}" type="datetimeFigureOut">
              <a:rPr lang="en-US" smtClean="0"/>
              <a:t>6/1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BBC5BE1-AB92-4B40-9A0C-A3AD693802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A37B05-7B44-4FAB-A4A1-E555323836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A96118-116D-41BC-BE60-D5FA251985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59908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53A24C-4285-47E5-BD6D-2E1A4E6BFE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B7A0623-DD9A-4FF4-9CBA-BA6530D713B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8F0A51E-A513-45DB-B70D-3EECD7D304C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0D35302-0722-4DBB-9A5E-6B1E5249AD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F0D08-22C3-40D4-8EF8-6E2F98D1D8F4}" type="datetimeFigureOut">
              <a:rPr lang="en-US" smtClean="0"/>
              <a:t>6/16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F09EB04-0122-4028-8A7B-172FB492F3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2F550E1-E370-4534-828F-8491E46F45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A96118-116D-41BC-BE60-D5FA251985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93722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581320-5914-4375-B100-3444DF544A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EDE2EEA-389B-459E-9BEE-60225FA5E9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0EAC44C-A0DB-4627-88D2-96DCC7D4FCA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4174F29-AA83-4916-A0AC-533440E8147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62F94FD-AA58-4D69-9500-5BA271E9565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709DAC8-DECF-415D-9D17-225C90794A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F0D08-22C3-40D4-8EF8-6E2F98D1D8F4}" type="datetimeFigureOut">
              <a:rPr lang="en-US" smtClean="0"/>
              <a:t>6/16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B2C9FB6-1321-49F7-8EE2-7812E54DBD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3067891-91FF-4DE7-BDCD-90FFBE5B42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A96118-116D-41BC-BE60-D5FA251985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91515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C0F7EA-45A3-4CAA-BE9A-57B3754D41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C58FFCE-80A6-4161-A076-51A994FC4E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F0D08-22C3-40D4-8EF8-6E2F98D1D8F4}" type="datetimeFigureOut">
              <a:rPr lang="en-US" smtClean="0"/>
              <a:t>6/16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0DA02E3-95B4-49F3-849A-931D701524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1BE9334-9DAA-412A-A3D4-739D6EE3E0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A96118-116D-41BC-BE60-D5FA251985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45505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9D555CE-EEA5-43E9-A1DD-7C5BFBB2A1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F0D08-22C3-40D4-8EF8-6E2F98D1D8F4}" type="datetimeFigureOut">
              <a:rPr lang="en-US" smtClean="0"/>
              <a:t>6/16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9A601C5-1550-4F9F-9D15-970D29E4CF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96B1C23-7962-459A-B8B0-D403BD8D03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A96118-116D-41BC-BE60-D5FA251985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6276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804123-CB0A-45E7-ABA7-8718990FCC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480A7B4-916A-4CAA-BB66-623B5F2824E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7C96C4C-FE38-409D-867F-311DF7C3717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379A1D0-8884-42DB-A9B6-74380DDB5B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F0D08-22C3-40D4-8EF8-6E2F98D1D8F4}" type="datetimeFigureOut">
              <a:rPr lang="en-US" smtClean="0"/>
              <a:t>6/16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EC2B4DB-03DA-467D-AD09-D88721DF50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E05360E-C0A4-4304-8621-A4D0A794E0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A96118-116D-41BC-BE60-D5FA251985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52282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4BD534-7032-4DB8-93C5-8825DDC087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C506235-5FD6-4612-8B40-298D765C667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FE63E75-3967-410C-B8DB-FD2006C7608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E100688-65EF-48FF-BB4A-7FDBA440BF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F0D08-22C3-40D4-8EF8-6E2F98D1D8F4}" type="datetimeFigureOut">
              <a:rPr lang="en-US" smtClean="0"/>
              <a:t>6/16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9CF34D7-5FA6-4022-89D3-1D46611F19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7604729-9D55-451B-B0EC-0686C9B23D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A96118-116D-41BC-BE60-D5FA251985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5996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CA7F9A9-97ED-4F3B-8ED5-A32C9A6836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F612E28-EBEE-45DF-88BA-7ADD6836B84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A254B92-4885-4DA4-B430-E1F9CAFDCBF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FF0D08-22C3-40D4-8EF8-6E2F98D1D8F4}" type="datetimeFigureOut">
              <a:rPr lang="en-US" smtClean="0"/>
              <a:t>6/1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1032B57-FF0F-4CEA-B0D9-612CE67CB55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6071EC8-AA01-44AE-A13E-8C2B644B5FE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A96118-116D-41BC-BE60-D5FA251985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30868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.png"/><Relationship Id="rId4" Type="http://schemas.openxmlformats.org/officeDocument/2006/relationships/image" Target="../media/image5.jp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>
            <a:extLst>
              <a:ext uri="{FF2B5EF4-FFF2-40B4-BE49-F238E27FC236}">
                <a16:creationId xmlns:a16="http://schemas.microsoft.com/office/drawing/2014/main" id="{A520B949-86E7-4513-AE3C-A5514EDA0CE2}"/>
              </a:ext>
            </a:extLst>
          </p:cNvPr>
          <p:cNvGrpSpPr/>
          <p:nvPr/>
        </p:nvGrpSpPr>
        <p:grpSpPr>
          <a:xfrm>
            <a:off x="1489753" y="750013"/>
            <a:ext cx="8846049" cy="3811713"/>
            <a:chOff x="1489753" y="750013"/>
            <a:chExt cx="8846049" cy="3811713"/>
          </a:xfrm>
        </p:grpSpPr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D1524781-E8B4-4301-BEDD-49F1597C2FAD}"/>
                </a:ext>
              </a:extLst>
            </p:cNvPr>
            <p:cNvSpPr/>
            <p:nvPr/>
          </p:nvSpPr>
          <p:spPr>
            <a:xfrm>
              <a:off x="1489753" y="750013"/>
              <a:ext cx="8846049" cy="381171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EEE7789A-5038-4C35-81DC-952470F97584}"/>
                </a:ext>
              </a:extLst>
            </p:cNvPr>
            <p:cNvGrpSpPr/>
            <p:nvPr/>
          </p:nvGrpSpPr>
          <p:grpSpPr>
            <a:xfrm>
              <a:off x="1645530" y="841291"/>
              <a:ext cx="8597041" cy="3626099"/>
              <a:chOff x="1645530" y="841291"/>
              <a:chExt cx="8597041" cy="3626099"/>
            </a:xfrm>
          </p:grpSpPr>
          <p:pic>
            <p:nvPicPr>
              <p:cNvPr id="2" name="Picture 1">
                <a:extLst>
                  <a:ext uri="{FF2B5EF4-FFF2-40B4-BE49-F238E27FC236}">
                    <a16:creationId xmlns:a16="http://schemas.microsoft.com/office/drawing/2014/main" id="{B0A8DD4E-24F8-43D1-8172-B8121FDCF93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6647107" y="850625"/>
                <a:ext cx="3595464" cy="3616765"/>
              </a:xfrm>
              <a:prstGeom prst="rect">
                <a:avLst/>
              </a:prstGeom>
            </p:spPr>
          </p:pic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id="{073AD20C-D224-4CBB-88EE-4BDE4405050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645530" y="841291"/>
                <a:ext cx="4834799" cy="3626099"/>
              </a:xfrm>
              <a:prstGeom prst="rect">
                <a:avLst/>
              </a:prstGeom>
            </p:spPr>
          </p:pic>
          <p:sp>
            <p:nvSpPr>
              <p:cNvPr id="4" name="TextBox 3">
                <a:extLst>
                  <a:ext uri="{FF2B5EF4-FFF2-40B4-BE49-F238E27FC236}">
                    <a16:creationId xmlns:a16="http://schemas.microsoft.com/office/drawing/2014/main" id="{4AEA19DA-03F8-43AD-BD93-29785492E127}"/>
                  </a:ext>
                </a:extLst>
              </p:cNvPr>
              <p:cNvSpPr txBox="1"/>
              <p:nvPr/>
            </p:nvSpPr>
            <p:spPr>
              <a:xfrm>
                <a:off x="3745213" y="841291"/>
                <a:ext cx="317716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000" b="1" dirty="0">
                    <a:solidFill>
                      <a:schemeClr val="bg1"/>
                    </a:solidFill>
                  </a:rPr>
                  <a:t>A</a:t>
                </a:r>
              </a:p>
            </p:txBody>
          </p:sp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EC39AFB9-0B87-47C3-9AB2-94D3E2FA3604}"/>
                  </a:ext>
                </a:extLst>
              </p:cNvPr>
              <p:cNvSpPr txBox="1"/>
              <p:nvPr/>
            </p:nvSpPr>
            <p:spPr>
              <a:xfrm>
                <a:off x="8421154" y="841291"/>
                <a:ext cx="317716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000" b="1" dirty="0">
                    <a:solidFill>
                      <a:schemeClr val="bg1"/>
                    </a:solidFill>
                  </a:rPr>
                  <a:t>B</a:t>
                </a:r>
              </a:p>
            </p:txBody>
          </p:sp>
        </p:grpSp>
      </p:grpSp>
      <p:sp>
        <p:nvSpPr>
          <p:cNvPr id="11" name="Content Placeholder 2">
            <a:extLst>
              <a:ext uri="{FF2B5EF4-FFF2-40B4-BE49-F238E27FC236}">
                <a16:creationId xmlns:a16="http://schemas.microsoft.com/office/drawing/2014/main" id="{F6ADA5AA-A436-42BD-B05E-6DC6B89C61BB}"/>
              </a:ext>
            </a:extLst>
          </p:cNvPr>
          <p:cNvSpPr txBox="1">
            <a:spLocks/>
          </p:cNvSpPr>
          <p:nvPr/>
        </p:nvSpPr>
        <p:spPr>
          <a:xfrm>
            <a:off x="2389239" y="4892929"/>
            <a:ext cx="7170069" cy="767298"/>
          </a:xfrm>
          <a:prstGeom prst="rect">
            <a:avLst/>
          </a:prstGeom>
        </p:spPr>
        <p:txBody>
          <a:bodyPr vert="horz" lIns="51435" tIns="25718" rIns="51435" bIns="25718" rtlCol="0">
            <a:normAutofit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sz="1400" b="1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Figure S1. </a:t>
            </a:r>
            <a:r>
              <a:rPr lang="en-US" sz="18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Evaluation of ethephon-induced injury on peach trees</a:t>
            </a:r>
            <a:endParaRPr lang="en-US" sz="4400" dirty="0"/>
          </a:p>
          <a:p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76244323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D4322A7E-BA78-4FD8-84C4-584CD9FD1561}"/>
              </a:ext>
            </a:extLst>
          </p:cNvPr>
          <p:cNvGrpSpPr/>
          <p:nvPr/>
        </p:nvGrpSpPr>
        <p:grpSpPr>
          <a:xfrm>
            <a:off x="92639" y="56477"/>
            <a:ext cx="6325498" cy="6745045"/>
            <a:chOff x="1579045" y="749300"/>
            <a:chExt cx="7666555" cy="9055100"/>
          </a:xfrm>
        </p:grpSpPr>
        <p:sp>
          <p:nvSpPr>
            <p:cNvPr id="3" name="Rectangle 2">
              <a:extLst>
                <a:ext uri="{FF2B5EF4-FFF2-40B4-BE49-F238E27FC236}">
                  <a16:creationId xmlns:a16="http://schemas.microsoft.com/office/drawing/2014/main" id="{5A8FCCB5-636C-4592-8D53-0CA8AE396603}"/>
                </a:ext>
              </a:extLst>
            </p:cNvPr>
            <p:cNvSpPr/>
            <p:nvPr/>
          </p:nvSpPr>
          <p:spPr>
            <a:xfrm>
              <a:off x="1579045" y="749300"/>
              <a:ext cx="7666555" cy="90551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A41F71F5-86C4-4A28-8CFF-54A66EB6049F}"/>
                </a:ext>
              </a:extLst>
            </p:cNvPr>
            <p:cNvGrpSpPr/>
            <p:nvPr/>
          </p:nvGrpSpPr>
          <p:grpSpPr>
            <a:xfrm>
              <a:off x="1796475" y="950665"/>
              <a:ext cx="7142107" cy="8596568"/>
              <a:chOff x="1796475" y="950665"/>
              <a:chExt cx="7142107" cy="8596568"/>
            </a:xfrm>
          </p:grpSpPr>
          <p:grpSp>
            <p:nvGrpSpPr>
              <p:cNvPr id="5" name="Group 4">
                <a:extLst>
                  <a:ext uri="{FF2B5EF4-FFF2-40B4-BE49-F238E27FC236}">
                    <a16:creationId xmlns:a16="http://schemas.microsoft.com/office/drawing/2014/main" id="{F4841187-B4C6-4220-BA16-BCC0D4D4ABA6}"/>
                  </a:ext>
                </a:extLst>
              </p:cNvPr>
              <p:cNvGrpSpPr/>
              <p:nvPr/>
            </p:nvGrpSpPr>
            <p:grpSpPr>
              <a:xfrm>
                <a:off x="1796475" y="950665"/>
                <a:ext cx="7142107" cy="3096493"/>
                <a:chOff x="1796475" y="950665"/>
                <a:chExt cx="7142107" cy="3096493"/>
              </a:xfrm>
            </p:grpSpPr>
            <p:pic>
              <p:nvPicPr>
                <p:cNvPr id="9" name="Picture 8" descr="A picture containing white, sitting, old, kitchen&#10;&#10;Description automatically generated">
                  <a:extLst>
                    <a:ext uri="{FF2B5EF4-FFF2-40B4-BE49-F238E27FC236}">
                      <a16:creationId xmlns:a16="http://schemas.microsoft.com/office/drawing/2014/main" id="{06D721C2-DB8F-488C-86FE-8721147E952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 rot="5400000">
                  <a:off x="1412427" y="1334713"/>
                  <a:ext cx="3072384" cy="2304288"/>
                </a:xfrm>
                <a:prstGeom prst="rect">
                  <a:avLst/>
                </a:prstGeom>
                <a:ln>
                  <a:noFill/>
                </a:ln>
              </p:spPr>
            </p:pic>
            <p:pic>
              <p:nvPicPr>
                <p:cNvPr id="10" name="Picture 9" descr="A picture containing indoor, sitting, white, small&#10;&#10;Description automatically generated">
                  <a:extLst>
                    <a:ext uri="{FF2B5EF4-FFF2-40B4-BE49-F238E27FC236}">
                      <a16:creationId xmlns:a16="http://schemas.microsoft.com/office/drawing/2014/main" id="{148E885E-BCA4-4813-AD82-F2BA9321C53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 rot="5400000">
                  <a:off x="6250246" y="1358822"/>
                  <a:ext cx="3072384" cy="2304288"/>
                </a:xfrm>
                <a:prstGeom prst="rect">
                  <a:avLst/>
                </a:prstGeom>
                <a:ln>
                  <a:noFill/>
                </a:ln>
              </p:spPr>
            </p:pic>
            <p:pic>
              <p:nvPicPr>
                <p:cNvPr id="11" name="Picture 10" descr="A picture containing building, sitting, small, table&#10;&#10;Description automatically generated">
                  <a:extLst>
                    <a:ext uri="{FF2B5EF4-FFF2-40B4-BE49-F238E27FC236}">
                      <a16:creationId xmlns:a16="http://schemas.microsoft.com/office/drawing/2014/main" id="{1E7C3FFE-F1AC-4398-8720-90DEA97E628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 rot="5400000">
                  <a:off x="3878836" y="1343028"/>
                  <a:ext cx="3072384" cy="2304288"/>
                </a:xfrm>
                <a:prstGeom prst="rect">
                  <a:avLst/>
                </a:prstGeom>
                <a:ln>
                  <a:noFill/>
                </a:ln>
              </p:spPr>
            </p:pic>
            <p:sp>
              <p:nvSpPr>
                <p:cNvPr id="12" name="TextBox 11">
                  <a:extLst>
                    <a:ext uri="{FF2B5EF4-FFF2-40B4-BE49-F238E27FC236}">
                      <a16:creationId xmlns:a16="http://schemas.microsoft.com/office/drawing/2014/main" id="{40305FB6-C37F-47F7-8C36-885D2AC869FD}"/>
                    </a:ext>
                  </a:extLst>
                </p:cNvPr>
                <p:cNvSpPr txBox="1"/>
                <p:nvPr/>
              </p:nvSpPr>
              <p:spPr>
                <a:xfrm>
                  <a:off x="2789761" y="974774"/>
                  <a:ext cx="317716" cy="369332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>
                      <a:solidFill>
                        <a:schemeClr val="bg1"/>
                      </a:solidFill>
                    </a:rPr>
                    <a:t>A</a:t>
                  </a:r>
                </a:p>
              </p:txBody>
            </p:sp>
            <p:sp>
              <p:nvSpPr>
                <p:cNvPr id="13" name="TextBox 12">
                  <a:extLst>
                    <a:ext uri="{FF2B5EF4-FFF2-40B4-BE49-F238E27FC236}">
                      <a16:creationId xmlns:a16="http://schemas.microsoft.com/office/drawing/2014/main" id="{A2E7D087-BC51-4450-99C5-0F7A7BFC17F2}"/>
                    </a:ext>
                  </a:extLst>
                </p:cNvPr>
                <p:cNvSpPr txBox="1"/>
                <p:nvPr/>
              </p:nvSpPr>
              <p:spPr>
                <a:xfrm>
                  <a:off x="5260178" y="958980"/>
                  <a:ext cx="309700" cy="369332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>
                      <a:solidFill>
                        <a:schemeClr val="bg1"/>
                      </a:solidFill>
                    </a:rPr>
                    <a:t>B</a:t>
                  </a:r>
                </a:p>
              </p:txBody>
            </p:sp>
            <p:sp>
              <p:nvSpPr>
                <p:cNvPr id="14" name="TextBox 13">
                  <a:extLst>
                    <a:ext uri="{FF2B5EF4-FFF2-40B4-BE49-F238E27FC236}">
                      <a16:creationId xmlns:a16="http://schemas.microsoft.com/office/drawing/2014/main" id="{8F5D9887-D842-4C2C-8BF0-DA45418DFA29}"/>
                    </a:ext>
                  </a:extLst>
                </p:cNvPr>
                <p:cNvSpPr txBox="1"/>
                <p:nvPr/>
              </p:nvSpPr>
              <p:spPr>
                <a:xfrm>
                  <a:off x="7632389" y="974774"/>
                  <a:ext cx="308098" cy="369332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>
                      <a:solidFill>
                        <a:schemeClr val="bg1"/>
                      </a:solidFill>
                    </a:rPr>
                    <a:t>C</a:t>
                  </a:r>
                </a:p>
              </p:txBody>
            </p:sp>
          </p:grpSp>
          <p:grpSp>
            <p:nvGrpSpPr>
              <p:cNvPr id="6" name="Group 5">
                <a:extLst>
                  <a:ext uri="{FF2B5EF4-FFF2-40B4-BE49-F238E27FC236}">
                    <a16:creationId xmlns:a16="http://schemas.microsoft.com/office/drawing/2014/main" id="{87BB530E-08DC-49CA-8168-20F0898689AA}"/>
                  </a:ext>
                </a:extLst>
              </p:cNvPr>
              <p:cNvGrpSpPr/>
              <p:nvPr/>
            </p:nvGrpSpPr>
            <p:grpSpPr>
              <a:xfrm>
                <a:off x="1796475" y="4168767"/>
                <a:ext cx="7142107" cy="5378466"/>
                <a:chOff x="1796475" y="4168767"/>
                <a:chExt cx="7142107" cy="5378466"/>
              </a:xfrm>
            </p:grpSpPr>
            <p:pic>
              <p:nvPicPr>
                <p:cNvPr id="7" name="Picture 6">
                  <a:extLst>
                    <a:ext uri="{FF2B5EF4-FFF2-40B4-BE49-F238E27FC236}">
                      <a16:creationId xmlns:a16="http://schemas.microsoft.com/office/drawing/2014/main" id="{9D7A2B78-A3DA-4075-A7B5-0EA4A7792EA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5"/>
                <a:srcRect l="21161" t="12681" r="20811" b="17399"/>
                <a:stretch/>
              </p:blipFill>
              <p:spPr>
                <a:xfrm>
                  <a:off x="1796475" y="4168767"/>
                  <a:ext cx="7142107" cy="5378466"/>
                </a:xfrm>
                <a:prstGeom prst="rect">
                  <a:avLst/>
                </a:prstGeom>
              </p:spPr>
            </p:pic>
            <p:sp>
              <p:nvSpPr>
                <p:cNvPr id="8" name="TextBox 7">
                  <a:extLst>
                    <a:ext uri="{FF2B5EF4-FFF2-40B4-BE49-F238E27FC236}">
                      <a16:creationId xmlns:a16="http://schemas.microsoft.com/office/drawing/2014/main" id="{C0B26F32-2BA5-4043-A43D-3C982F14F6EB}"/>
                    </a:ext>
                  </a:extLst>
                </p:cNvPr>
                <p:cNvSpPr txBox="1"/>
                <p:nvPr/>
              </p:nvSpPr>
              <p:spPr>
                <a:xfrm>
                  <a:off x="5203861" y="4557021"/>
                  <a:ext cx="327334" cy="369332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>
                      <a:solidFill>
                        <a:schemeClr val="bg1"/>
                      </a:solidFill>
                    </a:rPr>
                    <a:t>D</a:t>
                  </a:r>
                </a:p>
              </p:txBody>
            </p:sp>
          </p:grpSp>
        </p:grpSp>
      </p:grpSp>
      <p:sp>
        <p:nvSpPr>
          <p:cNvPr id="15" name="Title 1">
            <a:extLst>
              <a:ext uri="{FF2B5EF4-FFF2-40B4-BE49-F238E27FC236}">
                <a16:creationId xmlns:a16="http://schemas.microsoft.com/office/drawing/2014/main" id="{2FEBB223-C1F0-4300-9B34-B89B767F7A12}"/>
              </a:ext>
            </a:extLst>
          </p:cNvPr>
          <p:cNvSpPr txBox="1">
            <a:spLocks/>
          </p:cNvSpPr>
          <p:nvPr/>
        </p:nvSpPr>
        <p:spPr>
          <a:xfrm>
            <a:off x="6817247" y="1020994"/>
            <a:ext cx="4068467" cy="2260521"/>
          </a:xfrm>
          <a:prstGeom prst="rect">
            <a:avLst/>
          </a:prstGeom>
        </p:spPr>
        <p:txBody>
          <a:bodyPr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2.</a:t>
            </a:r>
            <a:r>
              <a:rPr lang="ro-RO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8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Low Temperature Exotherm (LTE) analysis of cold hardiness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b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</a:b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545800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>
            <a:extLst>
              <a:ext uri="{FF2B5EF4-FFF2-40B4-BE49-F238E27FC236}">
                <a16:creationId xmlns:a16="http://schemas.microsoft.com/office/drawing/2014/main" id="{487FC4C1-EB66-4E48-8822-5CAA74549D42}"/>
              </a:ext>
            </a:extLst>
          </p:cNvPr>
          <p:cNvGrpSpPr/>
          <p:nvPr/>
        </p:nvGrpSpPr>
        <p:grpSpPr>
          <a:xfrm>
            <a:off x="2231680" y="621323"/>
            <a:ext cx="7491046" cy="5169877"/>
            <a:chOff x="2286000" y="621323"/>
            <a:chExt cx="7491046" cy="5169877"/>
          </a:xfrm>
        </p:grpSpPr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4FC76BD7-EA1E-4453-9A5A-0A946691F9DD}"/>
                </a:ext>
              </a:extLst>
            </p:cNvPr>
            <p:cNvSpPr/>
            <p:nvPr/>
          </p:nvSpPr>
          <p:spPr>
            <a:xfrm>
              <a:off x="2286000" y="621323"/>
              <a:ext cx="7491046" cy="516987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" name="Content Placeholder 2">
              <a:extLst>
                <a:ext uri="{FF2B5EF4-FFF2-40B4-BE49-F238E27FC236}">
                  <a16:creationId xmlns:a16="http://schemas.microsoft.com/office/drawing/2014/main" id="{99411515-C914-40EC-A9D0-4243C6C9D285}"/>
                </a:ext>
              </a:extLst>
            </p:cNvPr>
            <p:cNvSpPr txBox="1">
              <a:spLocks/>
            </p:cNvSpPr>
            <p:nvPr/>
          </p:nvSpPr>
          <p:spPr>
            <a:xfrm>
              <a:off x="2528914" y="4858581"/>
              <a:ext cx="7035256" cy="767298"/>
            </a:xfrm>
            <a:prstGeom prst="rect">
              <a:avLst/>
            </a:prstGeom>
          </p:spPr>
          <p:txBody>
            <a:bodyPr vert="horz" lIns="51435" tIns="25718" rIns="51435" bIns="25718" rtlCol="0">
              <a:normAutofit/>
            </a:bodyPr>
            <a:lstStyle>
              <a:lvl1pPr marL="0" indent="0" algn="ctr" defTabSz="914400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None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l"/>
              <a:r>
                <a:rPr lang="en-US" sz="1400" b="1" dirty="0">
                  <a:latin typeface="Arial" panose="020B0604020202020204" pitchFamily="34" charset="0"/>
                  <a:ea typeface="+mj-ea"/>
                  <a:cs typeface="Arial" panose="020B0604020202020204" pitchFamily="34" charset="0"/>
                </a:rPr>
                <a:t>Figure S3.</a:t>
              </a:r>
              <a:r>
                <a:rPr lang="ro-RO" sz="1400" b="1" dirty="0">
                  <a:latin typeface="Arial" panose="020B0604020202020204" pitchFamily="34" charset="0"/>
                  <a:ea typeface="+mj-ea"/>
                  <a:cs typeface="Arial" panose="020B0604020202020204" pitchFamily="34" charset="0"/>
                </a:rPr>
                <a:t> </a:t>
              </a:r>
              <a:r>
                <a:rPr lang="en-US" sz="1400" dirty="0">
                  <a:effectLst/>
                  <a:latin typeface="Calibri" panose="020F0502020204030204" pitchFamily="34" charset="0"/>
                  <a:ea typeface="DengXian" panose="02010600030101010101" pitchFamily="2" charset="-122"/>
                  <a:cs typeface="Times New Roman" panose="02020603050405020304" pitchFamily="18" charset="0"/>
                </a:rPr>
                <a:t>Temperatures 2 weeks after full bloom in the orchards of ‘</a:t>
              </a:r>
              <a:r>
                <a:rPr lang="en-US" sz="1400" dirty="0" err="1">
                  <a:effectLst/>
                  <a:latin typeface="Calibri" panose="020F0502020204030204" pitchFamily="34" charset="0"/>
                  <a:ea typeface="DengXian" panose="02010600030101010101" pitchFamily="2" charset="-122"/>
                  <a:cs typeface="Times New Roman" panose="02020603050405020304" pitchFamily="18" charset="0"/>
                </a:rPr>
                <a:t>Redhaven</a:t>
              </a:r>
              <a:r>
                <a:rPr lang="en-US" sz="1400" dirty="0">
                  <a:effectLst/>
                  <a:latin typeface="Calibri" panose="020F0502020204030204" pitchFamily="34" charset="0"/>
                  <a:ea typeface="DengXian" panose="02010600030101010101" pitchFamily="2" charset="-122"/>
                  <a:cs typeface="Times New Roman" panose="02020603050405020304" pitchFamily="18" charset="0"/>
                </a:rPr>
                <a:t>’ and ‘</a:t>
              </a:r>
              <a:r>
                <a:rPr lang="en-US" sz="1400" dirty="0" err="1">
                  <a:effectLst/>
                  <a:latin typeface="Calibri" panose="020F0502020204030204" pitchFamily="34" charset="0"/>
                  <a:ea typeface="DengXian" panose="02010600030101010101" pitchFamily="2" charset="-122"/>
                  <a:cs typeface="Times New Roman" panose="02020603050405020304" pitchFamily="18" charset="0"/>
                </a:rPr>
                <a:t>Sunhigh</a:t>
              </a:r>
              <a:r>
                <a:rPr lang="en-US" sz="1400" dirty="0">
                  <a:effectLst/>
                  <a:latin typeface="Calibri" panose="020F0502020204030204" pitchFamily="34" charset="0"/>
                  <a:ea typeface="DengXian" panose="02010600030101010101" pitchFamily="2" charset="-122"/>
                  <a:cs typeface="Times New Roman" panose="02020603050405020304" pitchFamily="18" charset="0"/>
                </a:rPr>
                <a:t>’</a:t>
              </a:r>
              <a:r>
                <a:rPr lang="en-US" sz="1400" b="1" dirty="0">
                  <a:latin typeface="Arial" panose="020B0604020202020204" pitchFamily="34" charset="0"/>
                  <a:ea typeface="+mj-ea"/>
                  <a:cs typeface="Arial" panose="020B0604020202020204" pitchFamily="34" charset="0"/>
                </a:rPr>
                <a:t> </a:t>
              </a:r>
              <a:endParaRPr lang="en-US" sz="4400" dirty="0"/>
            </a:p>
            <a:p>
              <a:endParaRPr lang="en-US" sz="1400" dirty="0"/>
            </a:p>
          </p:txBody>
        </p:sp>
      </p:grpSp>
      <p:grpSp>
        <p:nvGrpSpPr>
          <p:cNvPr id="18" name="Group 17">
            <a:extLst>
              <a:ext uri="{FF2B5EF4-FFF2-40B4-BE49-F238E27FC236}">
                <a16:creationId xmlns:a16="http://schemas.microsoft.com/office/drawing/2014/main" id="{D82D9B8C-CB78-4A0B-96E6-05A65B040196}"/>
              </a:ext>
            </a:extLst>
          </p:cNvPr>
          <p:cNvGrpSpPr/>
          <p:nvPr/>
        </p:nvGrpSpPr>
        <p:grpSpPr>
          <a:xfrm>
            <a:off x="2688849" y="1273785"/>
            <a:ext cx="6354642" cy="3419476"/>
            <a:chOff x="2688849" y="1273785"/>
            <a:chExt cx="6354642" cy="3419476"/>
          </a:xfrm>
        </p:grpSpPr>
        <p:graphicFrame>
          <p:nvGraphicFramePr>
            <p:cNvPr id="13" name="Chart 12">
              <a:extLst>
                <a:ext uri="{FF2B5EF4-FFF2-40B4-BE49-F238E27FC236}">
                  <a16:creationId xmlns:a16="http://schemas.microsoft.com/office/drawing/2014/main" id="{EEB6D714-5984-4BB6-A707-C08E3F5D4720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2688849" y="1273785"/>
            <a:ext cx="6354642" cy="341947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cxnSp>
          <p:nvCxnSpPr>
            <p:cNvPr id="14" name="Straight Arrow Connector 13">
              <a:extLst>
                <a:ext uri="{FF2B5EF4-FFF2-40B4-BE49-F238E27FC236}">
                  <a16:creationId xmlns:a16="http://schemas.microsoft.com/office/drawing/2014/main" id="{70DD12A5-D63C-43DD-A44F-CC7B464AA49E}"/>
                </a:ext>
              </a:extLst>
            </p:cNvPr>
            <p:cNvCxnSpPr/>
            <p:nvPr/>
          </p:nvCxnSpPr>
          <p:spPr>
            <a:xfrm flipH="1" flipV="1">
              <a:off x="3654177" y="3366721"/>
              <a:ext cx="175846" cy="124557"/>
            </a:xfrm>
            <a:prstGeom prst="straightConnector1">
              <a:avLst/>
            </a:prstGeom>
            <a:ln w="12700">
              <a:solidFill>
                <a:srgbClr val="C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Arrow Connector 14">
              <a:extLst>
                <a:ext uri="{FF2B5EF4-FFF2-40B4-BE49-F238E27FC236}">
                  <a16:creationId xmlns:a16="http://schemas.microsoft.com/office/drawing/2014/main" id="{6FA373D0-CF3C-45DC-BCC3-84275FD0EEE7}"/>
                </a:ext>
              </a:extLst>
            </p:cNvPr>
            <p:cNvCxnSpPr/>
            <p:nvPr/>
          </p:nvCxnSpPr>
          <p:spPr>
            <a:xfrm flipH="1" flipV="1">
              <a:off x="5904299" y="3446237"/>
              <a:ext cx="175846" cy="124557"/>
            </a:xfrm>
            <a:prstGeom prst="straightConnector1">
              <a:avLst/>
            </a:prstGeom>
            <a:ln w="12700">
              <a:solidFill>
                <a:srgbClr val="C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Arrow Connector 15">
              <a:extLst>
                <a:ext uri="{FF2B5EF4-FFF2-40B4-BE49-F238E27FC236}">
                  <a16:creationId xmlns:a16="http://schemas.microsoft.com/office/drawing/2014/main" id="{21C767E5-ABBC-4095-8653-E2E991F5A47D}"/>
                </a:ext>
              </a:extLst>
            </p:cNvPr>
            <p:cNvCxnSpPr/>
            <p:nvPr/>
          </p:nvCxnSpPr>
          <p:spPr>
            <a:xfrm flipH="1" flipV="1">
              <a:off x="8036460" y="3442734"/>
              <a:ext cx="175846" cy="124557"/>
            </a:xfrm>
            <a:prstGeom prst="straightConnector1">
              <a:avLst/>
            </a:prstGeom>
            <a:ln w="12700">
              <a:solidFill>
                <a:srgbClr val="C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18120432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47C65DD2-426F-4472-AAC1-F9F20FC3EA01}"/>
              </a:ext>
            </a:extLst>
          </p:cNvPr>
          <p:cNvSpPr/>
          <p:nvPr/>
        </p:nvSpPr>
        <p:spPr>
          <a:xfrm>
            <a:off x="247650" y="66675"/>
            <a:ext cx="7658100" cy="679132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DDD981D5-245D-47BB-BEB1-E686B9C30551}"/>
              </a:ext>
            </a:extLst>
          </p:cNvPr>
          <p:cNvGraphicFramePr>
            <a:graphicFrameLocks noGrp="1"/>
          </p:cNvGraphicFramePr>
          <p:nvPr/>
        </p:nvGraphicFramePr>
        <p:xfrm>
          <a:off x="769827" y="558097"/>
          <a:ext cx="6756386" cy="5852742"/>
        </p:xfrm>
        <a:graphic>
          <a:graphicData uri="http://schemas.openxmlformats.org/drawingml/2006/table">
            <a:tbl>
              <a:tblPr/>
              <a:tblGrid>
                <a:gridCol w="535822">
                  <a:extLst>
                    <a:ext uri="{9D8B030D-6E8A-4147-A177-3AD203B41FA5}">
                      <a16:colId xmlns:a16="http://schemas.microsoft.com/office/drawing/2014/main" val="500783210"/>
                    </a:ext>
                  </a:extLst>
                </a:gridCol>
                <a:gridCol w="736757">
                  <a:extLst>
                    <a:ext uri="{9D8B030D-6E8A-4147-A177-3AD203B41FA5}">
                      <a16:colId xmlns:a16="http://schemas.microsoft.com/office/drawing/2014/main" val="1824408045"/>
                    </a:ext>
                  </a:extLst>
                </a:gridCol>
                <a:gridCol w="1931193">
                  <a:extLst>
                    <a:ext uri="{9D8B030D-6E8A-4147-A177-3AD203B41FA5}">
                      <a16:colId xmlns:a16="http://schemas.microsoft.com/office/drawing/2014/main" val="2743343580"/>
                    </a:ext>
                  </a:extLst>
                </a:gridCol>
                <a:gridCol w="1719097">
                  <a:extLst>
                    <a:ext uri="{9D8B030D-6E8A-4147-A177-3AD203B41FA5}">
                      <a16:colId xmlns:a16="http://schemas.microsoft.com/office/drawing/2014/main" val="4162267378"/>
                    </a:ext>
                  </a:extLst>
                </a:gridCol>
                <a:gridCol w="1297695">
                  <a:extLst>
                    <a:ext uri="{9D8B030D-6E8A-4147-A177-3AD203B41FA5}">
                      <a16:colId xmlns:a16="http://schemas.microsoft.com/office/drawing/2014/main" val="4157979316"/>
                    </a:ext>
                  </a:extLst>
                </a:gridCol>
                <a:gridCol w="535822">
                  <a:extLst>
                    <a:ext uri="{9D8B030D-6E8A-4147-A177-3AD203B41FA5}">
                      <a16:colId xmlns:a16="http://schemas.microsoft.com/office/drawing/2014/main" val="3283964403"/>
                    </a:ext>
                  </a:extLst>
                </a:gridCol>
              </a:tblGrid>
              <a:tr h="202639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2855038"/>
                  </a:ext>
                </a:extLst>
              </a:tr>
              <a:tr h="414488">
                <a:tc>
                  <a:txBody>
                    <a:bodyPr/>
                    <a:lstStyle/>
                    <a:p>
                      <a:pPr algn="ctr" fontAlgn="ctr"/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ne</a:t>
                      </a:r>
                    </a:p>
                  </a:txBody>
                  <a:tcPr marL="6853" marR="6853" marT="685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scription</a:t>
                      </a:r>
                    </a:p>
                  </a:txBody>
                  <a:tcPr marL="6853" marR="6853" marT="685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orward and reverse primer sequences (5'-3')</a:t>
                      </a:r>
                    </a:p>
                  </a:txBody>
                  <a:tcPr marL="6853" marR="6853" marT="685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cession no. </a:t>
                      </a:r>
                    </a:p>
                  </a:txBody>
                  <a:tcPr marL="6853" marR="6853" marT="685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30689939"/>
                  </a:ext>
                </a:extLst>
              </a:tr>
              <a:tr h="193576">
                <a:tc>
                  <a:txBody>
                    <a:bodyPr/>
                    <a:lstStyle/>
                    <a:p>
                      <a:pPr algn="ctr" fontAlgn="ctr"/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t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T</a:t>
                      </a:r>
                    </a:p>
                  </a:txBody>
                  <a:tcPr marL="6853" marR="6853" marT="685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t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tin</a:t>
                      </a:r>
                    </a:p>
                  </a:txBody>
                  <a:tcPr marL="6853" marR="6853" marT="685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TGTGCTGGACTCTGGTGA</a:t>
                      </a:r>
                    </a:p>
                  </a:txBody>
                  <a:tcPr marL="6853" marR="6853" marT="685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upe.6G163400.1</a:t>
                      </a: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97861733"/>
                  </a:ext>
                </a:extLst>
              </a:tr>
              <a:tr h="193576">
                <a:tc>
                  <a:txBody>
                    <a:bodyPr/>
                    <a:lstStyle/>
                    <a:p>
                      <a:pPr algn="ctr" fontAlgn="ctr"/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AAGGTCCAGACGAAGAA</a:t>
                      </a:r>
                    </a:p>
                  </a:txBody>
                  <a:tcPr marL="6853" marR="6853" marT="6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96830456"/>
                  </a:ext>
                </a:extLst>
              </a:tr>
              <a:tr h="193576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t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O</a:t>
                      </a:r>
                    </a:p>
                  </a:txBody>
                  <a:tcPr marL="6853" marR="6853" marT="6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minocyclopropane-1-Carboxylic Acid (ACC) Oxidase</a:t>
                      </a:r>
                    </a:p>
                  </a:txBody>
                  <a:tcPr marL="6853" marR="6853" marT="6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TGCTGGCCTCAAGTTCC</a:t>
                      </a:r>
                    </a:p>
                  </a:txBody>
                  <a:tcPr marL="6853" marR="6853" marT="6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upe.3G209900.1</a:t>
                      </a: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05542601"/>
                  </a:ext>
                </a:extLst>
              </a:tr>
              <a:tr h="193576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TGCAATTGGACCCAAACT</a:t>
                      </a:r>
                    </a:p>
                  </a:txBody>
                  <a:tcPr marL="6853" marR="6853" marT="6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86525234"/>
                  </a:ext>
                </a:extLst>
              </a:tr>
              <a:tr h="193576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t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S</a:t>
                      </a:r>
                    </a:p>
                  </a:txBody>
                  <a:tcPr marL="6853" marR="6853" marT="6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202122"/>
                          </a:solidFill>
                          <a:effectLst/>
                          <a:latin typeface="Calibri" panose="020F0502020204030204" pitchFamily="34" charset="0"/>
                        </a:rPr>
                        <a:t>Aminocyclopropane-1-carboxylic acid (ACC) synthase</a:t>
                      </a:r>
                    </a:p>
                  </a:txBody>
                  <a:tcPr marL="6853" marR="6853" marT="6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CCGAGACTTGGGATGGA</a:t>
                      </a:r>
                    </a:p>
                  </a:txBody>
                  <a:tcPr marL="6853" marR="6853" marT="6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upe.2G176900.1</a:t>
                      </a: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05216482"/>
                  </a:ext>
                </a:extLst>
              </a:tr>
              <a:tr h="193576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TGCAAGTGCTTCCTTGGT</a:t>
                      </a:r>
                    </a:p>
                  </a:txBody>
                  <a:tcPr marL="6853" marR="6853" marT="6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06603319"/>
                  </a:ext>
                </a:extLst>
              </a:tr>
              <a:tr h="193576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t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OC</a:t>
                      </a:r>
                    </a:p>
                  </a:txBody>
                  <a:tcPr marL="6853" marR="6853" marT="6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t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lene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Oxide Cyclase  </a:t>
                      </a:r>
                    </a:p>
                  </a:txBody>
                  <a:tcPr marL="6853" marR="6853" marT="6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TGAAGCTGCACCAGATTGT</a:t>
                      </a:r>
                    </a:p>
                  </a:txBody>
                  <a:tcPr marL="6853" marR="6853" marT="6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upe.3G239900.1</a:t>
                      </a: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86031850"/>
                  </a:ext>
                </a:extLst>
              </a:tr>
              <a:tr h="193576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AGCTCCTCAGGCAAATCC</a:t>
                      </a:r>
                    </a:p>
                  </a:txBody>
                  <a:tcPr marL="6853" marR="6853" marT="6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99337578"/>
                  </a:ext>
                </a:extLst>
              </a:tr>
              <a:tr h="193576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t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OS</a:t>
                      </a:r>
                    </a:p>
                  </a:txBody>
                  <a:tcPr marL="6853" marR="6853" marT="6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t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len  Oxide Synthase</a:t>
                      </a:r>
                    </a:p>
                  </a:txBody>
                  <a:tcPr marL="6853" marR="6853" marT="6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AGCCAATCCCTGGAGACTA</a:t>
                      </a:r>
                    </a:p>
                  </a:txBody>
                  <a:tcPr marL="6853" marR="6853" marT="6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upe.8G110100.1</a:t>
                      </a: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56197046"/>
                  </a:ext>
                </a:extLst>
              </a:tr>
              <a:tr h="193576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AGAAATCGTATCGGCCTTG</a:t>
                      </a:r>
                    </a:p>
                  </a:txBody>
                  <a:tcPr marL="6853" marR="6853" marT="6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90877870"/>
                  </a:ext>
                </a:extLst>
              </a:tr>
              <a:tr h="193576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t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A20-OX1</a:t>
                      </a:r>
                    </a:p>
                  </a:txBody>
                  <a:tcPr marL="6853" marR="6853" marT="6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t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ibberellin 20 oxidase-I </a:t>
                      </a:r>
                    </a:p>
                  </a:txBody>
                  <a:tcPr marL="6853" marR="6853" marT="6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GGGAAGGTGTACCAAGAAT</a:t>
                      </a:r>
                    </a:p>
                  </a:txBody>
                  <a:tcPr marL="6853" marR="6853" marT="6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upe.2G150700.1</a:t>
                      </a: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34396424"/>
                  </a:ext>
                </a:extLst>
              </a:tr>
              <a:tr h="193576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TTGGCCAACTCCTAAGCTC</a:t>
                      </a:r>
                    </a:p>
                  </a:txBody>
                  <a:tcPr marL="6853" marR="6853" marT="6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02795869"/>
                  </a:ext>
                </a:extLst>
              </a:tr>
              <a:tr h="193576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t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A20-OX2</a:t>
                      </a:r>
                    </a:p>
                  </a:txBody>
                  <a:tcPr marL="6853" marR="6853" marT="6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t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ibberellin 20 oxidase-II </a:t>
                      </a:r>
                    </a:p>
                  </a:txBody>
                  <a:tcPr marL="6853" marR="6853" marT="6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TGCCATGGAAGGAAACTC</a:t>
                      </a:r>
                    </a:p>
                  </a:txBody>
                  <a:tcPr marL="6853" marR="6853" marT="6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upe.1G442200.1</a:t>
                      </a: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47026488"/>
                  </a:ext>
                </a:extLst>
              </a:tr>
              <a:tr h="193576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GCCTAGTTTGGATTTGCAG</a:t>
                      </a:r>
                    </a:p>
                  </a:txBody>
                  <a:tcPr marL="6853" marR="6853" marT="6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73963622"/>
                  </a:ext>
                </a:extLst>
              </a:tr>
              <a:tr h="193576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t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JAR</a:t>
                      </a:r>
                    </a:p>
                  </a:txBody>
                  <a:tcPr marL="6853" marR="6853" marT="6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t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Jasmonic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Acid Resistance </a:t>
                      </a:r>
                    </a:p>
                  </a:txBody>
                  <a:tcPr marL="6853" marR="6853" marT="6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ATTCTTCGGAAGGGAACCT</a:t>
                      </a:r>
                    </a:p>
                  </a:txBody>
                  <a:tcPr marL="6853" marR="6853" marT="6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upe.2G184100.1</a:t>
                      </a: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21252877"/>
                  </a:ext>
                </a:extLst>
              </a:tr>
              <a:tr h="193576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CTACACATCTTGGGGCTTT</a:t>
                      </a:r>
                    </a:p>
                  </a:txBody>
                  <a:tcPr marL="6853" marR="6853" marT="6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49504660"/>
                  </a:ext>
                </a:extLst>
              </a:tr>
              <a:tr h="193576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t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X</a:t>
                      </a:r>
                    </a:p>
                  </a:txBody>
                  <a:tcPr marL="6853" marR="6853" marT="6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t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inoleate 9S-lipoxygenase </a:t>
                      </a:r>
                    </a:p>
                  </a:txBody>
                  <a:tcPr marL="6853" marR="6853" marT="6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GAACTTTGAAGCCATTGGT</a:t>
                      </a:r>
                    </a:p>
                  </a:txBody>
                  <a:tcPr marL="6853" marR="6853" marT="6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upe.6G324400.1</a:t>
                      </a: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5468887"/>
                  </a:ext>
                </a:extLst>
              </a:tr>
              <a:tr h="193576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CCCTCTTCAGCTGGTGTA</a:t>
                      </a:r>
                    </a:p>
                  </a:txBody>
                  <a:tcPr marL="6853" marR="6853" marT="6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9657020"/>
                  </a:ext>
                </a:extLst>
              </a:tr>
              <a:tr h="193576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t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CED2</a:t>
                      </a:r>
                    </a:p>
                  </a:txBody>
                  <a:tcPr marL="6853" marR="6853" marT="6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t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-</a:t>
                      </a:r>
                      <a:r>
                        <a:rPr lang="en-US" sz="9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is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epoxycarotenoid dioxygenase-II</a:t>
                      </a:r>
                    </a:p>
                  </a:txBody>
                  <a:tcPr marL="6853" marR="6853" marT="6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TCCCTCGGTTCTTCACTT</a:t>
                      </a:r>
                    </a:p>
                  </a:txBody>
                  <a:tcPr marL="6853" marR="6853" marT="6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upe.4G082000.1</a:t>
                      </a: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47387722"/>
                  </a:ext>
                </a:extLst>
              </a:tr>
              <a:tr h="193576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GTTGTTGGGTTTTGGAGAA</a:t>
                      </a:r>
                    </a:p>
                  </a:txBody>
                  <a:tcPr marL="6853" marR="6853" marT="6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17828114"/>
                  </a:ext>
                </a:extLst>
              </a:tr>
              <a:tr h="193576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t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CED3</a:t>
                      </a:r>
                    </a:p>
                  </a:txBody>
                  <a:tcPr marL="6853" marR="6853" marT="6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t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-</a:t>
                      </a:r>
                      <a:r>
                        <a:rPr lang="en-US" sz="9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is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epoxycarotenoid dioxygenase-III</a:t>
                      </a:r>
                    </a:p>
                  </a:txBody>
                  <a:tcPr marL="6853" marR="6853" marT="6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ATTTGAAAACCGGCAAGTC</a:t>
                      </a:r>
                    </a:p>
                  </a:txBody>
                  <a:tcPr marL="6853" marR="6853" marT="6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upe.4G150100.1</a:t>
                      </a: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52886504"/>
                  </a:ext>
                </a:extLst>
              </a:tr>
              <a:tr h="193576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TTTCTCCCCAGTTTGTTCC</a:t>
                      </a:r>
                    </a:p>
                  </a:txBody>
                  <a:tcPr marL="6853" marR="6853" marT="6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07800749"/>
                  </a:ext>
                </a:extLst>
              </a:tr>
              <a:tr h="193576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t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PR</a:t>
                      </a:r>
                    </a:p>
                  </a:txBody>
                  <a:tcPr marL="6853" marR="6853" marT="6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t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-oxophytodienoate reductase</a:t>
                      </a:r>
                    </a:p>
                  </a:txBody>
                  <a:tcPr marL="6853" marR="6853" marT="6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TGCAAATTCTTGCTTCAGG</a:t>
                      </a:r>
                    </a:p>
                  </a:txBody>
                  <a:tcPr marL="6853" marR="6853" marT="6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upe.7G200800.1</a:t>
                      </a: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44042615"/>
                  </a:ext>
                </a:extLst>
              </a:tr>
              <a:tr h="193576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GATCAATGGCTGGTGAGAT</a:t>
                      </a:r>
                    </a:p>
                  </a:txBody>
                  <a:tcPr marL="6853" marR="6853" marT="6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25667019"/>
                  </a:ext>
                </a:extLst>
              </a:tr>
              <a:tr h="193576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t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BQ</a:t>
                      </a:r>
                    </a:p>
                  </a:txBody>
                  <a:tcPr marL="6853" marR="6853" marT="6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t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biquitin</a:t>
                      </a:r>
                    </a:p>
                  </a:txBody>
                  <a:tcPr marL="6853" marR="6853" marT="6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TCTTCCGACACCATCGAC</a:t>
                      </a:r>
                    </a:p>
                  </a:txBody>
                  <a:tcPr marL="6853" marR="6853" marT="6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upe.3G004600.1</a:t>
                      </a: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36969936"/>
                  </a:ext>
                </a:extLst>
              </a:tr>
              <a:tr h="202639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CTGCGAAGATGAGACTGT</a:t>
                      </a:r>
                    </a:p>
                  </a:txBody>
                  <a:tcPr marL="6853" marR="6853" marT="68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04945654"/>
                  </a:ext>
                </a:extLst>
              </a:tr>
              <a:tr h="193576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3" marR="6853" marT="685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5327015"/>
                  </a:ext>
                </a:extLst>
              </a:tr>
            </a:tbl>
          </a:graphicData>
        </a:graphic>
      </p:graphicFrame>
      <p:sp>
        <p:nvSpPr>
          <p:cNvPr id="6" name="Subtitle 2">
            <a:extLst>
              <a:ext uri="{FF2B5EF4-FFF2-40B4-BE49-F238E27FC236}">
                <a16:creationId xmlns:a16="http://schemas.microsoft.com/office/drawing/2014/main" id="{F2D4500A-34B3-4AB6-97B4-32D4C87C0CFE}"/>
              </a:ext>
            </a:extLst>
          </p:cNvPr>
          <p:cNvSpPr txBox="1">
            <a:spLocks/>
          </p:cNvSpPr>
          <p:nvPr/>
        </p:nvSpPr>
        <p:spPr>
          <a:xfrm>
            <a:off x="1200956" y="168112"/>
            <a:ext cx="6087766" cy="558097"/>
          </a:xfrm>
          <a:prstGeom prst="rect">
            <a:avLst/>
          </a:prstGeom>
        </p:spPr>
        <p:txBody>
          <a:bodyPr/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Table S1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Gene-specific primer sequences used for relative gene expression analysis of peach ‘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Redhaven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’ using qPCR.  </a:t>
            </a:r>
          </a:p>
        </p:txBody>
      </p:sp>
    </p:spTree>
    <p:extLst>
      <p:ext uri="{BB962C8B-B14F-4D97-AF65-F5344CB8AC3E}">
        <p14:creationId xmlns:p14="http://schemas.microsoft.com/office/powerpoint/2010/main" val="20828276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190</TotalTime>
  <Words>213</Words>
  <Application>Microsoft Office PowerPoint</Application>
  <PresentationFormat>Widescreen</PresentationFormat>
  <Paragraphs>86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anyang Liu</dc:creator>
  <cp:lastModifiedBy>MDPI-13</cp:lastModifiedBy>
  <cp:revision>11</cp:revision>
  <dcterms:created xsi:type="dcterms:W3CDTF">2021-05-30T02:49:50Z</dcterms:created>
  <dcterms:modified xsi:type="dcterms:W3CDTF">2021-06-16T10:06:50Z</dcterms:modified>
</cp:coreProperties>
</file>